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9" d="100"/>
          <a:sy n="79" d="100"/>
        </p:scale>
        <p:origin x="42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Pod-GY</a:t>
            </a:r>
          </a:p>
        </c:rich>
      </c:tx>
      <c:layout>
        <c:manualLayout>
          <c:xMode val="edge"/>
          <c:yMode val="edge"/>
          <c:x val="0.36898343985028775"/>
          <c:y val="5.578800557880055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G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6499072615923011"/>
                  <c:y val="-0.22674179616436835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197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b="1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 = 0.0989x + 28.065</a:t>
                    </a:r>
                    <a:br>
                      <a:rPr lang="en-US" b="1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b="1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² = 0.3968</a:t>
                    </a:r>
                    <a:endParaRPr lang="en-US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97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B$2:$B$293</c:f>
              <c:numCache>
                <c:formatCode>0.0</c:formatCode>
                <c:ptCount val="292"/>
                <c:pt idx="0">
                  <c:v>461.62208921601803</c:v>
                </c:pt>
                <c:pt idx="1">
                  <c:v>402.069761406184</c:v>
                </c:pt>
                <c:pt idx="2">
                  <c:v>405.18313750180403</c:v>
                </c:pt>
                <c:pt idx="3">
                  <c:v>467.65634874860802</c:v>
                </c:pt>
                <c:pt idx="4">
                  <c:v>476.32022183334601</c:v>
                </c:pt>
                <c:pt idx="5">
                  <c:v>528.06289968192095</c:v>
                </c:pt>
                <c:pt idx="6">
                  <c:v>432.65862556094999</c:v>
                </c:pt>
                <c:pt idx="7">
                  <c:v>454.38531812850698</c:v>
                </c:pt>
                <c:pt idx="8">
                  <c:v>442.29432351891802</c:v>
                </c:pt>
                <c:pt idx="9">
                  <c:v>488.06898352996802</c:v>
                </c:pt>
                <c:pt idx="10">
                  <c:v>429.49571629635398</c:v>
                </c:pt>
                <c:pt idx="11">
                  <c:v>505.04336420919901</c:v>
                </c:pt>
                <c:pt idx="12">
                  <c:v>463.31974411366099</c:v>
                </c:pt>
                <c:pt idx="13">
                  <c:v>431.040131492961</c:v>
                </c:pt>
                <c:pt idx="14">
                  <c:v>368.046720129356</c:v>
                </c:pt>
                <c:pt idx="15">
                  <c:v>430.85078264381798</c:v>
                </c:pt>
                <c:pt idx="16">
                  <c:v>453.466296162199</c:v>
                </c:pt>
                <c:pt idx="17">
                  <c:v>400.00293286844902</c:v>
                </c:pt>
                <c:pt idx="18">
                  <c:v>461.24709569873397</c:v>
                </c:pt>
                <c:pt idx="19">
                  <c:v>567.69859278878505</c:v>
                </c:pt>
                <c:pt idx="20">
                  <c:v>476.42661056176502</c:v>
                </c:pt>
                <c:pt idx="21">
                  <c:v>447.874633528174</c:v>
                </c:pt>
                <c:pt idx="22">
                  <c:v>530.75887752929395</c:v>
                </c:pt>
                <c:pt idx="23">
                  <c:v>499.67238966371002</c:v>
                </c:pt>
                <c:pt idx="24">
                  <c:v>519.13230670256496</c:v>
                </c:pt>
                <c:pt idx="25">
                  <c:v>368.080616486922</c:v>
                </c:pt>
                <c:pt idx="26">
                  <c:v>362.72327436146702</c:v>
                </c:pt>
                <c:pt idx="27">
                  <c:v>477.11740221705298</c:v>
                </c:pt>
                <c:pt idx="28">
                  <c:v>517.61088026627601</c:v>
                </c:pt>
                <c:pt idx="29">
                  <c:v>374.58509702971401</c:v>
                </c:pt>
                <c:pt idx="30">
                  <c:v>427.85341233871901</c:v>
                </c:pt>
                <c:pt idx="31">
                  <c:v>510.74622312567999</c:v>
                </c:pt>
                <c:pt idx="32">
                  <c:v>424.941185202116</c:v>
                </c:pt>
                <c:pt idx="33">
                  <c:v>400.79804823766</c:v>
                </c:pt>
                <c:pt idx="34">
                  <c:v>418.03668849405199</c:v>
                </c:pt>
                <c:pt idx="35">
                  <c:v>528.12993181794104</c:v>
                </c:pt>
                <c:pt idx="36">
                  <c:v>493.78781842740199</c:v>
                </c:pt>
                <c:pt idx="37">
                  <c:v>470.309902861078</c:v>
                </c:pt>
                <c:pt idx="38">
                  <c:v>432.59185154078898</c:v>
                </c:pt>
                <c:pt idx="39">
                  <c:v>469.90902260099199</c:v>
                </c:pt>
                <c:pt idx="40">
                  <c:v>496.92862857830102</c:v>
                </c:pt>
                <c:pt idx="41">
                  <c:v>465.445137577568</c:v>
                </c:pt>
                <c:pt idx="42">
                  <c:v>458.311507724774</c:v>
                </c:pt>
                <c:pt idx="43">
                  <c:v>414.58462722679002</c:v>
                </c:pt>
                <c:pt idx="44">
                  <c:v>508.04222873150297</c:v>
                </c:pt>
                <c:pt idx="45">
                  <c:v>386.43586086088402</c:v>
                </c:pt>
                <c:pt idx="46">
                  <c:v>430.20923816155903</c:v>
                </c:pt>
                <c:pt idx="47">
                  <c:v>441.77050940333697</c:v>
                </c:pt>
                <c:pt idx="48">
                  <c:v>490.63048767170301</c:v>
                </c:pt>
                <c:pt idx="49">
                  <c:v>423.27726558202897</c:v>
                </c:pt>
                <c:pt idx="50">
                  <c:v>452.269393076288</c:v>
                </c:pt>
                <c:pt idx="51">
                  <c:v>493.66088679166</c:v>
                </c:pt>
                <c:pt idx="52">
                  <c:v>438.13932629817799</c:v>
                </c:pt>
                <c:pt idx="53">
                  <c:v>377.15470015959102</c:v>
                </c:pt>
                <c:pt idx="54">
                  <c:v>506.78938334509502</c:v>
                </c:pt>
                <c:pt idx="55">
                  <c:v>429.51772812243303</c:v>
                </c:pt>
                <c:pt idx="56">
                  <c:v>521.481140957153</c:v>
                </c:pt>
                <c:pt idx="57">
                  <c:v>386.06939061896298</c:v>
                </c:pt>
                <c:pt idx="58">
                  <c:v>418.951381251832</c:v>
                </c:pt>
                <c:pt idx="59">
                  <c:v>440.67241790287</c:v>
                </c:pt>
                <c:pt idx="60">
                  <c:v>479.87877330227298</c:v>
                </c:pt>
                <c:pt idx="61">
                  <c:v>432.33553255222603</c:v>
                </c:pt>
                <c:pt idx="62">
                  <c:v>500.66130410422198</c:v>
                </c:pt>
                <c:pt idx="63">
                  <c:v>532.23213729842098</c:v>
                </c:pt>
                <c:pt idx="64">
                  <c:v>531.30848693510995</c:v>
                </c:pt>
                <c:pt idx="65">
                  <c:v>457.67106422551598</c:v>
                </c:pt>
                <c:pt idx="66">
                  <c:v>479.06908747798099</c:v>
                </c:pt>
                <c:pt idx="67">
                  <c:v>438.227513282958</c:v>
                </c:pt>
                <c:pt idx="68">
                  <c:v>447.69857338966898</c:v>
                </c:pt>
                <c:pt idx="69">
                  <c:v>467.31102922115798</c:v>
                </c:pt>
                <c:pt idx="70">
                  <c:v>481.28296102593703</c:v>
                </c:pt>
                <c:pt idx="71">
                  <c:v>397.959311844902</c:v>
                </c:pt>
                <c:pt idx="72">
                  <c:v>499.91794197978402</c:v>
                </c:pt>
                <c:pt idx="73">
                  <c:v>437.29635193113</c:v>
                </c:pt>
                <c:pt idx="74">
                  <c:v>515.02681068272398</c:v>
                </c:pt>
                <c:pt idx="75">
                  <c:v>491.49490076712101</c:v>
                </c:pt>
                <c:pt idx="76">
                  <c:v>513.99692691411406</c:v>
                </c:pt>
                <c:pt idx="77">
                  <c:v>412.04741012759098</c:v>
                </c:pt>
                <c:pt idx="78">
                  <c:v>458.60727167241703</c:v>
                </c:pt>
                <c:pt idx="79">
                  <c:v>455.39362388015599</c:v>
                </c:pt>
                <c:pt idx="80">
                  <c:v>457.67105439837502</c:v>
                </c:pt>
                <c:pt idx="81">
                  <c:v>464.34773013293602</c:v>
                </c:pt>
                <c:pt idx="82">
                  <c:v>438.296064056896</c:v>
                </c:pt>
                <c:pt idx="83">
                  <c:v>391.76530570376298</c:v>
                </c:pt>
                <c:pt idx="84">
                  <c:v>418.56155735514199</c:v>
                </c:pt>
                <c:pt idx="85">
                  <c:v>460.96642249014297</c:v>
                </c:pt>
                <c:pt idx="86">
                  <c:v>405.73144892050101</c:v>
                </c:pt>
                <c:pt idx="87">
                  <c:v>464.65454161644999</c:v>
                </c:pt>
                <c:pt idx="88">
                  <c:v>360.77511006755998</c:v>
                </c:pt>
                <c:pt idx="89">
                  <c:v>438.67528951680401</c:v>
                </c:pt>
                <c:pt idx="90">
                  <c:v>430.66763265487401</c:v>
                </c:pt>
                <c:pt idx="91">
                  <c:v>431.538933063483</c:v>
                </c:pt>
                <c:pt idx="92">
                  <c:v>368.164112468572</c:v>
                </c:pt>
                <c:pt idx="93">
                  <c:v>463.34735256276099</c:v>
                </c:pt>
                <c:pt idx="94">
                  <c:v>419.666489169903</c:v>
                </c:pt>
                <c:pt idx="95">
                  <c:v>425.840673344538</c:v>
                </c:pt>
                <c:pt idx="96">
                  <c:v>423.433229986377</c:v>
                </c:pt>
                <c:pt idx="97">
                  <c:v>423.89566487965999</c:v>
                </c:pt>
                <c:pt idx="98">
                  <c:v>399.01548989934003</c:v>
                </c:pt>
                <c:pt idx="99">
                  <c:v>422.75018893398101</c:v>
                </c:pt>
                <c:pt idx="100">
                  <c:v>486.27265474697998</c:v>
                </c:pt>
                <c:pt idx="101">
                  <c:v>476.95326167153701</c:v>
                </c:pt>
                <c:pt idx="102">
                  <c:v>400.74940744586502</c:v>
                </c:pt>
                <c:pt idx="103">
                  <c:v>426.95740598251098</c:v>
                </c:pt>
                <c:pt idx="104">
                  <c:v>517.12054062761399</c:v>
                </c:pt>
                <c:pt idx="105">
                  <c:v>497.02450958838</c:v>
                </c:pt>
                <c:pt idx="106">
                  <c:v>484.14730767494098</c:v>
                </c:pt>
                <c:pt idx="107">
                  <c:v>434.16732718806998</c:v>
                </c:pt>
                <c:pt idx="108">
                  <c:v>466.68256450614302</c:v>
                </c:pt>
                <c:pt idx="109">
                  <c:v>476.06751279522598</c:v>
                </c:pt>
                <c:pt idx="110">
                  <c:v>549.91554394691696</c:v>
                </c:pt>
                <c:pt idx="111">
                  <c:v>478.55085848828202</c:v>
                </c:pt>
                <c:pt idx="112">
                  <c:v>429.43686491756301</c:v>
                </c:pt>
                <c:pt idx="113">
                  <c:v>525.08242761860902</c:v>
                </c:pt>
                <c:pt idx="114">
                  <c:v>549.62583278447096</c:v>
                </c:pt>
                <c:pt idx="115">
                  <c:v>453.71410689537203</c:v>
                </c:pt>
                <c:pt idx="116">
                  <c:v>485.38065157502803</c:v>
                </c:pt>
                <c:pt idx="117">
                  <c:v>445.98038464293398</c:v>
                </c:pt>
                <c:pt idx="118">
                  <c:v>506.55350266770699</c:v>
                </c:pt>
                <c:pt idx="119">
                  <c:v>472.58893879368998</c:v>
                </c:pt>
                <c:pt idx="120">
                  <c:v>429.98677701817297</c:v>
                </c:pt>
                <c:pt idx="121">
                  <c:v>403.66266191134503</c:v>
                </c:pt>
                <c:pt idx="122">
                  <c:v>443.944088760412</c:v>
                </c:pt>
                <c:pt idx="123">
                  <c:v>410.13762632313598</c:v>
                </c:pt>
                <c:pt idx="124">
                  <c:v>528.63088449916495</c:v>
                </c:pt>
                <c:pt idx="125">
                  <c:v>421.397077083971</c:v>
                </c:pt>
                <c:pt idx="126">
                  <c:v>537.27703702467704</c:v>
                </c:pt>
                <c:pt idx="127">
                  <c:v>415.091133019251</c:v>
                </c:pt>
                <c:pt idx="128">
                  <c:v>486.966597266181</c:v>
                </c:pt>
                <c:pt idx="129">
                  <c:v>387.166645168939</c:v>
                </c:pt>
                <c:pt idx="130">
                  <c:v>397.20658265414801</c:v>
                </c:pt>
                <c:pt idx="131">
                  <c:v>451.32044253527999</c:v>
                </c:pt>
                <c:pt idx="132">
                  <c:v>457.06988675815398</c:v>
                </c:pt>
                <c:pt idx="133">
                  <c:v>456.786282344771</c:v>
                </c:pt>
                <c:pt idx="134">
                  <c:v>426.90584601587602</c:v>
                </c:pt>
                <c:pt idx="135">
                  <c:v>465.771894312234</c:v>
                </c:pt>
                <c:pt idx="136">
                  <c:v>428.95215036937498</c:v>
                </c:pt>
                <c:pt idx="137">
                  <c:v>458.67896524497701</c:v>
                </c:pt>
                <c:pt idx="138">
                  <c:v>463.106631006133</c:v>
                </c:pt>
                <c:pt idx="139">
                  <c:v>488.53818905935998</c:v>
                </c:pt>
                <c:pt idx="140">
                  <c:v>478.18577392287102</c:v>
                </c:pt>
                <c:pt idx="141">
                  <c:v>492.47210582049598</c:v>
                </c:pt>
                <c:pt idx="142">
                  <c:v>411.03139120471002</c:v>
                </c:pt>
                <c:pt idx="143">
                  <c:v>480.63220815016098</c:v>
                </c:pt>
                <c:pt idx="144">
                  <c:v>450.314559859562</c:v>
                </c:pt>
                <c:pt idx="145">
                  <c:v>435.97919799763798</c:v>
                </c:pt>
                <c:pt idx="146">
                  <c:v>364.49509041163799</c:v>
                </c:pt>
                <c:pt idx="147">
                  <c:v>435.00953523106699</c:v>
                </c:pt>
                <c:pt idx="148">
                  <c:v>436.90801010141098</c:v>
                </c:pt>
                <c:pt idx="149">
                  <c:v>480.747589817787</c:v>
                </c:pt>
                <c:pt idx="150">
                  <c:v>503.64077661493701</c:v>
                </c:pt>
                <c:pt idx="151">
                  <c:v>471.32379617374397</c:v>
                </c:pt>
                <c:pt idx="152">
                  <c:v>457.20196930773801</c:v>
                </c:pt>
                <c:pt idx="153">
                  <c:v>471.64507107214803</c:v>
                </c:pt>
                <c:pt idx="154">
                  <c:v>400.59374193208203</c:v>
                </c:pt>
                <c:pt idx="155">
                  <c:v>472.33459519853602</c:v>
                </c:pt>
                <c:pt idx="156">
                  <c:v>471.04824055654802</c:v>
                </c:pt>
                <c:pt idx="157">
                  <c:v>456.11931395679602</c:v>
                </c:pt>
                <c:pt idx="158">
                  <c:v>432.00774784077998</c:v>
                </c:pt>
                <c:pt idx="159">
                  <c:v>427.155677697133</c:v>
                </c:pt>
                <c:pt idx="160">
                  <c:v>501.89813243034399</c:v>
                </c:pt>
                <c:pt idx="161">
                  <c:v>496.28540040203001</c:v>
                </c:pt>
                <c:pt idx="162">
                  <c:v>562.11725294662494</c:v>
                </c:pt>
                <c:pt idx="163">
                  <c:v>459.56713893469998</c:v>
                </c:pt>
                <c:pt idx="164">
                  <c:v>478.67336682056703</c:v>
                </c:pt>
                <c:pt idx="165">
                  <c:v>512.25027775619697</c:v>
                </c:pt>
                <c:pt idx="166">
                  <c:v>425.73189070319899</c:v>
                </c:pt>
                <c:pt idx="167">
                  <c:v>451.07196601024299</c:v>
                </c:pt>
                <c:pt idx="168">
                  <c:v>481.06050006953598</c:v>
                </c:pt>
                <c:pt idx="169">
                  <c:v>393.97744726925299</c:v>
                </c:pt>
                <c:pt idx="170">
                  <c:v>518.362831614946</c:v>
                </c:pt>
                <c:pt idx="171">
                  <c:v>441.98478610132099</c:v>
                </c:pt>
                <c:pt idx="172">
                  <c:v>435.81529618145498</c:v>
                </c:pt>
                <c:pt idx="173">
                  <c:v>461.73340874540202</c:v>
                </c:pt>
                <c:pt idx="174">
                  <c:v>491.33607797801301</c:v>
                </c:pt>
                <c:pt idx="175">
                  <c:v>485.91854202084198</c:v>
                </c:pt>
                <c:pt idx="176">
                  <c:v>457.62603441364502</c:v>
                </c:pt>
                <c:pt idx="177">
                  <c:v>451.44229869197102</c:v>
                </c:pt>
                <c:pt idx="178">
                  <c:v>434.53998788796599</c:v>
                </c:pt>
                <c:pt idx="179">
                  <c:v>444.703548814447</c:v>
                </c:pt>
                <c:pt idx="180">
                  <c:v>449.49932468151201</c:v>
                </c:pt>
                <c:pt idx="181">
                  <c:v>403.11631092372397</c:v>
                </c:pt>
                <c:pt idx="182">
                  <c:v>515.50315993531296</c:v>
                </c:pt>
                <c:pt idx="183">
                  <c:v>426.51204333678697</c:v>
                </c:pt>
                <c:pt idx="184">
                  <c:v>445.19703362989799</c:v>
                </c:pt>
                <c:pt idx="185">
                  <c:v>456.76408064340802</c:v>
                </c:pt>
                <c:pt idx="186">
                  <c:v>413.09056153820802</c:v>
                </c:pt>
                <c:pt idx="187">
                  <c:v>463.32067729554598</c:v>
                </c:pt>
                <c:pt idx="188">
                  <c:v>454.88887013311103</c:v>
                </c:pt>
                <c:pt idx="189">
                  <c:v>467.25062993078097</c:v>
                </c:pt>
                <c:pt idx="190">
                  <c:v>537.00177220056196</c:v>
                </c:pt>
                <c:pt idx="191">
                  <c:v>466.85440492855798</c:v>
                </c:pt>
                <c:pt idx="192">
                  <c:v>399.122041951092</c:v>
                </c:pt>
                <c:pt idx="193">
                  <c:v>431.965648905526</c:v>
                </c:pt>
                <c:pt idx="194">
                  <c:v>485.104705696243</c:v>
                </c:pt>
                <c:pt idx="195">
                  <c:v>468.05192393768601</c:v>
                </c:pt>
                <c:pt idx="196">
                  <c:v>485.24994919744398</c:v>
                </c:pt>
                <c:pt idx="197">
                  <c:v>452.283766528922</c:v>
                </c:pt>
                <c:pt idx="198">
                  <c:v>572.81522539325499</c:v>
                </c:pt>
                <c:pt idx="199">
                  <c:v>474.65561077259702</c:v>
                </c:pt>
                <c:pt idx="200">
                  <c:v>429.80475493190602</c:v>
                </c:pt>
                <c:pt idx="201">
                  <c:v>476.61316884676802</c:v>
                </c:pt>
                <c:pt idx="202">
                  <c:v>479.19519116508798</c:v>
                </c:pt>
                <c:pt idx="203">
                  <c:v>507.99634759432797</c:v>
                </c:pt>
                <c:pt idx="204">
                  <c:v>532.10756235038195</c:v>
                </c:pt>
                <c:pt idx="205">
                  <c:v>491.77286883631399</c:v>
                </c:pt>
                <c:pt idx="206">
                  <c:v>402.51056533974702</c:v>
                </c:pt>
                <c:pt idx="207">
                  <c:v>472.00229361157398</c:v>
                </c:pt>
                <c:pt idx="208">
                  <c:v>511.198575675629</c:v>
                </c:pt>
                <c:pt idx="209">
                  <c:v>480.81702893544298</c:v>
                </c:pt>
                <c:pt idx="210">
                  <c:v>433.63730406468102</c:v>
                </c:pt>
                <c:pt idx="211">
                  <c:v>529.90126356025905</c:v>
                </c:pt>
                <c:pt idx="212">
                  <c:v>427.214497145591</c:v>
                </c:pt>
                <c:pt idx="213">
                  <c:v>479.37309993091998</c:v>
                </c:pt>
                <c:pt idx="214">
                  <c:v>548.52241458695403</c:v>
                </c:pt>
                <c:pt idx="215">
                  <c:v>458.85413427046302</c:v>
                </c:pt>
                <c:pt idx="216">
                  <c:v>437.87551833531398</c:v>
                </c:pt>
                <c:pt idx="217">
                  <c:v>386.57940789230901</c:v>
                </c:pt>
                <c:pt idx="218">
                  <c:v>477.72970998939002</c:v>
                </c:pt>
                <c:pt idx="219">
                  <c:v>468.25866887012899</c:v>
                </c:pt>
                <c:pt idx="220">
                  <c:v>542.437579098838</c:v>
                </c:pt>
                <c:pt idx="221">
                  <c:v>432.98077169349602</c:v>
                </c:pt>
                <c:pt idx="222">
                  <c:v>535.00583166136505</c:v>
                </c:pt>
                <c:pt idx="223">
                  <c:v>488.83451279385997</c:v>
                </c:pt>
                <c:pt idx="224">
                  <c:v>444.12588935175899</c:v>
                </c:pt>
                <c:pt idx="225">
                  <c:v>491.22510823670001</c:v>
                </c:pt>
                <c:pt idx="226">
                  <c:v>446.43036555998998</c:v>
                </c:pt>
                <c:pt idx="227">
                  <c:v>456.54603608627099</c:v>
                </c:pt>
                <c:pt idx="228">
                  <c:v>580.12638108365604</c:v>
                </c:pt>
                <c:pt idx="229">
                  <c:v>428.92959720648003</c:v>
                </c:pt>
                <c:pt idx="230">
                  <c:v>503.37974679803602</c:v>
                </c:pt>
                <c:pt idx="231">
                  <c:v>437.95679946953101</c:v>
                </c:pt>
                <c:pt idx="232">
                  <c:v>479.57630778485202</c:v>
                </c:pt>
                <c:pt idx="233">
                  <c:v>409.83162465220403</c:v>
                </c:pt>
                <c:pt idx="234">
                  <c:v>391.13291992623402</c:v>
                </c:pt>
                <c:pt idx="235">
                  <c:v>435.089397577814</c:v>
                </c:pt>
                <c:pt idx="236">
                  <c:v>470.26644190433899</c:v>
                </c:pt>
                <c:pt idx="237">
                  <c:v>434.92296818681302</c:v>
                </c:pt>
                <c:pt idx="238">
                  <c:v>465.42885137485598</c:v>
                </c:pt>
                <c:pt idx="239">
                  <c:v>525.84992241683199</c:v>
                </c:pt>
                <c:pt idx="240">
                  <c:v>525.16144862563601</c:v>
                </c:pt>
                <c:pt idx="241">
                  <c:v>413.79929608476601</c:v>
                </c:pt>
                <c:pt idx="242">
                  <c:v>452.86746677680202</c:v>
                </c:pt>
                <c:pt idx="243">
                  <c:v>553.53746786038403</c:v>
                </c:pt>
                <c:pt idx="244">
                  <c:v>497.64541913265498</c:v>
                </c:pt>
                <c:pt idx="245">
                  <c:v>521.20552794487196</c:v>
                </c:pt>
                <c:pt idx="246">
                  <c:v>415.74357528809202</c:v>
                </c:pt>
                <c:pt idx="247">
                  <c:v>503.52523580781701</c:v>
                </c:pt>
                <c:pt idx="248">
                  <c:v>420.82867235982002</c:v>
                </c:pt>
                <c:pt idx="249">
                  <c:v>438.07050716131698</c:v>
                </c:pt>
                <c:pt idx="250">
                  <c:v>477.96891931227498</c:v>
                </c:pt>
                <c:pt idx="251">
                  <c:v>436.791466848742</c:v>
                </c:pt>
                <c:pt idx="252">
                  <c:v>476.95475404546198</c:v>
                </c:pt>
                <c:pt idx="253">
                  <c:v>572.47212128148499</c:v>
                </c:pt>
                <c:pt idx="254">
                  <c:v>432.34175082591599</c:v>
                </c:pt>
                <c:pt idx="255">
                  <c:v>440.77982897798199</c:v>
                </c:pt>
                <c:pt idx="256">
                  <c:v>453.675731949468</c:v>
                </c:pt>
                <c:pt idx="257">
                  <c:v>506.08716847103602</c:v>
                </c:pt>
                <c:pt idx="258">
                  <c:v>447.03030543135299</c:v>
                </c:pt>
                <c:pt idx="259">
                  <c:v>416.85765397983602</c:v>
                </c:pt>
                <c:pt idx="260">
                  <c:v>420.18640003782099</c:v>
                </c:pt>
                <c:pt idx="261">
                  <c:v>466.590015610894</c:v>
                </c:pt>
                <c:pt idx="262">
                  <c:v>459.25456996704099</c:v>
                </c:pt>
                <c:pt idx="263">
                  <c:v>480.44323511338001</c:v>
                </c:pt>
                <c:pt idx="264">
                  <c:v>378.78305323122402</c:v>
                </c:pt>
                <c:pt idx="265">
                  <c:v>411.59724316527797</c:v>
                </c:pt>
                <c:pt idx="266">
                  <c:v>408.76742038747102</c:v>
                </c:pt>
                <c:pt idx="267">
                  <c:v>479.43061829999402</c:v>
                </c:pt>
                <c:pt idx="268">
                  <c:v>407.68698206609599</c:v>
                </c:pt>
                <c:pt idx="269">
                  <c:v>447.301007590415</c:v>
                </c:pt>
                <c:pt idx="270">
                  <c:v>428.658657597211</c:v>
                </c:pt>
                <c:pt idx="271">
                  <c:v>497.39043240442999</c:v>
                </c:pt>
                <c:pt idx="272">
                  <c:v>473.383660276444</c:v>
                </c:pt>
                <c:pt idx="273">
                  <c:v>454.38559131132502</c:v>
                </c:pt>
                <c:pt idx="274">
                  <c:v>481.80120589901998</c:v>
                </c:pt>
                <c:pt idx="275">
                  <c:v>412.059169010559</c:v>
                </c:pt>
                <c:pt idx="276">
                  <c:v>494.16691300461201</c:v>
                </c:pt>
                <c:pt idx="277">
                  <c:v>463.59225131793602</c:v>
                </c:pt>
                <c:pt idx="278">
                  <c:v>480.244119756911</c:v>
                </c:pt>
                <c:pt idx="279">
                  <c:v>505.34505445501799</c:v>
                </c:pt>
                <c:pt idx="280">
                  <c:v>418.73739346675302</c:v>
                </c:pt>
                <c:pt idx="281">
                  <c:v>434.154019524641</c:v>
                </c:pt>
                <c:pt idx="282">
                  <c:v>445.27556406157498</c:v>
                </c:pt>
                <c:pt idx="283">
                  <c:v>497.14458219191698</c:v>
                </c:pt>
                <c:pt idx="284">
                  <c:v>477.53354576701599</c:v>
                </c:pt>
                <c:pt idx="285">
                  <c:v>421.95838718866202</c:v>
                </c:pt>
                <c:pt idx="286">
                  <c:v>389.49254763492002</c:v>
                </c:pt>
                <c:pt idx="287">
                  <c:v>421.42160136986701</c:v>
                </c:pt>
                <c:pt idx="288">
                  <c:v>463.12355026492003</c:v>
                </c:pt>
                <c:pt idx="289">
                  <c:v>505.79346954062902</c:v>
                </c:pt>
                <c:pt idx="290">
                  <c:v>460.10315257798902</c:v>
                </c:pt>
                <c:pt idx="291">
                  <c:v>469.099904793419</c:v>
                </c:pt>
              </c:numCache>
            </c:numRef>
          </c:xVal>
          <c:yVal>
            <c:numRef>
              <c:f>Sheet1!$G$2:$G$293</c:f>
              <c:numCache>
                <c:formatCode>0.0</c:formatCode>
                <c:ptCount val="292"/>
                <c:pt idx="0">
                  <c:v>75.175185865463803</c:v>
                </c:pt>
                <c:pt idx="1">
                  <c:v>77.280762251155494</c:v>
                </c:pt>
                <c:pt idx="2">
                  <c:v>66.236922542963995</c:v>
                </c:pt>
                <c:pt idx="3">
                  <c:v>76.749217605516506</c:v>
                </c:pt>
                <c:pt idx="4">
                  <c:v>72.297496060432806</c:v>
                </c:pt>
                <c:pt idx="5">
                  <c:v>78.097124422005393</c:v>
                </c:pt>
                <c:pt idx="6">
                  <c:v>66.896393641304996</c:v>
                </c:pt>
                <c:pt idx="7">
                  <c:v>79.481449996611303</c:v>
                </c:pt>
                <c:pt idx="8">
                  <c:v>73.631875156809699</c:v>
                </c:pt>
                <c:pt idx="9">
                  <c:v>87.445739811342307</c:v>
                </c:pt>
                <c:pt idx="10">
                  <c:v>75.689039109647297</c:v>
                </c:pt>
                <c:pt idx="11">
                  <c:v>79.140903014594997</c:v>
                </c:pt>
                <c:pt idx="12">
                  <c:v>85.720186678772905</c:v>
                </c:pt>
                <c:pt idx="13">
                  <c:v>75.974709074757698</c:v>
                </c:pt>
                <c:pt idx="14">
                  <c:v>62.257033455099602</c:v>
                </c:pt>
                <c:pt idx="15">
                  <c:v>74.873685966021796</c:v>
                </c:pt>
                <c:pt idx="16">
                  <c:v>66.088676113301801</c:v>
                </c:pt>
                <c:pt idx="17">
                  <c:v>63.063856865872999</c:v>
                </c:pt>
                <c:pt idx="18">
                  <c:v>81.393960288029504</c:v>
                </c:pt>
                <c:pt idx="19">
                  <c:v>74.277702786989394</c:v>
                </c:pt>
                <c:pt idx="20">
                  <c:v>80.877763315476997</c:v>
                </c:pt>
                <c:pt idx="21">
                  <c:v>72.934313952962697</c:v>
                </c:pt>
                <c:pt idx="22">
                  <c:v>83.081909085019007</c:v>
                </c:pt>
                <c:pt idx="23">
                  <c:v>75.836335801850595</c:v>
                </c:pt>
                <c:pt idx="24">
                  <c:v>86.025680182162503</c:v>
                </c:pt>
                <c:pt idx="25">
                  <c:v>59.033954086390402</c:v>
                </c:pt>
                <c:pt idx="26">
                  <c:v>62.523599165507498</c:v>
                </c:pt>
                <c:pt idx="27">
                  <c:v>79.399416002888501</c:v>
                </c:pt>
                <c:pt idx="28">
                  <c:v>87.715480357376094</c:v>
                </c:pt>
                <c:pt idx="29">
                  <c:v>58.817891407709297</c:v>
                </c:pt>
                <c:pt idx="30">
                  <c:v>66.898768346378503</c:v>
                </c:pt>
                <c:pt idx="31">
                  <c:v>78.246588668676793</c:v>
                </c:pt>
                <c:pt idx="32">
                  <c:v>70.658795145663007</c:v>
                </c:pt>
                <c:pt idx="33">
                  <c:v>64.382064881926496</c:v>
                </c:pt>
                <c:pt idx="34">
                  <c:v>73.957447551210507</c:v>
                </c:pt>
                <c:pt idx="35">
                  <c:v>76.830220835431405</c:v>
                </c:pt>
                <c:pt idx="36">
                  <c:v>75.780741157089693</c:v>
                </c:pt>
                <c:pt idx="37">
                  <c:v>69.268678678481606</c:v>
                </c:pt>
                <c:pt idx="38">
                  <c:v>71.978046425664004</c:v>
                </c:pt>
                <c:pt idx="39">
                  <c:v>71.388449858721998</c:v>
                </c:pt>
                <c:pt idx="40">
                  <c:v>73.972713601756297</c:v>
                </c:pt>
                <c:pt idx="41">
                  <c:v>72.606104905431806</c:v>
                </c:pt>
                <c:pt idx="42">
                  <c:v>76.137534313306006</c:v>
                </c:pt>
                <c:pt idx="43">
                  <c:v>77.151087957233401</c:v>
                </c:pt>
                <c:pt idx="44">
                  <c:v>79.877103524988698</c:v>
                </c:pt>
                <c:pt idx="45">
                  <c:v>66.477582236520902</c:v>
                </c:pt>
                <c:pt idx="46">
                  <c:v>69.818865565865806</c:v>
                </c:pt>
                <c:pt idx="47">
                  <c:v>83.515263451626396</c:v>
                </c:pt>
                <c:pt idx="48">
                  <c:v>71.589766718453305</c:v>
                </c:pt>
                <c:pt idx="49">
                  <c:v>68.307891420804395</c:v>
                </c:pt>
                <c:pt idx="50">
                  <c:v>68.408914284697602</c:v>
                </c:pt>
                <c:pt idx="51">
                  <c:v>85.4833346718858</c:v>
                </c:pt>
                <c:pt idx="52">
                  <c:v>65.448782714843404</c:v>
                </c:pt>
                <c:pt idx="53">
                  <c:v>65.711931814085801</c:v>
                </c:pt>
                <c:pt idx="54">
                  <c:v>84.824001966451505</c:v>
                </c:pt>
                <c:pt idx="55">
                  <c:v>65.933061827718006</c:v>
                </c:pt>
                <c:pt idx="56">
                  <c:v>77.090059221936002</c:v>
                </c:pt>
                <c:pt idx="57">
                  <c:v>65.333708912602802</c:v>
                </c:pt>
                <c:pt idx="58">
                  <c:v>67.855022456875403</c:v>
                </c:pt>
                <c:pt idx="59">
                  <c:v>66.741745516582995</c:v>
                </c:pt>
                <c:pt idx="60">
                  <c:v>78.6640175153385</c:v>
                </c:pt>
                <c:pt idx="61">
                  <c:v>61.714097768926898</c:v>
                </c:pt>
                <c:pt idx="62">
                  <c:v>81.815545712584196</c:v>
                </c:pt>
                <c:pt idx="63">
                  <c:v>87.478806672377203</c:v>
                </c:pt>
                <c:pt idx="64">
                  <c:v>78.059966293532895</c:v>
                </c:pt>
                <c:pt idx="65">
                  <c:v>72.519249747186393</c:v>
                </c:pt>
                <c:pt idx="66">
                  <c:v>78.795124886131902</c:v>
                </c:pt>
                <c:pt idx="67">
                  <c:v>72.405038887037193</c:v>
                </c:pt>
                <c:pt idx="68">
                  <c:v>68.646152000036295</c:v>
                </c:pt>
                <c:pt idx="69">
                  <c:v>64.570742660589303</c:v>
                </c:pt>
                <c:pt idx="70">
                  <c:v>75.608272310008005</c:v>
                </c:pt>
                <c:pt idx="71">
                  <c:v>62.418552321480099</c:v>
                </c:pt>
                <c:pt idx="72">
                  <c:v>75.271094807720203</c:v>
                </c:pt>
                <c:pt idx="73">
                  <c:v>72.731504704381194</c:v>
                </c:pt>
                <c:pt idx="74">
                  <c:v>75.797533301546693</c:v>
                </c:pt>
                <c:pt idx="75">
                  <c:v>88.343550869620103</c:v>
                </c:pt>
                <c:pt idx="76">
                  <c:v>84.906600239030993</c:v>
                </c:pt>
                <c:pt idx="77">
                  <c:v>71.662558429502198</c:v>
                </c:pt>
                <c:pt idx="78">
                  <c:v>75.036752875095004</c:v>
                </c:pt>
                <c:pt idx="79">
                  <c:v>83.923902238541899</c:v>
                </c:pt>
                <c:pt idx="80">
                  <c:v>68.432966485553294</c:v>
                </c:pt>
                <c:pt idx="81">
                  <c:v>64.445507103732595</c:v>
                </c:pt>
                <c:pt idx="82">
                  <c:v>63.811108111641801</c:v>
                </c:pt>
                <c:pt idx="83">
                  <c:v>69.899253910492106</c:v>
                </c:pt>
                <c:pt idx="84">
                  <c:v>69.867466961729306</c:v>
                </c:pt>
                <c:pt idx="85">
                  <c:v>68.959105495433306</c:v>
                </c:pt>
                <c:pt idx="86">
                  <c:v>68.0069243226108</c:v>
                </c:pt>
                <c:pt idx="87">
                  <c:v>87.5447585478382</c:v>
                </c:pt>
                <c:pt idx="88">
                  <c:v>66.863966118163205</c:v>
                </c:pt>
                <c:pt idx="89">
                  <c:v>75.073578621329105</c:v>
                </c:pt>
                <c:pt idx="90">
                  <c:v>69.760285822393996</c:v>
                </c:pt>
                <c:pt idx="91">
                  <c:v>78.987618757669097</c:v>
                </c:pt>
                <c:pt idx="92">
                  <c:v>58.031849909585503</c:v>
                </c:pt>
                <c:pt idx="93">
                  <c:v>68.7588866795911</c:v>
                </c:pt>
                <c:pt idx="94">
                  <c:v>75.7074732373313</c:v>
                </c:pt>
                <c:pt idx="95">
                  <c:v>80.763797583042205</c:v>
                </c:pt>
                <c:pt idx="96">
                  <c:v>76.635953131248897</c:v>
                </c:pt>
                <c:pt idx="97">
                  <c:v>63.8099628802034</c:v>
                </c:pt>
                <c:pt idx="98">
                  <c:v>63.678744380979303</c:v>
                </c:pt>
                <c:pt idx="99">
                  <c:v>75.976730282629106</c:v>
                </c:pt>
                <c:pt idx="100">
                  <c:v>83.917775899649698</c:v>
                </c:pt>
                <c:pt idx="101">
                  <c:v>66.846729617399106</c:v>
                </c:pt>
                <c:pt idx="102">
                  <c:v>69.083197147579895</c:v>
                </c:pt>
                <c:pt idx="103">
                  <c:v>74.552066667286695</c:v>
                </c:pt>
                <c:pt idx="104">
                  <c:v>75.305812423360095</c:v>
                </c:pt>
                <c:pt idx="105">
                  <c:v>83.303561781746296</c:v>
                </c:pt>
                <c:pt idx="106">
                  <c:v>76.627303409792006</c:v>
                </c:pt>
                <c:pt idx="107">
                  <c:v>63.031711828055201</c:v>
                </c:pt>
                <c:pt idx="108">
                  <c:v>75.832189308980801</c:v>
                </c:pt>
                <c:pt idx="109">
                  <c:v>91.268903563792804</c:v>
                </c:pt>
                <c:pt idx="110">
                  <c:v>74.239406597478094</c:v>
                </c:pt>
                <c:pt idx="111">
                  <c:v>78.807228354348496</c:v>
                </c:pt>
                <c:pt idx="112">
                  <c:v>68.2501235941359</c:v>
                </c:pt>
                <c:pt idx="113">
                  <c:v>88.398298239349103</c:v>
                </c:pt>
                <c:pt idx="114">
                  <c:v>80.370298465400793</c:v>
                </c:pt>
                <c:pt idx="115">
                  <c:v>68.024411204335806</c:v>
                </c:pt>
                <c:pt idx="116">
                  <c:v>80.407681902619203</c:v>
                </c:pt>
                <c:pt idx="117">
                  <c:v>73.5279053829899</c:v>
                </c:pt>
                <c:pt idx="118">
                  <c:v>70.697596410061294</c:v>
                </c:pt>
                <c:pt idx="119">
                  <c:v>78.953601405448495</c:v>
                </c:pt>
                <c:pt idx="120">
                  <c:v>72.441287864260303</c:v>
                </c:pt>
                <c:pt idx="121">
                  <c:v>60.163666164670602</c:v>
                </c:pt>
                <c:pt idx="122">
                  <c:v>69.0872593880339</c:v>
                </c:pt>
                <c:pt idx="123">
                  <c:v>67.7987849617938</c:v>
                </c:pt>
                <c:pt idx="124">
                  <c:v>82.993721806932598</c:v>
                </c:pt>
                <c:pt idx="125">
                  <c:v>69.367851990489299</c:v>
                </c:pt>
                <c:pt idx="126">
                  <c:v>78.844651731703195</c:v>
                </c:pt>
                <c:pt idx="127">
                  <c:v>75.394540032828303</c:v>
                </c:pt>
                <c:pt idx="128">
                  <c:v>82.221123026660806</c:v>
                </c:pt>
                <c:pt idx="129">
                  <c:v>65.3333881849112</c:v>
                </c:pt>
                <c:pt idx="130">
                  <c:v>68.318673615056099</c:v>
                </c:pt>
                <c:pt idx="131">
                  <c:v>71.247303395372597</c:v>
                </c:pt>
                <c:pt idx="132">
                  <c:v>68.108485726883202</c:v>
                </c:pt>
                <c:pt idx="133">
                  <c:v>72.415104238138994</c:v>
                </c:pt>
                <c:pt idx="134">
                  <c:v>72.920649452545604</c:v>
                </c:pt>
                <c:pt idx="135">
                  <c:v>68.813130678629093</c:v>
                </c:pt>
                <c:pt idx="136">
                  <c:v>72.200205012959302</c:v>
                </c:pt>
                <c:pt idx="137">
                  <c:v>71.161439800364107</c:v>
                </c:pt>
                <c:pt idx="138">
                  <c:v>70.765967007596203</c:v>
                </c:pt>
                <c:pt idx="139">
                  <c:v>80.273318303338698</c:v>
                </c:pt>
                <c:pt idx="140">
                  <c:v>69.985367339311395</c:v>
                </c:pt>
                <c:pt idx="141">
                  <c:v>74.614044829760005</c:v>
                </c:pt>
                <c:pt idx="142">
                  <c:v>72.626739861112299</c:v>
                </c:pt>
                <c:pt idx="143">
                  <c:v>81.179525648188005</c:v>
                </c:pt>
                <c:pt idx="144">
                  <c:v>89.041313103297696</c:v>
                </c:pt>
                <c:pt idx="145">
                  <c:v>78.691301660454897</c:v>
                </c:pt>
                <c:pt idx="146">
                  <c:v>61.2801126823842</c:v>
                </c:pt>
                <c:pt idx="147">
                  <c:v>64.854340297895106</c:v>
                </c:pt>
                <c:pt idx="148">
                  <c:v>68.0734711916176</c:v>
                </c:pt>
                <c:pt idx="149">
                  <c:v>63.896890870171298</c:v>
                </c:pt>
                <c:pt idx="150">
                  <c:v>74.564459243939197</c:v>
                </c:pt>
                <c:pt idx="151">
                  <c:v>76.639942039456798</c:v>
                </c:pt>
                <c:pt idx="152">
                  <c:v>66.778085360024605</c:v>
                </c:pt>
                <c:pt idx="153">
                  <c:v>70.733997869398806</c:v>
                </c:pt>
                <c:pt idx="154">
                  <c:v>62.362825389031102</c:v>
                </c:pt>
                <c:pt idx="155">
                  <c:v>71.814876421574098</c:v>
                </c:pt>
                <c:pt idx="156">
                  <c:v>70.037543767372398</c:v>
                </c:pt>
                <c:pt idx="157">
                  <c:v>71.090367967076503</c:v>
                </c:pt>
                <c:pt idx="158">
                  <c:v>69.135063177761197</c:v>
                </c:pt>
                <c:pt idx="159">
                  <c:v>70.016511863431404</c:v>
                </c:pt>
                <c:pt idx="160">
                  <c:v>75.431680890833903</c:v>
                </c:pt>
                <c:pt idx="161">
                  <c:v>74.951162530576994</c:v>
                </c:pt>
                <c:pt idx="162">
                  <c:v>93.313061636827697</c:v>
                </c:pt>
                <c:pt idx="163">
                  <c:v>75.046684032016302</c:v>
                </c:pt>
                <c:pt idx="164">
                  <c:v>74.514695369396705</c:v>
                </c:pt>
                <c:pt idx="165">
                  <c:v>72.345451377161098</c:v>
                </c:pt>
                <c:pt idx="166">
                  <c:v>64.2565765403222</c:v>
                </c:pt>
                <c:pt idx="167">
                  <c:v>79.993402730845801</c:v>
                </c:pt>
                <c:pt idx="168">
                  <c:v>71.858354490134303</c:v>
                </c:pt>
                <c:pt idx="169">
                  <c:v>61.795520727218999</c:v>
                </c:pt>
                <c:pt idx="170">
                  <c:v>78.8273824025907</c:v>
                </c:pt>
                <c:pt idx="171">
                  <c:v>69.471260608987606</c:v>
                </c:pt>
                <c:pt idx="172">
                  <c:v>67.699759179193705</c:v>
                </c:pt>
                <c:pt idx="173">
                  <c:v>68.051002420714696</c:v>
                </c:pt>
                <c:pt idx="174">
                  <c:v>76.959002010550705</c:v>
                </c:pt>
                <c:pt idx="175">
                  <c:v>75.005678597870201</c:v>
                </c:pt>
                <c:pt idx="176">
                  <c:v>70.081597426661503</c:v>
                </c:pt>
                <c:pt idx="177">
                  <c:v>75.221810390880904</c:v>
                </c:pt>
                <c:pt idx="178">
                  <c:v>70.793383617586599</c:v>
                </c:pt>
                <c:pt idx="179">
                  <c:v>71.911924687160194</c:v>
                </c:pt>
                <c:pt idx="180">
                  <c:v>66.369416630822101</c:v>
                </c:pt>
                <c:pt idx="181">
                  <c:v>65.859232852930006</c:v>
                </c:pt>
                <c:pt idx="182">
                  <c:v>82.945133027145999</c:v>
                </c:pt>
                <c:pt idx="183">
                  <c:v>75.878056157407102</c:v>
                </c:pt>
                <c:pt idx="184">
                  <c:v>77.592005210561993</c:v>
                </c:pt>
                <c:pt idx="185">
                  <c:v>68.077910493146106</c:v>
                </c:pt>
                <c:pt idx="186">
                  <c:v>65.896364220511998</c:v>
                </c:pt>
                <c:pt idx="187">
                  <c:v>85.827480079194899</c:v>
                </c:pt>
                <c:pt idx="188">
                  <c:v>74.175903420161703</c:v>
                </c:pt>
                <c:pt idx="189">
                  <c:v>70.301263051364103</c:v>
                </c:pt>
                <c:pt idx="190">
                  <c:v>76.749925186603605</c:v>
                </c:pt>
                <c:pt idx="191">
                  <c:v>65.682087580000498</c:v>
                </c:pt>
                <c:pt idx="192">
                  <c:v>65.147701421623594</c:v>
                </c:pt>
                <c:pt idx="193">
                  <c:v>71.395523329541305</c:v>
                </c:pt>
                <c:pt idx="194">
                  <c:v>73.768262017344597</c:v>
                </c:pt>
                <c:pt idx="195">
                  <c:v>75.296663503983098</c:v>
                </c:pt>
                <c:pt idx="196">
                  <c:v>78.711780770011998</c:v>
                </c:pt>
                <c:pt idx="197">
                  <c:v>75.394663724285394</c:v>
                </c:pt>
                <c:pt idx="198">
                  <c:v>90.393819059386502</c:v>
                </c:pt>
                <c:pt idx="199">
                  <c:v>73.982052940841101</c:v>
                </c:pt>
                <c:pt idx="200">
                  <c:v>69.918284343981298</c:v>
                </c:pt>
                <c:pt idx="201">
                  <c:v>80.330796531456599</c:v>
                </c:pt>
                <c:pt idx="202">
                  <c:v>79.9103046408203</c:v>
                </c:pt>
                <c:pt idx="203">
                  <c:v>87.416535906333905</c:v>
                </c:pt>
                <c:pt idx="204">
                  <c:v>70.035888594461696</c:v>
                </c:pt>
                <c:pt idx="205">
                  <c:v>76.163249223311496</c:v>
                </c:pt>
                <c:pt idx="206">
                  <c:v>65.1086945722396</c:v>
                </c:pt>
                <c:pt idx="207">
                  <c:v>76.706319800306204</c:v>
                </c:pt>
                <c:pt idx="208">
                  <c:v>81.176948948137195</c:v>
                </c:pt>
                <c:pt idx="209">
                  <c:v>69.748609070931707</c:v>
                </c:pt>
                <c:pt idx="210">
                  <c:v>73.591276103339695</c:v>
                </c:pt>
                <c:pt idx="211">
                  <c:v>78.676078522817804</c:v>
                </c:pt>
                <c:pt idx="212">
                  <c:v>75.213977312378006</c:v>
                </c:pt>
                <c:pt idx="213">
                  <c:v>67.902379370234001</c:v>
                </c:pt>
                <c:pt idx="214">
                  <c:v>87.680740742462802</c:v>
                </c:pt>
                <c:pt idx="215">
                  <c:v>83.222177120479799</c:v>
                </c:pt>
                <c:pt idx="216">
                  <c:v>67.403475992130197</c:v>
                </c:pt>
                <c:pt idx="217">
                  <c:v>72.805533603581907</c:v>
                </c:pt>
                <c:pt idx="218">
                  <c:v>83.391310976068397</c:v>
                </c:pt>
                <c:pt idx="219">
                  <c:v>77.680857021814603</c:v>
                </c:pt>
                <c:pt idx="220">
                  <c:v>81.466078230365994</c:v>
                </c:pt>
                <c:pt idx="221">
                  <c:v>63.656835553330303</c:v>
                </c:pt>
                <c:pt idx="222">
                  <c:v>82.195588086267307</c:v>
                </c:pt>
                <c:pt idx="223">
                  <c:v>73.694848903410303</c:v>
                </c:pt>
                <c:pt idx="224">
                  <c:v>69.084031592561502</c:v>
                </c:pt>
                <c:pt idx="225">
                  <c:v>79.585465319896997</c:v>
                </c:pt>
                <c:pt idx="226">
                  <c:v>77.014031878092098</c:v>
                </c:pt>
                <c:pt idx="227">
                  <c:v>81.843500482333795</c:v>
                </c:pt>
                <c:pt idx="228">
                  <c:v>84.501546468637699</c:v>
                </c:pt>
                <c:pt idx="229">
                  <c:v>77.808467091031105</c:v>
                </c:pt>
                <c:pt idx="230">
                  <c:v>83.465819485647401</c:v>
                </c:pt>
                <c:pt idx="231">
                  <c:v>70.389974010409802</c:v>
                </c:pt>
                <c:pt idx="232">
                  <c:v>73.751924926115706</c:v>
                </c:pt>
                <c:pt idx="233">
                  <c:v>67.867028128896095</c:v>
                </c:pt>
                <c:pt idx="234">
                  <c:v>67.459729876144905</c:v>
                </c:pt>
                <c:pt idx="235">
                  <c:v>76.326474377424105</c:v>
                </c:pt>
                <c:pt idx="236">
                  <c:v>70.305713661696998</c:v>
                </c:pt>
                <c:pt idx="237">
                  <c:v>66.359742489227799</c:v>
                </c:pt>
                <c:pt idx="238">
                  <c:v>71.581415976560706</c:v>
                </c:pt>
                <c:pt idx="239">
                  <c:v>76.793678796508303</c:v>
                </c:pt>
                <c:pt idx="240">
                  <c:v>78.544550892912696</c:v>
                </c:pt>
                <c:pt idx="241">
                  <c:v>69.251355338454005</c:v>
                </c:pt>
                <c:pt idx="242">
                  <c:v>76.622622492889803</c:v>
                </c:pt>
                <c:pt idx="243">
                  <c:v>69.401232417491201</c:v>
                </c:pt>
                <c:pt idx="244">
                  <c:v>79.797518572081998</c:v>
                </c:pt>
                <c:pt idx="245">
                  <c:v>68.002886337808206</c:v>
                </c:pt>
                <c:pt idx="246">
                  <c:v>66.550610349486405</c:v>
                </c:pt>
                <c:pt idx="247">
                  <c:v>79.612408442685094</c:v>
                </c:pt>
                <c:pt idx="248">
                  <c:v>65.648231152147702</c:v>
                </c:pt>
                <c:pt idx="249">
                  <c:v>73.239528579108693</c:v>
                </c:pt>
                <c:pt idx="250">
                  <c:v>67.380766751035793</c:v>
                </c:pt>
                <c:pt idx="251">
                  <c:v>68.080293434839803</c:v>
                </c:pt>
                <c:pt idx="252">
                  <c:v>84.784856728069101</c:v>
                </c:pt>
                <c:pt idx="253">
                  <c:v>77.943341233467805</c:v>
                </c:pt>
                <c:pt idx="254">
                  <c:v>70.5269487356654</c:v>
                </c:pt>
                <c:pt idx="255">
                  <c:v>73.867372977572501</c:v>
                </c:pt>
                <c:pt idx="256">
                  <c:v>77.875943010805102</c:v>
                </c:pt>
                <c:pt idx="257">
                  <c:v>79.131212881119694</c:v>
                </c:pt>
                <c:pt idx="258">
                  <c:v>72.684782153438405</c:v>
                </c:pt>
                <c:pt idx="259">
                  <c:v>74.128752868683407</c:v>
                </c:pt>
                <c:pt idx="260">
                  <c:v>67.575903782677898</c:v>
                </c:pt>
                <c:pt idx="261">
                  <c:v>78.519196959977805</c:v>
                </c:pt>
                <c:pt idx="262">
                  <c:v>68.526573432248497</c:v>
                </c:pt>
                <c:pt idx="263">
                  <c:v>68.903412909504993</c:v>
                </c:pt>
                <c:pt idx="264">
                  <c:v>67.918451465871399</c:v>
                </c:pt>
                <c:pt idx="265">
                  <c:v>72.794779826529705</c:v>
                </c:pt>
                <c:pt idx="266">
                  <c:v>73.243462475666803</c:v>
                </c:pt>
                <c:pt idx="267">
                  <c:v>84.382065085992295</c:v>
                </c:pt>
                <c:pt idx="268">
                  <c:v>67.549424079673202</c:v>
                </c:pt>
                <c:pt idx="269">
                  <c:v>66.674041308420598</c:v>
                </c:pt>
                <c:pt idx="270">
                  <c:v>65.324001550219194</c:v>
                </c:pt>
                <c:pt idx="271">
                  <c:v>75.876041120475605</c:v>
                </c:pt>
                <c:pt idx="272">
                  <c:v>72.785238687714099</c:v>
                </c:pt>
                <c:pt idx="273">
                  <c:v>76.091161709329995</c:v>
                </c:pt>
                <c:pt idx="274">
                  <c:v>69.881465354288295</c:v>
                </c:pt>
                <c:pt idx="275">
                  <c:v>65.103369840584904</c:v>
                </c:pt>
                <c:pt idx="276">
                  <c:v>76.901120207916193</c:v>
                </c:pt>
                <c:pt idx="277">
                  <c:v>66.231027827274801</c:v>
                </c:pt>
                <c:pt idx="278">
                  <c:v>72.557166168108196</c:v>
                </c:pt>
                <c:pt idx="279">
                  <c:v>75.166669862620296</c:v>
                </c:pt>
                <c:pt idx="280">
                  <c:v>76.161714366637298</c:v>
                </c:pt>
                <c:pt idx="281">
                  <c:v>68.097449994446194</c:v>
                </c:pt>
                <c:pt idx="282">
                  <c:v>69.391429781295599</c:v>
                </c:pt>
                <c:pt idx="283">
                  <c:v>73.0993747302863</c:v>
                </c:pt>
                <c:pt idx="284">
                  <c:v>79.687006345453398</c:v>
                </c:pt>
                <c:pt idx="285">
                  <c:v>70.788632661608602</c:v>
                </c:pt>
                <c:pt idx="286">
                  <c:v>57.5782612569324</c:v>
                </c:pt>
                <c:pt idx="287">
                  <c:v>72.5586615541783</c:v>
                </c:pt>
                <c:pt idx="288">
                  <c:v>66.579228507855305</c:v>
                </c:pt>
                <c:pt idx="289">
                  <c:v>74.369736094141501</c:v>
                </c:pt>
                <c:pt idx="290">
                  <c:v>73.482146429185804</c:v>
                </c:pt>
                <c:pt idx="291">
                  <c:v>75.9052483217952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C3D-4F2E-A4A2-90C336228C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311168"/>
        <c:axId val="200312704"/>
      </c:scatterChart>
      <c:valAx>
        <c:axId val="2003111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312704"/>
        <c:crosses val="autoZero"/>
        <c:crossBetween val="midCat"/>
      </c:valAx>
      <c:valAx>
        <c:axId val="200312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3111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862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i="0" u="none" strike="noStrike" kern="1200" spc="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S-GY</a:t>
            </a:r>
          </a:p>
        </c:rich>
      </c:tx>
      <c:layout>
        <c:manualLayout>
          <c:xMode val="edge"/>
          <c:yMode val="edge"/>
          <c:x val="0.4149721784776903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862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G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2945144356955379"/>
                  <c:y val="-0.1838534072129872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sz="1197" b="0" i="0" u="none" strike="noStrike" kern="1200" baseline="0">
                        <a:solidFill>
                          <a:prstClr val="black">
                            <a:lumMod val="65000"/>
                            <a:lumOff val="35000"/>
                          </a:prst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1052x + 22.313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4736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sz="1197" b="0" i="0" u="none" strike="noStrike" kern="120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C$2:$C$293</c:f>
              <c:numCache>
                <c:formatCode>0.0</c:formatCode>
                <c:ptCount val="292"/>
                <c:pt idx="0">
                  <c:v>483.51541996971503</c:v>
                </c:pt>
                <c:pt idx="1">
                  <c:v>516.15098389580601</c:v>
                </c:pt>
                <c:pt idx="2">
                  <c:v>429.56493361889</c:v>
                </c:pt>
                <c:pt idx="3">
                  <c:v>510.84058262043499</c:v>
                </c:pt>
                <c:pt idx="4">
                  <c:v>503.14393796551002</c:v>
                </c:pt>
                <c:pt idx="5">
                  <c:v>574.906853751673</c:v>
                </c:pt>
                <c:pt idx="6">
                  <c:v>456.35821092663502</c:v>
                </c:pt>
                <c:pt idx="7">
                  <c:v>475.05521074697901</c:v>
                </c:pt>
                <c:pt idx="8">
                  <c:v>459.20755412270103</c:v>
                </c:pt>
                <c:pt idx="9">
                  <c:v>526.59223535389197</c:v>
                </c:pt>
                <c:pt idx="10">
                  <c:v>464.80353978535601</c:v>
                </c:pt>
                <c:pt idx="11">
                  <c:v>536.31830419533105</c:v>
                </c:pt>
                <c:pt idx="12">
                  <c:v>523.79691538924305</c:v>
                </c:pt>
                <c:pt idx="13">
                  <c:v>481.178070859309</c:v>
                </c:pt>
                <c:pt idx="14">
                  <c:v>390.87435947320603</c:v>
                </c:pt>
                <c:pt idx="15">
                  <c:v>482.82350562063903</c:v>
                </c:pt>
                <c:pt idx="16">
                  <c:v>468.50386293658198</c:v>
                </c:pt>
                <c:pt idx="17">
                  <c:v>423.373751455719</c:v>
                </c:pt>
                <c:pt idx="18">
                  <c:v>511.52692696678201</c:v>
                </c:pt>
                <c:pt idx="19">
                  <c:v>604.65579103720495</c:v>
                </c:pt>
                <c:pt idx="20">
                  <c:v>502.174419499208</c:v>
                </c:pt>
                <c:pt idx="21">
                  <c:v>463.83115355762197</c:v>
                </c:pt>
                <c:pt idx="22">
                  <c:v>558.02934005959298</c:v>
                </c:pt>
                <c:pt idx="23">
                  <c:v>556.81107767073502</c:v>
                </c:pt>
                <c:pt idx="24">
                  <c:v>559.55207208645197</c:v>
                </c:pt>
                <c:pt idx="25">
                  <c:v>422.06572562588298</c:v>
                </c:pt>
                <c:pt idx="26">
                  <c:v>389.66954532691801</c:v>
                </c:pt>
                <c:pt idx="27">
                  <c:v>493.76452509237402</c:v>
                </c:pt>
                <c:pt idx="28">
                  <c:v>583.68879080204795</c:v>
                </c:pt>
                <c:pt idx="29">
                  <c:v>390.34094520724801</c:v>
                </c:pt>
                <c:pt idx="30">
                  <c:v>445.32762950175498</c:v>
                </c:pt>
                <c:pt idx="31">
                  <c:v>537.80253773003994</c:v>
                </c:pt>
                <c:pt idx="32">
                  <c:v>459.91891513045499</c:v>
                </c:pt>
                <c:pt idx="33">
                  <c:v>448.88501334492997</c:v>
                </c:pt>
                <c:pt idx="34">
                  <c:v>449.92202631747801</c:v>
                </c:pt>
                <c:pt idx="35">
                  <c:v>541.53970838622195</c:v>
                </c:pt>
                <c:pt idx="36">
                  <c:v>517.27356343936003</c:v>
                </c:pt>
                <c:pt idx="37">
                  <c:v>489.67272331444798</c:v>
                </c:pt>
                <c:pt idx="38">
                  <c:v>465.63594352831899</c:v>
                </c:pt>
                <c:pt idx="39">
                  <c:v>494.11573652550999</c:v>
                </c:pt>
                <c:pt idx="40">
                  <c:v>510.97261363731798</c:v>
                </c:pt>
                <c:pt idx="41">
                  <c:v>482.33121344825298</c:v>
                </c:pt>
                <c:pt idx="42">
                  <c:v>477.910601041554</c:v>
                </c:pt>
                <c:pt idx="43">
                  <c:v>474.705129022726</c:v>
                </c:pt>
                <c:pt idx="44">
                  <c:v>548.29874423607998</c:v>
                </c:pt>
                <c:pt idx="45">
                  <c:v>454.14063048206998</c:v>
                </c:pt>
                <c:pt idx="46">
                  <c:v>448.12619466515298</c:v>
                </c:pt>
                <c:pt idx="47">
                  <c:v>466.04414156160101</c:v>
                </c:pt>
                <c:pt idx="48">
                  <c:v>517.22235502931801</c:v>
                </c:pt>
                <c:pt idx="49">
                  <c:v>449.87692328466801</c:v>
                </c:pt>
                <c:pt idx="50">
                  <c:v>473.41297345190702</c:v>
                </c:pt>
                <c:pt idx="51">
                  <c:v>510.10803043818902</c:v>
                </c:pt>
                <c:pt idx="52">
                  <c:v>462.78442529767801</c:v>
                </c:pt>
                <c:pt idx="53">
                  <c:v>390.10234156713602</c:v>
                </c:pt>
                <c:pt idx="54">
                  <c:v>534.38218501555002</c:v>
                </c:pt>
                <c:pt idx="55">
                  <c:v>442.83318006760101</c:v>
                </c:pt>
                <c:pt idx="56">
                  <c:v>533.98499360336905</c:v>
                </c:pt>
                <c:pt idx="57">
                  <c:v>405.468466140967</c:v>
                </c:pt>
                <c:pt idx="58">
                  <c:v>440.72182932245897</c:v>
                </c:pt>
                <c:pt idx="59">
                  <c:v>458.74157481329001</c:v>
                </c:pt>
                <c:pt idx="60">
                  <c:v>500.85341008764698</c:v>
                </c:pt>
                <c:pt idx="61">
                  <c:v>446.353006453055</c:v>
                </c:pt>
                <c:pt idx="62">
                  <c:v>518.73610049235901</c:v>
                </c:pt>
                <c:pt idx="63">
                  <c:v>549.75220849237303</c:v>
                </c:pt>
                <c:pt idx="64">
                  <c:v>571.47343548001299</c:v>
                </c:pt>
                <c:pt idx="65">
                  <c:v>485.38958136602599</c:v>
                </c:pt>
                <c:pt idx="66">
                  <c:v>523.72966746305303</c:v>
                </c:pt>
                <c:pt idx="67">
                  <c:v>459.07910345822597</c:v>
                </c:pt>
                <c:pt idx="68">
                  <c:v>464.95426257472701</c:v>
                </c:pt>
                <c:pt idx="69">
                  <c:v>494.48551595297999</c:v>
                </c:pt>
                <c:pt idx="70">
                  <c:v>500.47912111639101</c:v>
                </c:pt>
                <c:pt idx="71">
                  <c:v>419.07631221008</c:v>
                </c:pt>
                <c:pt idx="72">
                  <c:v>520.41011382382499</c:v>
                </c:pt>
                <c:pt idx="73">
                  <c:v>471.79965770050802</c:v>
                </c:pt>
                <c:pt idx="74">
                  <c:v>528.31362937748804</c:v>
                </c:pt>
                <c:pt idx="75">
                  <c:v>524.30012926115398</c:v>
                </c:pt>
                <c:pt idx="76">
                  <c:v>530.18360884217896</c:v>
                </c:pt>
                <c:pt idx="77">
                  <c:v>508.24959457077301</c:v>
                </c:pt>
                <c:pt idx="78">
                  <c:v>477.659047597305</c:v>
                </c:pt>
                <c:pt idx="79">
                  <c:v>481.16063406940299</c:v>
                </c:pt>
                <c:pt idx="80">
                  <c:v>492.86098174587403</c:v>
                </c:pt>
                <c:pt idx="81">
                  <c:v>482.05763816140302</c:v>
                </c:pt>
                <c:pt idx="82">
                  <c:v>443.812846139008</c:v>
                </c:pt>
                <c:pt idx="83">
                  <c:v>404.26347889074401</c:v>
                </c:pt>
                <c:pt idx="84">
                  <c:v>440.83104679160999</c:v>
                </c:pt>
                <c:pt idx="85">
                  <c:v>481.87762061279602</c:v>
                </c:pt>
                <c:pt idx="86">
                  <c:v>423.02442301522098</c:v>
                </c:pt>
                <c:pt idx="87">
                  <c:v>496.21351983965297</c:v>
                </c:pt>
                <c:pt idx="88">
                  <c:v>378.329562042769</c:v>
                </c:pt>
                <c:pt idx="89">
                  <c:v>541.86086330822695</c:v>
                </c:pt>
                <c:pt idx="90">
                  <c:v>451.79887829777402</c:v>
                </c:pt>
                <c:pt idx="91">
                  <c:v>482.73038397851201</c:v>
                </c:pt>
                <c:pt idx="92">
                  <c:v>393.60963643030902</c:v>
                </c:pt>
                <c:pt idx="93">
                  <c:v>485.79165760401202</c:v>
                </c:pt>
                <c:pt idx="94">
                  <c:v>457.37800759731198</c:v>
                </c:pt>
                <c:pt idx="95">
                  <c:v>513.15192953498604</c:v>
                </c:pt>
                <c:pt idx="96">
                  <c:v>465.68490147501598</c:v>
                </c:pt>
                <c:pt idx="97">
                  <c:v>439.81257892456802</c:v>
                </c:pt>
                <c:pt idx="98">
                  <c:v>415.35523631757502</c:v>
                </c:pt>
                <c:pt idx="99">
                  <c:v>464.61257322728301</c:v>
                </c:pt>
                <c:pt idx="100">
                  <c:v>522.14805906094205</c:v>
                </c:pt>
                <c:pt idx="101">
                  <c:v>492.27321722581598</c:v>
                </c:pt>
                <c:pt idx="102">
                  <c:v>432.20073559066299</c:v>
                </c:pt>
                <c:pt idx="103">
                  <c:v>459.37823874643999</c:v>
                </c:pt>
                <c:pt idx="104">
                  <c:v>551.15627927894104</c:v>
                </c:pt>
                <c:pt idx="105">
                  <c:v>552.30557408481502</c:v>
                </c:pt>
                <c:pt idx="106">
                  <c:v>495.12386823293701</c:v>
                </c:pt>
                <c:pt idx="107">
                  <c:v>466.97989445755002</c:v>
                </c:pt>
                <c:pt idx="108">
                  <c:v>490.059094942238</c:v>
                </c:pt>
                <c:pt idx="109">
                  <c:v>512.949320814158</c:v>
                </c:pt>
                <c:pt idx="110">
                  <c:v>565.24500758462796</c:v>
                </c:pt>
                <c:pt idx="111">
                  <c:v>493.750390689607</c:v>
                </c:pt>
                <c:pt idx="112">
                  <c:v>448.85267655370802</c:v>
                </c:pt>
                <c:pt idx="113">
                  <c:v>584.08590334605196</c:v>
                </c:pt>
                <c:pt idx="114">
                  <c:v>563.70154801456795</c:v>
                </c:pt>
                <c:pt idx="115">
                  <c:v>479.37684029859599</c:v>
                </c:pt>
                <c:pt idx="116">
                  <c:v>511.83915581899799</c:v>
                </c:pt>
                <c:pt idx="117">
                  <c:v>485.380425281839</c:v>
                </c:pt>
                <c:pt idx="118">
                  <c:v>525.00178438197497</c:v>
                </c:pt>
                <c:pt idx="119">
                  <c:v>493.62346241848297</c:v>
                </c:pt>
                <c:pt idx="120">
                  <c:v>440.64563107945401</c:v>
                </c:pt>
                <c:pt idx="121">
                  <c:v>421.15696907275799</c:v>
                </c:pt>
                <c:pt idx="122">
                  <c:v>462.23170483795298</c:v>
                </c:pt>
                <c:pt idx="123">
                  <c:v>463.63974981834099</c:v>
                </c:pt>
                <c:pt idx="124">
                  <c:v>583.95451926604801</c:v>
                </c:pt>
                <c:pt idx="125">
                  <c:v>466.75515848743402</c:v>
                </c:pt>
                <c:pt idx="126">
                  <c:v>556.322484889885</c:v>
                </c:pt>
                <c:pt idx="127">
                  <c:v>447.742053891826</c:v>
                </c:pt>
                <c:pt idx="128">
                  <c:v>512.56252701756398</c:v>
                </c:pt>
                <c:pt idx="129">
                  <c:v>402.59966858624603</c:v>
                </c:pt>
                <c:pt idx="130">
                  <c:v>428.82050388982799</c:v>
                </c:pt>
                <c:pt idx="131">
                  <c:v>463.44870049911498</c:v>
                </c:pt>
                <c:pt idx="132">
                  <c:v>473.597982892066</c:v>
                </c:pt>
                <c:pt idx="133">
                  <c:v>479.46863130306201</c:v>
                </c:pt>
                <c:pt idx="134">
                  <c:v>443.946994685905</c:v>
                </c:pt>
                <c:pt idx="135">
                  <c:v>485.19246953039999</c:v>
                </c:pt>
                <c:pt idx="136">
                  <c:v>452.23647640974599</c:v>
                </c:pt>
                <c:pt idx="137">
                  <c:v>510.76350709214898</c:v>
                </c:pt>
                <c:pt idx="138">
                  <c:v>478.763200580812</c:v>
                </c:pt>
                <c:pt idx="139">
                  <c:v>507.56303205167302</c:v>
                </c:pt>
                <c:pt idx="140">
                  <c:v>494.60103022161201</c:v>
                </c:pt>
                <c:pt idx="141">
                  <c:v>507.28192259507898</c:v>
                </c:pt>
                <c:pt idx="142">
                  <c:v>449.20137729504899</c:v>
                </c:pt>
                <c:pt idx="143">
                  <c:v>510.20618825406001</c:v>
                </c:pt>
                <c:pt idx="144">
                  <c:v>501.19750291064503</c:v>
                </c:pt>
                <c:pt idx="145">
                  <c:v>484.649031630237</c:v>
                </c:pt>
                <c:pt idx="146">
                  <c:v>386.56646993326598</c:v>
                </c:pt>
                <c:pt idx="147">
                  <c:v>454.25061661014598</c:v>
                </c:pt>
                <c:pt idx="148">
                  <c:v>463.18956583723502</c:v>
                </c:pt>
                <c:pt idx="149">
                  <c:v>498.45928585368</c:v>
                </c:pt>
                <c:pt idx="150">
                  <c:v>520.30697423882702</c:v>
                </c:pt>
                <c:pt idx="151">
                  <c:v>513.41290504989399</c:v>
                </c:pt>
                <c:pt idx="152">
                  <c:v>474.28754815048597</c:v>
                </c:pt>
                <c:pt idx="153">
                  <c:v>516.46953592943498</c:v>
                </c:pt>
                <c:pt idx="154">
                  <c:v>418.656243571647</c:v>
                </c:pt>
                <c:pt idx="155">
                  <c:v>488.80660282363198</c:v>
                </c:pt>
                <c:pt idx="156">
                  <c:v>484.00922918959702</c:v>
                </c:pt>
                <c:pt idx="157">
                  <c:v>484.61768288444898</c:v>
                </c:pt>
                <c:pt idx="158">
                  <c:v>461.01003617625599</c:v>
                </c:pt>
                <c:pt idx="159">
                  <c:v>439.09589883752199</c:v>
                </c:pt>
                <c:pt idx="160">
                  <c:v>519.09032381880104</c:v>
                </c:pt>
                <c:pt idx="161">
                  <c:v>515.90084566652695</c:v>
                </c:pt>
                <c:pt idx="162">
                  <c:v>582.17906836974896</c:v>
                </c:pt>
                <c:pt idx="163">
                  <c:v>483.35192579402099</c:v>
                </c:pt>
                <c:pt idx="164">
                  <c:v>511.79819434653899</c:v>
                </c:pt>
                <c:pt idx="165">
                  <c:v>538.10579837825298</c:v>
                </c:pt>
                <c:pt idx="166">
                  <c:v>444.84141411791302</c:v>
                </c:pt>
                <c:pt idx="167">
                  <c:v>464.33871022243198</c:v>
                </c:pt>
                <c:pt idx="168">
                  <c:v>511.27306800157299</c:v>
                </c:pt>
                <c:pt idx="169">
                  <c:v>418.51286251922102</c:v>
                </c:pt>
                <c:pt idx="170">
                  <c:v>539.99419649614401</c:v>
                </c:pt>
                <c:pt idx="171">
                  <c:v>466.11188167636902</c:v>
                </c:pt>
                <c:pt idx="172">
                  <c:v>462.08024001883302</c:v>
                </c:pt>
                <c:pt idx="173">
                  <c:v>475.74425054523402</c:v>
                </c:pt>
                <c:pt idx="174">
                  <c:v>508.59649516440697</c:v>
                </c:pt>
                <c:pt idx="175">
                  <c:v>534.45962028425402</c:v>
                </c:pt>
                <c:pt idx="176">
                  <c:v>490.07241579650798</c:v>
                </c:pt>
                <c:pt idx="177">
                  <c:v>508.181650058272</c:v>
                </c:pt>
                <c:pt idx="178">
                  <c:v>464.34567696218897</c:v>
                </c:pt>
                <c:pt idx="179">
                  <c:v>459.610391007212</c:v>
                </c:pt>
                <c:pt idx="180">
                  <c:v>476.81070477080999</c:v>
                </c:pt>
                <c:pt idx="181">
                  <c:v>419.91160678000898</c:v>
                </c:pt>
                <c:pt idx="182">
                  <c:v>549.80381136601898</c:v>
                </c:pt>
                <c:pt idx="183">
                  <c:v>469.399905275413</c:v>
                </c:pt>
                <c:pt idx="184">
                  <c:v>460.38760728715499</c:v>
                </c:pt>
                <c:pt idx="185">
                  <c:v>477.12776585642001</c:v>
                </c:pt>
                <c:pt idx="186">
                  <c:v>429.47882702177799</c:v>
                </c:pt>
                <c:pt idx="187">
                  <c:v>480.939925219938</c:v>
                </c:pt>
                <c:pt idx="188">
                  <c:v>499.43306592573902</c:v>
                </c:pt>
                <c:pt idx="189">
                  <c:v>479.31422059461403</c:v>
                </c:pt>
                <c:pt idx="190">
                  <c:v>554.62620650081794</c:v>
                </c:pt>
                <c:pt idx="191">
                  <c:v>485.35977500164898</c:v>
                </c:pt>
                <c:pt idx="192">
                  <c:v>414.65371193044803</c:v>
                </c:pt>
                <c:pt idx="193">
                  <c:v>442.23463608529897</c:v>
                </c:pt>
                <c:pt idx="194">
                  <c:v>496.07596785124002</c:v>
                </c:pt>
                <c:pt idx="195">
                  <c:v>508.09131599301298</c:v>
                </c:pt>
                <c:pt idx="196">
                  <c:v>503.35409545850001</c:v>
                </c:pt>
                <c:pt idx="197">
                  <c:v>482.46162482856698</c:v>
                </c:pt>
                <c:pt idx="198">
                  <c:v>593.66109880588704</c:v>
                </c:pt>
                <c:pt idx="199">
                  <c:v>489.423495977242</c:v>
                </c:pt>
                <c:pt idx="200">
                  <c:v>455.57263821175701</c:v>
                </c:pt>
                <c:pt idx="201">
                  <c:v>495.91666717093602</c:v>
                </c:pt>
                <c:pt idx="202">
                  <c:v>517.90152504341597</c:v>
                </c:pt>
                <c:pt idx="203">
                  <c:v>533.61372617785003</c:v>
                </c:pt>
                <c:pt idx="204">
                  <c:v>553.07089238085496</c:v>
                </c:pt>
                <c:pt idx="205">
                  <c:v>510.61676063175798</c:v>
                </c:pt>
                <c:pt idx="206">
                  <c:v>420.85156026391098</c:v>
                </c:pt>
                <c:pt idx="207">
                  <c:v>487.20898243123003</c:v>
                </c:pt>
                <c:pt idx="208">
                  <c:v>529.79533098939805</c:v>
                </c:pt>
                <c:pt idx="209">
                  <c:v>494.30519209138998</c:v>
                </c:pt>
                <c:pt idx="210">
                  <c:v>486.26351962112102</c:v>
                </c:pt>
                <c:pt idx="211">
                  <c:v>586.02821846012796</c:v>
                </c:pt>
                <c:pt idx="212">
                  <c:v>467.02714386979301</c:v>
                </c:pt>
                <c:pt idx="213">
                  <c:v>495.669166436372</c:v>
                </c:pt>
                <c:pt idx="214">
                  <c:v>573.70275631235597</c:v>
                </c:pt>
                <c:pt idx="215">
                  <c:v>481.82887923446498</c:v>
                </c:pt>
                <c:pt idx="216">
                  <c:v>465.47632207707397</c:v>
                </c:pt>
                <c:pt idx="217">
                  <c:v>433.37483207653997</c:v>
                </c:pt>
                <c:pt idx="218">
                  <c:v>502.04956916615998</c:v>
                </c:pt>
                <c:pt idx="219">
                  <c:v>496.11064023914599</c:v>
                </c:pt>
                <c:pt idx="220">
                  <c:v>574.04094262397496</c:v>
                </c:pt>
                <c:pt idx="221">
                  <c:v>462.82381336362801</c:v>
                </c:pt>
                <c:pt idx="222">
                  <c:v>559.14140990297801</c:v>
                </c:pt>
                <c:pt idx="223">
                  <c:v>512.35154191994502</c:v>
                </c:pt>
                <c:pt idx="224">
                  <c:v>464.549074076529</c:v>
                </c:pt>
                <c:pt idx="225">
                  <c:v>509.07588742112398</c:v>
                </c:pt>
                <c:pt idx="226">
                  <c:v>473.76612474433398</c:v>
                </c:pt>
                <c:pt idx="227">
                  <c:v>476.743545463202</c:v>
                </c:pt>
                <c:pt idx="228">
                  <c:v>597.36466831347798</c:v>
                </c:pt>
                <c:pt idx="229">
                  <c:v>448.110032077749</c:v>
                </c:pt>
                <c:pt idx="230">
                  <c:v>518.21780581176995</c:v>
                </c:pt>
                <c:pt idx="231">
                  <c:v>481.65964132359102</c:v>
                </c:pt>
                <c:pt idx="232">
                  <c:v>496.30925580380102</c:v>
                </c:pt>
                <c:pt idx="233">
                  <c:v>432.70610860943498</c:v>
                </c:pt>
                <c:pt idx="234">
                  <c:v>407.73702584574602</c:v>
                </c:pt>
                <c:pt idx="235">
                  <c:v>455.59726428933101</c:v>
                </c:pt>
                <c:pt idx="236">
                  <c:v>480.88722033362501</c:v>
                </c:pt>
                <c:pt idx="237">
                  <c:v>463.23980590705298</c:v>
                </c:pt>
                <c:pt idx="238">
                  <c:v>481.36565485986603</c:v>
                </c:pt>
                <c:pt idx="239">
                  <c:v>536.72038979387003</c:v>
                </c:pt>
                <c:pt idx="240">
                  <c:v>547.663178004629</c:v>
                </c:pt>
                <c:pt idx="241">
                  <c:v>433.430221407011</c:v>
                </c:pt>
                <c:pt idx="242">
                  <c:v>495.988769298205</c:v>
                </c:pt>
                <c:pt idx="243">
                  <c:v>572.67836100684599</c:v>
                </c:pt>
                <c:pt idx="244">
                  <c:v>521.55471430309296</c:v>
                </c:pt>
                <c:pt idx="245">
                  <c:v>534.00647154442299</c:v>
                </c:pt>
                <c:pt idx="246">
                  <c:v>428.038349453698</c:v>
                </c:pt>
                <c:pt idx="247">
                  <c:v>519.81289767375199</c:v>
                </c:pt>
                <c:pt idx="248">
                  <c:v>437.83409863908298</c:v>
                </c:pt>
                <c:pt idx="249">
                  <c:v>458.385163750841</c:v>
                </c:pt>
                <c:pt idx="250">
                  <c:v>498.96003460976601</c:v>
                </c:pt>
                <c:pt idx="251">
                  <c:v>455.06602886933399</c:v>
                </c:pt>
                <c:pt idx="252">
                  <c:v>534.69676755027001</c:v>
                </c:pt>
                <c:pt idx="253">
                  <c:v>599.820728440229</c:v>
                </c:pt>
                <c:pt idx="254">
                  <c:v>446.79943336353</c:v>
                </c:pt>
                <c:pt idx="255">
                  <c:v>458.16119269843301</c:v>
                </c:pt>
                <c:pt idx="256">
                  <c:v>488.866523043298</c:v>
                </c:pt>
                <c:pt idx="257">
                  <c:v>531.81851259698101</c:v>
                </c:pt>
                <c:pt idx="258">
                  <c:v>475.273259091981</c:v>
                </c:pt>
                <c:pt idx="259">
                  <c:v>435.19954341511999</c:v>
                </c:pt>
                <c:pt idx="260">
                  <c:v>488.96360911025698</c:v>
                </c:pt>
                <c:pt idx="261">
                  <c:v>487.68831443400398</c:v>
                </c:pt>
                <c:pt idx="262">
                  <c:v>480.67179268958699</c:v>
                </c:pt>
                <c:pt idx="263">
                  <c:v>514.24672287769704</c:v>
                </c:pt>
                <c:pt idx="264">
                  <c:v>430.85144295264303</c:v>
                </c:pt>
                <c:pt idx="265">
                  <c:v>446.951259958854</c:v>
                </c:pt>
                <c:pt idx="266">
                  <c:v>427.16909060665898</c:v>
                </c:pt>
                <c:pt idx="267">
                  <c:v>522.02082575841098</c:v>
                </c:pt>
                <c:pt idx="268">
                  <c:v>441.05213116759899</c:v>
                </c:pt>
                <c:pt idx="269">
                  <c:v>465.15759929795502</c:v>
                </c:pt>
                <c:pt idx="270">
                  <c:v>449.53484545887898</c:v>
                </c:pt>
                <c:pt idx="271">
                  <c:v>517.57081283409195</c:v>
                </c:pt>
                <c:pt idx="272">
                  <c:v>490.14492453459599</c:v>
                </c:pt>
                <c:pt idx="273">
                  <c:v>499.483573623138</c:v>
                </c:pt>
                <c:pt idx="274">
                  <c:v>510.17994538027699</c:v>
                </c:pt>
                <c:pt idx="275">
                  <c:v>432.47085917431502</c:v>
                </c:pt>
                <c:pt idx="276">
                  <c:v>514.57868391076101</c:v>
                </c:pt>
                <c:pt idx="277">
                  <c:v>485.791852874131</c:v>
                </c:pt>
                <c:pt idx="278">
                  <c:v>500.65543128774902</c:v>
                </c:pt>
                <c:pt idx="279">
                  <c:v>523.21134212079596</c:v>
                </c:pt>
                <c:pt idx="280">
                  <c:v>439.294925015655</c:v>
                </c:pt>
                <c:pt idx="281">
                  <c:v>456.07942078854398</c:v>
                </c:pt>
                <c:pt idx="282">
                  <c:v>481.220269671251</c:v>
                </c:pt>
                <c:pt idx="283">
                  <c:v>538.23068401560499</c:v>
                </c:pt>
                <c:pt idx="284">
                  <c:v>508.774860390985</c:v>
                </c:pt>
                <c:pt idx="285">
                  <c:v>437.66072861702003</c:v>
                </c:pt>
                <c:pt idx="286">
                  <c:v>413.43407786730501</c:v>
                </c:pt>
                <c:pt idx="287">
                  <c:v>442.43744888292599</c:v>
                </c:pt>
                <c:pt idx="288">
                  <c:v>486.719620230788</c:v>
                </c:pt>
                <c:pt idx="289">
                  <c:v>527.03873985652297</c:v>
                </c:pt>
                <c:pt idx="290">
                  <c:v>484.44062032455003</c:v>
                </c:pt>
                <c:pt idx="291">
                  <c:v>484.15766289849103</c:v>
                </c:pt>
              </c:numCache>
            </c:numRef>
          </c:xVal>
          <c:yVal>
            <c:numRef>
              <c:f>Sheet1!$G$2:$G$293</c:f>
              <c:numCache>
                <c:formatCode>0.0</c:formatCode>
                <c:ptCount val="292"/>
                <c:pt idx="0">
                  <c:v>75.175185865463803</c:v>
                </c:pt>
                <c:pt idx="1">
                  <c:v>77.280762251155494</c:v>
                </c:pt>
                <c:pt idx="2">
                  <c:v>66.236922542963995</c:v>
                </c:pt>
                <c:pt idx="3">
                  <c:v>76.749217605516506</c:v>
                </c:pt>
                <c:pt idx="4">
                  <c:v>72.297496060432806</c:v>
                </c:pt>
                <c:pt idx="5">
                  <c:v>78.097124422005393</c:v>
                </c:pt>
                <c:pt idx="6">
                  <c:v>66.896393641304996</c:v>
                </c:pt>
                <c:pt idx="7">
                  <c:v>79.481449996611303</c:v>
                </c:pt>
                <c:pt idx="8">
                  <c:v>73.631875156809699</c:v>
                </c:pt>
                <c:pt idx="9">
                  <c:v>87.445739811342307</c:v>
                </c:pt>
                <c:pt idx="10">
                  <c:v>75.689039109647297</c:v>
                </c:pt>
                <c:pt idx="11">
                  <c:v>79.140903014594997</c:v>
                </c:pt>
                <c:pt idx="12">
                  <c:v>85.720186678772905</c:v>
                </c:pt>
                <c:pt idx="13">
                  <c:v>75.974709074757698</c:v>
                </c:pt>
                <c:pt idx="14">
                  <c:v>62.257033455099602</c:v>
                </c:pt>
                <c:pt idx="15">
                  <c:v>74.873685966021796</c:v>
                </c:pt>
                <c:pt idx="16">
                  <c:v>66.088676113301801</c:v>
                </c:pt>
                <c:pt idx="17">
                  <c:v>63.063856865872999</c:v>
                </c:pt>
                <c:pt idx="18">
                  <c:v>81.393960288029504</c:v>
                </c:pt>
                <c:pt idx="19">
                  <c:v>74.277702786989394</c:v>
                </c:pt>
                <c:pt idx="20">
                  <c:v>80.877763315476997</c:v>
                </c:pt>
                <c:pt idx="21">
                  <c:v>72.934313952962697</c:v>
                </c:pt>
                <c:pt idx="22">
                  <c:v>83.081909085019007</c:v>
                </c:pt>
                <c:pt idx="23">
                  <c:v>75.836335801850595</c:v>
                </c:pt>
                <c:pt idx="24">
                  <c:v>86.025680182162503</c:v>
                </c:pt>
                <c:pt idx="25">
                  <c:v>59.033954086390402</c:v>
                </c:pt>
                <c:pt idx="26">
                  <c:v>62.523599165507498</c:v>
                </c:pt>
                <c:pt idx="27">
                  <c:v>79.399416002888501</c:v>
                </c:pt>
                <c:pt idx="28">
                  <c:v>87.715480357376094</c:v>
                </c:pt>
                <c:pt idx="29">
                  <c:v>58.817891407709297</c:v>
                </c:pt>
                <c:pt idx="30">
                  <c:v>66.898768346378503</c:v>
                </c:pt>
                <c:pt idx="31">
                  <c:v>78.246588668676793</c:v>
                </c:pt>
                <c:pt idx="32">
                  <c:v>70.658795145663007</c:v>
                </c:pt>
                <c:pt idx="33">
                  <c:v>64.382064881926496</c:v>
                </c:pt>
                <c:pt idx="34">
                  <c:v>73.957447551210507</c:v>
                </c:pt>
                <c:pt idx="35">
                  <c:v>76.830220835431405</c:v>
                </c:pt>
                <c:pt idx="36">
                  <c:v>75.780741157089693</c:v>
                </c:pt>
                <c:pt idx="37">
                  <c:v>69.268678678481606</c:v>
                </c:pt>
                <c:pt idx="38">
                  <c:v>71.978046425664004</c:v>
                </c:pt>
                <c:pt idx="39">
                  <c:v>71.388449858721998</c:v>
                </c:pt>
                <c:pt idx="40">
                  <c:v>73.972713601756297</c:v>
                </c:pt>
                <c:pt idx="41">
                  <c:v>72.606104905431806</c:v>
                </c:pt>
                <c:pt idx="42">
                  <c:v>76.137534313306006</c:v>
                </c:pt>
                <c:pt idx="43">
                  <c:v>77.151087957233401</c:v>
                </c:pt>
                <c:pt idx="44">
                  <c:v>79.877103524988698</c:v>
                </c:pt>
                <c:pt idx="45">
                  <c:v>66.477582236520902</c:v>
                </c:pt>
                <c:pt idx="46">
                  <c:v>69.818865565865806</c:v>
                </c:pt>
                <c:pt idx="47">
                  <c:v>83.515263451626396</c:v>
                </c:pt>
                <c:pt idx="48">
                  <c:v>71.589766718453305</c:v>
                </c:pt>
                <c:pt idx="49">
                  <c:v>68.307891420804395</c:v>
                </c:pt>
                <c:pt idx="50">
                  <c:v>68.408914284697602</c:v>
                </c:pt>
                <c:pt idx="51">
                  <c:v>85.4833346718858</c:v>
                </c:pt>
                <c:pt idx="52">
                  <c:v>65.448782714843404</c:v>
                </c:pt>
                <c:pt idx="53">
                  <c:v>65.711931814085801</c:v>
                </c:pt>
                <c:pt idx="54">
                  <c:v>84.824001966451505</c:v>
                </c:pt>
                <c:pt idx="55">
                  <c:v>65.933061827718006</c:v>
                </c:pt>
                <c:pt idx="56">
                  <c:v>77.090059221936002</c:v>
                </c:pt>
                <c:pt idx="57">
                  <c:v>65.333708912602802</c:v>
                </c:pt>
                <c:pt idx="58">
                  <c:v>67.855022456875403</c:v>
                </c:pt>
                <c:pt idx="59">
                  <c:v>66.741745516582995</c:v>
                </c:pt>
                <c:pt idx="60">
                  <c:v>78.6640175153385</c:v>
                </c:pt>
                <c:pt idx="61">
                  <c:v>61.714097768926898</c:v>
                </c:pt>
                <c:pt idx="62">
                  <c:v>81.815545712584196</c:v>
                </c:pt>
                <c:pt idx="63">
                  <c:v>87.478806672377203</c:v>
                </c:pt>
                <c:pt idx="64">
                  <c:v>78.059966293532895</c:v>
                </c:pt>
                <c:pt idx="65">
                  <c:v>72.519249747186393</c:v>
                </c:pt>
                <c:pt idx="66">
                  <c:v>78.795124886131902</c:v>
                </c:pt>
                <c:pt idx="67">
                  <c:v>72.405038887037193</c:v>
                </c:pt>
                <c:pt idx="68">
                  <c:v>68.646152000036295</c:v>
                </c:pt>
                <c:pt idx="69">
                  <c:v>64.570742660589303</c:v>
                </c:pt>
                <c:pt idx="70">
                  <c:v>75.608272310008005</c:v>
                </c:pt>
                <c:pt idx="71">
                  <c:v>62.418552321480099</c:v>
                </c:pt>
                <c:pt idx="72">
                  <c:v>75.271094807720203</c:v>
                </c:pt>
                <c:pt idx="73">
                  <c:v>72.731504704381194</c:v>
                </c:pt>
                <c:pt idx="74">
                  <c:v>75.797533301546693</c:v>
                </c:pt>
                <c:pt idx="75">
                  <c:v>88.343550869620103</c:v>
                </c:pt>
                <c:pt idx="76">
                  <c:v>84.906600239030993</c:v>
                </c:pt>
                <c:pt idx="77">
                  <c:v>71.662558429502198</c:v>
                </c:pt>
                <c:pt idx="78">
                  <c:v>75.036752875095004</c:v>
                </c:pt>
                <c:pt idx="79">
                  <c:v>83.923902238541899</c:v>
                </c:pt>
                <c:pt idx="80">
                  <c:v>68.432966485553294</c:v>
                </c:pt>
                <c:pt idx="81">
                  <c:v>64.445507103732595</c:v>
                </c:pt>
                <c:pt idx="82">
                  <c:v>63.811108111641801</c:v>
                </c:pt>
                <c:pt idx="83">
                  <c:v>69.899253910492106</c:v>
                </c:pt>
                <c:pt idx="84">
                  <c:v>69.867466961729306</c:v>
                </c:pt>
                <c:pt idx="85">
                  <c:v>68.959105495433306</c:v>
                </c:pt>
                <c:pt idx="86">
                  <c:v>68.0069243226108</c:v>
                </c:pt>
                <c:pt idx="87">
                  <c:v>87.5447585478382</c:v>
                </c:pt>
                <c:pt idx="88">
                  <c:v>66.863966118163205</c:v>
                </c:pt>
                <c:pt idx="89">
                  <c:v>75.073578621329105</c:v>
                </c:pt>
                <c:pt idx="90">
                  <c:v>69.760285822393996</c:v>
                </c:pt>
                <c:pt idx="91">
                  <c:v>78.987618757669097</c:v>
                </c:pt>
                <c:pt idx="92">
                  <c:v>58.031849909585503</c:v>
                </c:pt>
                <c:pt idx="93">
                  <c:v>68.7588866795911</c:v>
                </c:pt>
                <c:pt idx="94">
                  <c:v>75.7074732373313</c:v>
                </c:pt>
                <c:pt idx="95">
                  <c:v>80.763797583042205</c:v>
                </c:pt>
                <c:pt idx="96">
                  <c:v>76.635953131248897</c:v>
                </c:pt>
                <c:pt idx="97">
                  <c:v>63.8099628802034</c:v>
                </c:pt>
                <c:pt idx="98">
                  <c:v>63.678744380979303</c:v>
                </c:pt>
                <c:pt idx="99">
                  <c:v>75.976730282629106</c:v>
                </c:pt>
                <c:pt idx="100">
                  <c:v>83.917775899649698</c:v>
                </c:pt>
                <c:pt idx="101">
                  <c:v>66.846729617399106</c:v>
                </c:pt>
                <c:pt idx="102">
                  <c:v>69.083197147579895</c:v>
                </c:pt>
                <c:pt idx="103">
                  <c:v>74.552066667286695</c:v>
                </c:pt>
                <c:pt idx="104">
                  <c:v>75.305812423360095</c:v>
                </c:pt>
                <c:pt idx="105">
                  <c:v>83.303561781746296</c:v>
                </c:pt>
                <c:pt idx="106">
                  <c:v>76.627303409792006</c:v>
                </c:pt>
                <c:pt idx="107">
                  <c:v>63.031711828055201</c:v>
                </c:pt>
                <c:pt idx="108">
                  <c:v>75.832189308980801</c:v>
                </c:pt>
                <c:pt idx="109">
                  <c:v>91.268903563792804</c:v>
                </c:pt>
                <c:pt idx="110">
                  <c:v>74.239406597478094</c:v>
                </c:pt>
                <c:pt idx="111">
                  <c:v>78.807228354348496</c:v>
                </c:pt>
                <c:pt idx="112">
                  <c:v>68.2501235941359</c:v>
                </c:pt>
                <c:pt idx="113">
                  <c:v>88.398298239349103</c:v>
                </c:pt>
                <c:pt idx="114">
                  <c:v>80.370298465400793</c:v>
                </c:pt>
                <c:pt idx="115">
                  <c:v>68.024411204335806</c:v>
                </c:pt>
                <c:pt idx="116">
                  <c:v>80.407681902619203</c:v>
                </c:pt>
                <c:pt idx="117">
                  <c:v>73.5279053829899</c:v>
                </c:pt>
                <c:pt idx="118">
                  <c:v>70.697596410061294</c:v>
                </c:pt>
                <c:pt idx="119">
                  <c:v>78.953601405448495</c:v>
                </c:pt>
                <c:pt idx="120">
                  <c:v>72.441287864260303</c:v>
                </c:pt>
                <c:pt idx="121">
                  <c:v>60.163666164670602</c:v>
                </c:pt>
                <c:pt idx="122">
                  <c:v>69.0872593880339</c:v>
                </c:pt>
                <c:pt idx="123">
                  <c:v>67.7987849617938</c:v>
                </c:pt>
                <c:pt idx="124">
                  <c:v>82.993721806932598</c:v>
                </c:pt>
                <c:pt idx="125">
                  <c:v>69.367851990489299</c:v>
                </c:pt>
                <c:pt idx="126">
                  <c:v>78.844651731703195</c:v>
                </c:pt>
                <c:pt idx="127">
                  <c:v>75.394540032828303</c:v>
                </c:pt>
                <c:pt idx="128">
                  <c:v>82.221123026660806</c:v>
                </c:pt>
                <c:pt idx="129">
                  <c:v>65.3333881849112</c:v>
                </c:pt>
                <c:pt idx="130">
                  <c:v>68.318673615056099</c:v>
                </c:pt>
                <c:pt idx="131">
                  <c:v>71.247303395372597</c:v>
                </c:pt>
                <c:pt idx="132">
                  <c:v>68.108485726883202</c:v>
                </c:pt>
                <c:pt idx="133">
                  <c:v>72.415104238138994</c:v>
                </c:pt>
                <c:pt idx="134">
                  <c:v>72.920649452545604</c:v>
                </c:pt>
                <c:pt idx="135">
                  <c:v>68.813130678629093</c:v>
                </c:pt>
                <c:pt idx="136">
                  <c:v>72.200205012959302</c:v>
                </c:pt>
                <c:pt idx="137">
                  <c:v>71.161439800364107</c:v>
                </c:pt>
                <c:pt idx="138">
                  <c:v>70.765967007596203</c:v>
                </c:pt>
                <c:pt idx="139">
                  <c:v>80.273318303338698</c:v>
                </c:pt>
                <c:pt idx="140">
                  <c:v>69.985367339311395</c:v>
                </c:pt>
                <c:pt idx="141">
                  <c:v>74.614044829760005</c:v>
                </c:pt>
                <c:pt idx="142">
                  <c:v>72.626739861112299</c:v>
                </c:pt>
                <c:pt idx="143">
                  <c:v>81.179525648188005</c:v>
                </c:pt>
                <c:pt idx="144">
                  <c:v>89.041313103297696</c:v>
                </c:pt>
                <c:pt idx="145">
                  <c:v>78.691301660454897</c:v>
                </c:pt>
                <c:pt idx="146">
                  <c:v>61.2801126823842</c:v>
                </c:pt>
                <c:pt idx="147">
                  <c:v>64.854340297895106</c:v>
                </c:pt>
                <c:pt idx="148">
                  <c:v>68.0734711916176</c:v>
                </c:pt>
                <c:pt idx="149">
                  <c:v>63.896890870171298</c:v>
                </c:pt>
                <c:pt idx="150">
                  <c:v>74.564459243939197</c:v>
                </c:pt>
                <c:pt idx="151">
                  <c:v>76.639942039456798</c:v>
                </c:pt>
                <c:pt idx="152">
                  <c:v>66.778085360024605</c:v>
                </c:pt>
                <c:pt idx="153">
                  <c:v>70.733997869398806</c:v>
                </c:pt>
                <c:pt idx="154">
                  <c:v>62.362825389031102</c:v>
                </c:pt>
                <c:pt idx="155">
                  <c:v>71.814876421574098</c:v>
                </c:pt>
                <c:pt idx="156">
                  <c:v>70.037543767372398</c:v>
                </c:pt>
                <c:pt idx="157">
                  <c:v>71.090367967076503</c:v>
                </c:pt>
                <c:pt idx="158">
                  <c:v>69.135063177761197</c:v>
                </c:pt>
                <c:pt idx="159">
                  <c:v>70.016511863431404</c:v>
                </c:pt>
                <c:pt idx="160">
                  <c:v>75.431680890833903</c:v>
                </c:pt>
                <c:pt idx="161">
                  <c:v>74.951162530576994</c:v>
                </c:pt>
                <c:pt idx="162">
                  <c:v>93.313061636827697</c:v>
                </c:pt>
                <c:pt idx="163">
                  <c:v>75.046684032016302</c:v>
                </c:pt>
                <c:pt idx="164">
                  <c:v>74.514695369396705</c:v>
                </c:pt>
                <c:pt idx="165">
                  <c:v>72.345451377161098</c:v>
                </c:pt>
                <c:pt idx="166">
                  <c:v>64.2565765403222</c:v>
                </c:pt>
                <c:pt idx="167">
                  <c:v>79.993402730845801</c:v>
                </c:pt>
                <c:pt idx="168">
                  <c:v>71.858354490134303</c:v>
                </c:pt>
                <c:pt idx="169">
                  <c:v>61.795520727218999</c:v>
                </c:pt>
                <c:pt idx="170">
                  <c:v>78.8273824025907</c:v>
                </c:pt>
                <c:pt idx="171">
                  <c:v>69.471260608987606</c:v>
                </c:pt>
                <c:pt idx="172">
                  <c:v>67.699759179193705</c:v>
                </c:pt>
                <c:pt idx="173">
                  <c:v>68.051002420714696</c:v>
                </c:pt>
                <c:pt idx="174">
                  <c:v>76.959002010550705</c:v>
                </c:pt>
                <c:pt idx="175">
                  <c:v>75.005678597870201</c:v>
                </c:pt>
                <c:pt idx="176">
                  <c:v>70.081597426661503</c:v>
                </c:pt>
                <c:pt idx="177">
                  <c:v>75.221810390880904</c:v>
                </c:pt>
                <c:pt idx="178">
                  <c:v>70.793383617586599</c:v>
                </c:pt>
                <c:pt idx="179">
                  <c:v>71.911924687160194</c:v>
                </c:pt>
                <c:pt idx="180">
                  <c:v>66.369416630822101</c:v>
                </c:pt>
                <c:pt idx="181">
                  <c:v>65.859232852930006</c:v>
                </c:pt>
                <c:pt idx="182">
                  <c:v>82.945133027145999</c:v>
                </c:pt>
                <c:pt idx="183">
                  <c:v>75.878056157407102</c:v>
                </c:pt>
                <c:pt idx="184">
                  <c:v>77.592005210561993</c:v>
                </c:pt>
                <c:pt idx="185">
                  <c:v>68.077910493146106</c:v>
                </c:pt>
                <c:pt idx="186">
                  <c:v>65.896364220511998</c:v>
                </c:pt>
                <c:pt idx="187">
                  <c:v>85.827480079194899</c:v>
                </c:pt>
                <c:pt idx="188">
                  <c:v>74.175903420161703</c:v>
                </c:pt>
                <c:pt idx="189">
                  <c:v>70.301263051364103</c:v>
                </c:pt>
                <c:pt idx="190">
                  <c:v>76.749925186603605</c:v>
                </c:pt>
                <c:pt idx="191">
                  <c:v>65.682087580000498</c:v>
                </c:pt>
                <c:pt idx="192">
                  <c:v>65.147701421623594</c:v>
                </c:pt>
                <c:pt idx="193">
                  <c:v>71.395523329541305</c:v>
                </c:pt>
                <c:pt idx="194">
                  <c:v>73.768262017344597</c:v>
                </c:pt>
                <c:pt idx="195">
                  <c:v>75.296663503983098</c:v>
                </c:pt>
                <c:pt idx="196">
                  <c:v>78.711780770011998</c:v>
                </c:pt>
                <c:pt idx="197">
                  <c:v>75.394663724285394</c:v>
                </c:pt>
                <c:pt idx="198">
                  <c:v>90.393819059386502</c:v>
                </c:pt>
                <c:pt idx="199">
                  <c:v>73.982052940841101</c:v>
                </c:pt>
                <c:pt idx="200">
                  <c:v>69.918284343981298</c:v>
                </c:pt>
                <c:pt idx="201">
                  <c:v>80.330796531456599</c:v>
                </c:pt>
                <c:pt idx="202">
                  <c:v>79.9103046408203</c:v>
                </c:pt>
                <c:pt idx="203">
                  <c:v>87.416535906333905</c:v>
                </c:pt>
                <c:pt idx="204">
                  <c:v>70.035888594461696</c:v>
                </c:pt>
                <c:pt idx="205">
                  <c:v>76.163249223311496</c:v>
                </c:pt>
                <c:pt idx="206">
                  <c:v>65.1086945722396</c:v>
                </c:pt>
                <c:pt idx="207">
                  <c:v>76.706319800306204</c:v>
                </c:pt>
                <c:pt idx="208">
                  <c:v>81.176948948137195</c:v>
                </c:pt>
                <c:pt idx="209">
                  <c:v>69.748609070931707</c:v>
                </c:pt>
                <c:pt idx="210">
                  <c:v>73.591276103339695</c:v>
                </c:pt>
                <c:pt idx="211">
                  <c:v>78.676078522817804</c:v>
                </c:pt>
                <c:pt idx="212">
                  <c:v>75.213977312378006</c:v>
                </c:pt>
                <c:pt idx="213">
                  <c:v>67.902379370234001</c:v>
                </c:pt>
                <c:pt idx="214">
                  <c:v>87.680740742462802</c:v>
                </c:pt>
                <c:pt idx="215">
                  <c:v>83.222177120479799</c:v>
                </c:pt>
                <c:pt idx="216">
                  <c:v>67.403475992130197</c:v>
                </c:pt>
                <c:pt idx="217">
                  <c:v>72.805533603581907</c:v>
                </c:pt>
                <c:pt idx="218">
                  <c:v>83.391310976068397</c:v>
                </c:pt>
                <c:pt idx="219">
                  <c:v>77.680857021814603</c:v>
                </c:pt>
                <c:pt idx="220">
                  <c:v>81.466078230365994</c:v>
                </c:pt>
                <c:pt idx="221">
                  <c:v>63.656835553330303</c:v>
                </c:pt>
                <c:pt idx="222">
                  <c:v>82.195588086267307</c:v>
                </c:pt>
                <c:pt idx="223">
                  <c:v>73.694848903410303</c:v>
                </c:pt>
                <c:pt idx="224">
                  <c:v>69.084031592561502</c:v>
                </c:pt>
                <c:pt idx="225">
                  <c:v>79.585465319896997</c:v>
                </c:pt>
                <c:pt idx="226">
                  <c:v>77.014031878092098</c:v>
                </c:pt>
                <c:pt idx="227">
                  <c:v>81.843500482333795</c:v>
                </c:pt>
                <c:pt idx="228">
                  <c:v>84.501546468637699</c:v>
                </c:pt>
                <c:pt idx="229">
                  <c:v>77.808467091031105</c:v>
                </c:pt>
                <c:pt idx="230">
                  <c:v>83.465819485647401</c:v>
                </c:pt>
                <c:pt idx="231">
                  <c:v>70.389974010409802</c:v>
                </c:pt>
                <c:pt idx="232">
                  <c:v>73.751924926115706</c:v>
                </c:pt>
                <c:pt idx="233">
                  <c:v>67.867028128896095</c:v>
                </c:pt>
                <c:pt idx="234">
                  <c:v>67.459729876144905</c:v>
                </c:pt>
                <c:pt idx="235">
                  <c:v>76.326474377424105</c:v>
                </c:pt>
                <c:pt idx="236">
                  <c:v>70.305713661696998</c:v>
                </c:pt>
                <c:pt idx="237">
                  <c:v>66.359742489227799</c:v>
                </c:pt>
                <c:pt idx="238">
                  <c:v>71.581415976560706</c:v>
                </c:pt>
                <c:pt idx="239">
                  <c:v>76.793678796508303</c:v>
                </c:pt>
                <c:pt idx="240">
                  <c:v>78.544550892912696</c:v>
                </c:pt>
                <c:pt idx="241">
                  <c:v>69.251355338454005</c:v>
                </c:pt>
                <c:pt idx="242">
                  <c:v>76.622622492889803</c:v>
                </c:pt>
                <c:pt idx="243">
                  <c:v>69.401232417491201</c:v>
                </c:pt>
                <c:pt idx="244">
                  <c:v>79.797518572081998</c:v>
                </c:pt>
                <c:pt idx="245">
                  <c:v>68.002886337808206</c:v>
                </c:pt>
                <c:pt idx="246">
                  <c:v>66.550610349486405</c:v>
                </c:pt>
                <c:pt idx="247">
                  <c:v>79.612408442685094</c:v>
                </c:pt>
                <c:pt idx="248">
                  <c:v>65.648231152147702</c:v>
                </c:pt>
                <c:pt idx="249">
                  <c:v>73.239528579108693</c:v>
                </c:pt>
                <c:pt idx="250">
                  <c:v>67.380766751035793</c:v>
                </c:pt>
                <c:pt idx="251">
                  <c:v>68.080293434839803</c:v>
                </c:pt>
                <c:pt idx="252">
                  <c:v>84.784856728069101</c:v>
                </c:pt>
                <c:pt idx="253">
                  <c:v>77.943341233467805</c:v>
                </c:pt>
                <c:pt idx="254">
                  <c:v>70.5269487356654</c:v>
                </c:pt>
                <c:pt idx="255">
                  <c:v>73.867372977572501</c:v>
                </c:pt>
                <c:pt idx="256">
                  <c:v>77.875943010805102</c:v>
                </c:pt>
                <c:pt idx="257">
                  <c:v>79.131212881119694</c:v>
                </c:pt>
                <c:pt idx="258">
                  <c:v>72.684782153438405</c:v>
                </c:pt>
                <c:pt idx="259">
                  <c:v>74.128752868683407</c:v>
                </c:pt>
                <c:pt idx="260">
                  <c:v>67.575903782677898</c:v>
                </c:pt>
                <c:pt idx="261">
                  <c:v>78.519196959977805</c:v>
                </c:pt>
                <c:pt idx="262">
                  <c:v>68.526573432248497</c:v>
                </c:pt>
                <c:pt idx="263">
                  <c:v>68.903412909504993</c:v>
                </c:pt>
                <c:pt idx="264">
                  <c:v>67.918451465871399</c:v>
                </c:pt>
                <c:pt idx="265">
                  <c:v>72.794779826529705</c:v>
                </c:pt>
                <c:pt idx="266">
                  <c:v>73.243462475666803</c:v>
                </c:pt>
                <c:pt idx="267">
                  <c:v>84.382065085992295</c:v>
                </c:pt>
                <c:pt idx="268">
                  <c:v>67.549424079673202</c:v>
                </c:pt>
                <c:pt idx="269">
                  <c:v>66.674041308420598</c:v>
                </c:pt>
                <c:pt idx="270">
                  <c:v>65.324001550219194</c:v>
                </c:pt>
                <c:pt idx="271">
                  <c:v>75.876041120475605</c:v>
                </c:pt>
                <c:pt idx="272">
                  <c:v>72.785238687714099</c:v>
                </c:pt>
                <c:pt idx="273">
                  <c:v>76.091161709329995</c:v>
                </c:pt>
                <c:pt idx="274">
                  <c:v>69.881465354288295</c:v>
                </c:pt>
                <c:pt idx="275">
                  <c:v>65.103369840584904</c:v>
                </c:pt>
                <c:pt idx="276">
                  <c:v>76.901120207916193</c:v>
                </c:pt>
                <c:pt idx="277">
                  <c:v>66.231027827274801</c:v>
                </c:pt>
                <c:pt idx="278">
                  <c:v>72.557166168108196</c:v>
                </c:pt>
                <c:pt idx="279">
                  <c:v>75.166669862620296</c:v>
                </c:pt>
                <c:pt idx="280">
                  <c:v>76.161714366637298</c:v>
                </c:pt>
                <c:pt idx="281">
                  <c:v>68.097449994446194</c:v>
                </c:pt>
                <c:pt idx="282">
                  <c:v>69.391429781295599</c:v>
                </c:pt>
                <c:pt idx="283">
                  <c:v>73.0993747302863</c:v>
                </c:pt>
                <c:pt idx="284">
                  <c:v>79.687006345453398</c:v>
                </c:pt>
                <c:pt idx="285">
                  <c:v>70.788632661608602</c:v>
                </c:pt>
                <c:pt idx="286">
                  <c:v>57.5782612569324</c:v>
                </c:pt>
                <c:pt idx="287">
                  <c:v>72.5586615541783</c:v>
                </c:pt>
                <c:pt idx="288">
                  <c:v>66.579228507855305</c:v>
                </c:pt>
                <c:pt idx="289">
                  <c:v>74.369736094141501</c:v>
                </c:pt>
                <c:pt idx="290">
                  <c:v>73.482146429185804</c:v>
                </c:pt>
                <c:pt idx="291">
                  <c:v>75.9052483217952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548-4850-B4A5-B8977D0629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9681280"/>
        <c:axId val="129682816"/>
      </c:scatterChart>
      <c:valAx>
        <c:axId val="1296812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682816"/>
        <c:crosses val="autoZero"/>
        <c:crossBetween val="midCat"/>
      </c:valAx>
      <c:valAx>
        <c:axId val="1296828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6812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862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i="0" u="none" strike="noStrike" kern="1200" spc="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M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862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157397080121857"/>
          <c:y val="0.18057945459520261"/>
          <c:w val="0.75892335958005253"/>
          <c:h val="0.6544184679617750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G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5206491688538934"/>
                  <c:y val="-0.20703453734949798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sz="1197" b="0" i="0" u="none" strike="noStrike" kern="1200" baseline="0">
                        <a:solidFill>
                          <a:prstClr val="black">
                            <a:lumMod val="65000"/>
                            <a:lumOff val="35000"/>
                          </a:prst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636x - 15.377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8219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sz="1197" b="0" i="0" u="none" strike="noStrike" kern="120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D$2:$D$293</c:f>
              <c:numCache>
                <c:formatCode>0.0</c:formatCode>
                <c:ptCount val="292"/>
                <c:pt idx="0">
                  <c:v>143.32198233451001</c:v>
                </c:pt>
                <c:pt idx="1">
                  <c:v>145.03156309367901</c:v>
                </c:pt>
                <c:pt idx="2">
                  <c:v>145.521309913717</c:v>
                </c:pt>
                <c:pt idx="3">
                  <c:v>141.698282988654</c:v>
                </c:pt>
                <c:pt idx="4">
                  <c:v>132.767263048215</c:v>
                </c:pt>
                <c:pt idx="5">
                  <c:v>141.59384546442399</c:v>
                </c:pt>
                <c:pt idx="6">
                  <c:v>132.56204270888799</c:v>
                </c:pt>
                <c:pt idx="7">
                  <c:v>146.552330576651</c:v>
                </c:pt>
                <c:pt idx="8">
                  <c:v>138.205403022978</c:v>
                </c:pt>
                <c:pt idx="9">
                  <c:v>154.75438865794001</c:v>
                </c:pt>
                <c:pt idx="10">
                  <c:v>144.63746096134199</c:v>
                </c:pt>
                <c:pt idx="11">
                  <c:v>150.76791521461399</c:v>
                </c:pt>
                <c:pt idx="12">
                  <c:v>158.09753826277901</c:v>
                </c:pt>
                <c:pt idx="13">
                  <c:v>135.096984793026</c:v>
                </c:pt>
                <c:pt idx="14">
                  <c:v>123.245490346308</c:v>
                </c:pt>
                <c:pt idx="15">
                  <c:v>139.87472876238999</c:v>
                </c:pt>
                <c:pt idx="16">
                  <c:v>134.58410172780799</c:v>
                </c:pt>
                <c:pt idx="17">
                  <c:v>123.357318715285</c:v>
                </c:pt>
                <c:pt idx="18">
                  <c:v>146.279055970793</c:v>
                </c:pt>
                <c:pt idx="19">
                  <c:v>138.19848959273901</c:v>
                </c:pt>
                <c:pt idx="20">
                  <c:v>149.71898132360599</c:v>
                </c:pt>
                <c:pt idx="21">
                  <c:v>144.76280354359699</c:v>
                </c:pt>
                <c:pt idx="22">
                  <c:v>152.975381747516</c:v>
                </c:pt>
                <c:pt idx="23">
                  <c:v>137.04049749869</c:v>
                </c:pt>
                <c:pt idx="24">
                  <c:v>152.118155109307</c:v>
                </c:pt>
                <c:pt idx="25">
                  <c:v>126.98445420036001</c:v>
                </c:pt>
                <c:pt idx="26">
                  <c:v>129.00376454072301</c:v>
                </c:pt>
                <c:pt idx="27">
                  <c:v>143.10087367795401</c:v>
                </c:pt>
                <c:pt idx="28">
                  <c:v>161.82609440177299</c:v>
                </c:pt>
                <c:pt idx="29">
                  <c:v>128.93526666893601</c:v>
                </c:pt>
                <c:pt idx="30">
                  <c:v>129.27138714013</c:v>
                </c:pt>
                <c:pt idx="31">
                  <c:v>146.017678763525</c:v>
                </c:pt>
                <c:pt idx="32">
                  <c:v>135.930100450955</c:v>
                </c:pt>
                <c:pt idx="33">
                  <c:v>127.37989712565999</c:v>
                </c:pt>
                <c:pt idx="34">
                  <c:v>137.54062310307401</c:v>
                </c:pt>
                <c:pt idx="35">
                  <c:v>146.260243762107</c:v>
                </c:pt>
                <c:pt idx="36">
                  <c:v>139.75934696986599</c:v>
                </c:pt>
                <c:pt idx="37">
                  <c:v>137.82806825514299</c:v>
                </c:pt>
                <c:pt idx="38">
                  <c:v>135.89352637180301</c:v>
                </c:pt>
                <c:pt idx="39">
                  <c:v>137.09235796194201</c:v>
                </c:pt>
                <c:pt idx="40">
                  <c:v>143.09272593552299</c:v>
                </c:pt>
                <c:pt idx="41">
                  <c:v>136.464150465872</c:v>
                </c:pt>
                <c:pt idx="42">
                  <c:v>141.84637492765299</c:v>
                </c:pt>
                <c:pt idx="43">
                  <c:v>139.255525444456</c:v>
                </c:pt>
                <c:pt idx="44">
                  <c:v>147.95074663984201</c:v>
                </c:pt>
                <c:pt idx="45">
                  <c:v>131.95850618984599</c:v>
                </c:pt>
                <c:pt idx="46">
                  <c:v>133.13344151249501</c:v>
                </c:pt>
                <c:pt idx="47">
                  <c:v>153.52640258270401</c:v>
                </c:pt>
                <c:pt idx="48">
                  <c:v>133.83975078121199</c:v>
                </c:pt>
                <c:pt idx="49">
                  <c:v>127.892587869468</c:v>
                </c:pt>
                <c:pt idx="50">
                  <c:v>132.395858549031</c:v>
                </c:pt>
                <c:pt idx="51">
                  <c:v>152.998932898959</c:v>
                </c:pt>
                <c:pt idx="52">
                  <c:v>120.759547670869</c:v>
                </c:pt>
                <c:pt idx="53">
                  <c:v>128.446926223432</c:v>
                </c:pt>
                <c:pt idx="54">
                  <c:v>151.91754019608899</c:v>
                </c:pt>
                <c:pt idx="55">
                  <c:v>131.87124404046801</c:v>
                </c:pt>
                <c:pt idx="56">
                  <c:v>150.496622217929</c:v>
                </c:pt>
                <c:pt idx="57">
                  <c:v>132.04331397534301</c:v>
                </c:pt>
                <c:pt idx="58">
                  <c:v>133.61402789464199</c:v>
                </c:pt>
                <c:pt idx="59">
                  <c:v>125.785482291566</c:v>
                </c:pt>
                <c:pt idx="60">
                  <c:v>142.70357302770799</c:v>
                </c:pt>
                <c:pt idx="61">
                  <c:v>121.21371977016599</c:v>
                </c:pt>
                <c:pt idx="62">
                  <c:v>150.153911266785</c:v>
                </c:pt>
                <c:pt idx="63">
                  <c:v>158.32134146775601</c:v>
                </c:pt>
                <c:pt idx="64">
                  <c:v>143.410792235478</c:v>
                </c:pt>
                <c:pt idx="65">
                  <c:v>140.220600877235</c:v>
                </c:pt>
                <c:pt idx="66">
                  <c:v>144.399485821659</c:v>
                </c:pt>
                <c:pt idx="67">
                  <c:v>143.67401850607399</c:v>
                </c:pt>
                <c:pt idx="68">
                  <c:v>147.80385818887501</c:v>
                </c:pt>
                <c:pt idx="69">
                  <c:v>123.970061591392</c:v>
                </c:pt>
                <c:pt idx="70">
                  <c:v>148.55491518859199</c:v>
                </c:pt>
                <c:pt idx="71">
                  <c:v>129.05333644619699</c:v>
                </c:pt>
                <c:pt idx="72">
                  <c:v>144.70248217433999</c:v>
                </c:pt>
                <c:pt idx="73">
                  <c:v>135.04690053227</c:v>
                </c:pt>
                <c:pt idx="74">
                  <c:v>140.20007637478</c:v>
                </c:pt>
                <c:pt idx="75">
                  <c:v>157.269331646642</c:v>
                </c:pt>
                <c:pt idx="76">
                  <c:v>153.02206231361501</c:v>
                </c:pt>
                <c:pt idx="77">
                  <c:v>131.83595100919001</c:v>
                </c:pt>
                <c:pt idx="78">
                  <c:v>143.41770319282901</c:v>
                </c:pt>
                <c:pt idx="79">
                  <c:v>158.38366167510799</c:v>
                </c:pt>
                <c:pt idx="80">
                  <c:v>126.970831042425</c:v>
                </c:pt>
                <c:pt idx="81">
                  <c:v>125.103232796787</c:v>
                </c:pt>
                <c:pt idx="82">
                  <c:v>125.46722447736499</c:v>
                </c:pt>
                <c:pt idx="83">
                  <c:v>136.156268920125</c:v>
                </c:pt>
                <c:pt idx="84">
                  <c:v>132.86648872272599</c:v>
                </c:pt>
                <c:pt idx="85">
                  <c:v>137.06589659632701</c:v>
                </c:pt>
                <c:pt idx="86">
                  <c:v>129.097298927189</c:v>
                </c:pt>
                <c:pt idx="87">
                  <c:v>161.65917555434299</c:v>
                </c:pt>
                <c:pt idx="88">
                  <c:v>145.474507999493</c:v>
                </c:pt>
                <c:pt idx="89">
                  <c:v>143.48980505632599</c:v>
                </c:pt>
                <c:pt idx="90">
                  <c:v>129.02753934140799</c:v>
                </c:pt>
                <c:pt idx="91">
                  <c:v>145.813581080978</c:v>
                </c:pt>
                <c:pt idx="92">
                  <c:v>118.095545732631</c:v>
                </c:pt>
                <c:pt idx="93">
                  <c:v>134.649998662771</c:v>
                </c:pt>
                <c:pt idx="94">
                  <c:v>143.08301960032099</c:v>
                </c:pt>
                <c:pt idx="95">
                  <c:v>146.57193342983101</c:v>
                </c:pt>
                <c:pt idx="96">
                  <c:v>139.770111892377</c:v>
                </c:pt>
                <c:pt idx="97">
                  <c:v>125.227679246855</c:v>
                </c:pt>
                <c:pt idx="98">
                  <c:v>123.705684548601</c:v>
                </c:pt>
                <c:pt idx="99">
                  <c:v>138.188408323207</c:v>
                </c:pt>
                <c:pt idx="100">
                  <c:v>153.625129842044</c:v>
                </c:pt>
                <c:pt idx="101">
                  <c:v>130.93784999348301</c:v>
                </c:pt>
                <c:pt idx="102">
                  <c:v>133.038963889982</c:v>
                </c:pt>
                <c:pt idx="103">
                  <c:v>142.376607616005</c:v>
                </c:pt>
                <c:pt idx="104">
                  <c:v>151.48651771092599</c:v>
                </c:pt>
                <c:pt idx="105">
                  <c:v>152.13893330993201</c:v>
                </c:pt>
                <c:pt idx="106">
                  <c:v>145.13576968427699</c:v>
                </c:pt>
                <c:pt idx="107">
                  <c:v>132.415102145643</c:v>
                </c:pt>
                <c:pt idx="108">
                  <c:v>138.107003098652</c:v>
                </c:pt>
                <c:pt idx="109">
                  <c:v>160.93742987098699</c:v>
                </c:pt>
                <c:pt idx="110">
                  <c:v>142.477436734089</c:v>
                </c:pt>
                <c:pt idx="111">
                  <c:v>147.51497880282301</c:v>
                </c:pt>
                <c:pt idx="112">
                  <c:v>133.04218951170401</c:v>
                </c:pt>
                <c:pt idx="113">
                  <c:v>154.56295877225099</c:v>
                </c:pt>
                <c:pt idx="114">
                  <c:v>148.032933513221</c:v>
                </c:pt>
                <c:pt idx="115">
                  <c:v>127.26379538245899</c:v>
                </c:pt>
                <c:pt idx="116">
                  <c:v>153.28472051399001</c:v>
                </c:pt>
                <c:pt idx="117">
                  <c:v>141.76604338523001</c:v>
                </c:pt>
                <c:pt idx="118">
                  <c:v>134.48212488319601</c:v>
                </c:pt>
                <c:pt idx="119">
                  <c:v>143.33757829290801</c:v>
                </c:pt>
                <c:pt idx="120">
                  <c:v>135.16655752831301</c:v>
                </c:pt>
                <c:pt idx="121">
                  <c:v>118.952006263903</c:v>
                </c:pt>
                <c:pt idx="122">
                  <c:v>134.60016493882699</c:v>
                </c:pt>
                <c:pt idx="123">
                  <c:v>128.62875601484799</c:v>
                </c:pt>
                <c:pt idx="124">
                  <c:v>155.124545697195</c:v>
                </c:pt>
                <c:pt idx="125">
                  <c:v>129.18457589780999</c:v>
                </c:pt>
                <c:pt idx="126">
                  <c:v>145.9277156675</c:v>
                </c:pt>
                <c:pt idx="127">
                  <c:v>139.29482797828999</c:v>
                </c:pt>
                <c:pt idx="128">
                  <c:v>147.43195696569299</c:v>
                </c:pt>
                <c:pt idx="129">
                  <c:v>128.183480281329</c:v>
                </c:pt>
                <c:pt idx="130">
                  <c:v>132.31550822867999</c:v>
                </c:pt>
                <c:pt idx="131">
                  <c:v>135.680141721149</c:v>
                </c:pt>
                <c:pt idx="132">
                  <c:v>129.118034177091</c:v>
                </c:pt>
                <c:pt idx="133">
                  <c:v>138.19829375502999</c:v>
                </c:pt>
                <c:pt idx="134">
                  <c:v>136.40429895213799</c:v>
                </c:pt>
                <c:pt idx="135">
                  <c:v>130.41236107075099</c:v>
                </c:pt>
                <c:pt idx="136">
                  <c:v>134.59324427246901</c:v>
                </c:pt>
                <c:pt idx="137">
                  <c:v>135.48905141403</c:v>
                </c:pt>
                <c:pt idx="138">
                  <c:v>140.312460818018</c:v>
                </c:pt>
                <c:pt idx="139">
                  <c:v>156.49574163979599</c:v>
                </c:pt>
                <c:pt idx="140">
                  <c:v>137.09432601483999</c:v>
                </c:pt>
                <c:pt idx="141">
                  <c:v>142.057626457119</c:v>
                </c:pt>
                <c:pt idx="142">
                  <c:v>132.27177746252801</c:v>
                </c:pt>
                <c:pt idx="143">
                  <c:v>147.568594030789</c:v>
                </c:pt>
                <c:pt idx="144">
                  <c:v>161.584103954499</c:v>
                </c:pt>
                <c:pt idx="145">
                  <c:v>147.83425360597701</c:v>
                </c:pt>
                <c:pt idx="146">
                  <c:v>120.66590412863</c:v>
                </c:pt>
                <c:pt idx="147">
                  <c:v>129.451656834918</c:v>
                </c:pt>
                <c:pt idx="148">
                  <c:v>130.78125716158499</c:v>
                </c:pt>
                <c:pt idx="149">
                  <c:v>128.283822751603</c:v>
                </c:pt>
                <c:pt idx="150">
                  <c:v>140.96671311479301</c:v>
                </c:pt>
                <c:pt idx="151">
                  <c:v>140.39543001813001</c:v>
                </c:pt>
                <c:pt idx="152">
                  <c:v>126.35522388799799</c:v>
                </c:pt>
                <c:pt idx="153">
                  <c:v>134.28743097895699</c:v>
                </c:pt>
                <c:pt idx="154">
                  <c:v>129.93137919789899</c:v>
                </c:pt>
                <c:pt idx="155">
                  <c:v>132.38790402347499</c:v>
                </c:pt>
                <c:pt idx="156">
                  <c:v>133.80296152234001</c:v>
                </c:pt>
                <c:pt idx="157">
                  <c:v>141.522936530083</c:v>
                </c:pt>
                <c:pt idx="158">
                  <c:v>126.83154520273401</c:v>
                </c:pt>
                <c:pt idx="159">
                  <c:v>131.929783330541</c:v>
                </c:pt>
                <c:pt idx="160">
                  <c:v>138.514337604334</c:v>
                </c:pt>
                <c:pt idx="161">
                  <c:v>140.839706062749</c:v>
                </c:pt>
                <c:pt idx="162">
                  <c:v>162.269565455411</c:v>
                </c:pt>
                <c:pt idx="163">
                  <c:v>141.14216330438501</c:v>
                </c:pt>
                <c:pt idx="164">
                  <c:v>138.20282384270399</c:v>
                </c:pt>
                <c:pt idx="165">
                  <c:v>138.58045307683199</c:v>
                </c:pt>
                <c:pt idx="166">
                  <c:v>129.85348044249901</c:v>
                </c:pt>
                <c:pt idx="167">
                  <c:v>151.514020411779</c:v>
                </c:pt>
                <c:pt idx="168">
                  <c:v>147.04527404531501</c:v>
                </c:pt>
                <c:pt idx="169">
                  <c:v>128.72202635055299</c:v>
                </c:pt>
                <c:pt idx="170">
                  <c:v>154.67828428505501</c:v>
                </c:pt>
                <c:pt idx="171">
                  <c:v>138.78663755275701</c:v>
                </c:pt>
                <c:pt idx="172">
                  <c:v>130.924824351365</c:v>
                </c:pt>
                <c:pt idx="173">
                  <c:v>135.18468225804199</c:v>
                </c:pt>
                <c:pt idx="174">
                  <c:v>141.94463631003799</c:v>
                </c:pt>
                <c:pt idx="175">
                  <c:v>146.42229468109801</c:v>
                </c:pt>
                <c:pt idx="176">
                  <c:v>134.79779646847601</c:v>
                </c:pt>
                <c:pt idx="177">
                  <c:v>140.53149756252799</c:v>
                </c:pt>
                <c:pt idx="178">
                  <c:v>139.36025787803101</c:v>
                </c:pt>
                <c:pt idx="179">
                  <c:v>137.182419945379</c:v>
                </c:pt>
                <c:pt idx="180">
                  <c:v>126.982076161105</c:v>
                </c:pt>
                <c:pt idx="181">
                  <c:v>124.995419736961</c:v>
                </c:pt>
                <c:pt idx="182">
                  <c:v>153.35500851675701</c:v>
                </c:pt>
                <c:pt idx="183">
                  <c:v>140.85872126044299</c:v>
                </c:pt>
                <c:pt idx="184">
                  <c:v>148.88659436961601</c:v>
                </c:pt>
                <c:pt idx="185">
                  <c:v>132.90602512481101</c:v>
                </c:pt>
                <c:pt idx="186">
                  <c:v>129.38791421008699</c:v>
                </c:pt>
                <c:pt idx="187">
                  <c:v>158.53662659436799</c:v>
                </c:pt>
                <c:pt idx="188">
                  <c:v>142.91157675337399</c:v>
                </c:pt>
                <c:pt idx="189">
                  <c:v>135.092397584471</c:v>
                </c:pt>
                <c:pt idx="190">
                  <c:v>147.160825821853</c:v>
                </c:pt>
                <c:pt idx="191">
                  <c:v>133.84678631462401</c:v>
                </c:pt>
                <c:pt idx="192">
                  <c:v>127.048551209773</c:v>
                </c:pt>
                <c:pt idx="193">
                  <c:v>136.794224656918</c:v>
                </c:pt>
                <c:pt idx="194">
                  <c:v>147.78760336941099</c:v>
                </c:pt>
                <c:pt idx="195">
                  <c:v>145.89355210600701</c:v>
                </c:pt>
                <c:pt idx="196">
                  <c:v>146.40560653418899</c:v>
                </c:pt>
                <c:pt idx="197">
                  <c:v>137.950390328738</c:v>
                </c:pt>
                <c:pt idx="198">
                  <c:v>165.168231338326</c:v>
                </c:pt>
                <c:pt idx="199">
                  <c:v>137.466339819909</c:v>
                </c:pt>
                <c:pt idx="200">
                  <c:v>141.97350380989701</c:v>
                </c:pt>
                <c:pt idx="201">
                  <c:v>146.953371807645</c:v>
                </c:pt>
                <c:pt idx="202">
                  <c:v>143.64698239361101</c:v>
                </c:pt>
                <c:pt idx="203">
                  <c:v>161.43560124152199</c:v>
                </c:pt>
                <c:pt idx="204">
                  <c:v>137.130021965521</c:v>
                </c:pt>
                <c:pt idx="205">
                  <c:v>151.24036062765401</c:v>
                </c:pt>
                <c:pt idx="206">
                  <c:v>123.40198600462899</c:v>
                </c:pt>
                <c:pt idx="207">
                  <c:v>153.63907453622099</c:v>
                </c:pt>
                <c:pt idx="208">
                  <c:v>150.76564786930399</c:v>
                </c:pt>
                <c:pt idx="209">
                  <c:v>139.97678895442201</c:v>
                </c:pt>
                <c:pt idx="210">
                  <c:v>137.12616408210499</c:v>
                </c:pt>
                <c:pt idx="211">
                  <c:v>152.509238197412</c:v>
                </c:pt>
                <c:pt idx="212">
                  <c:v>143.28630981950599</c:v>
                </c:pt>
                <c:pt idx="213">
                  <c:v>135.704082091185</c:v>
                </c:pt>
                <c:pt idx="214">
                  <c:v>162.33522694889299</c:v>
                </c:pt>
                <c:pt idx="215">
                  <c:v>141.78221354626601</c:v>
                </c:pt>
                <c:pt idx="216">
                  <c:v>132.44771763706601</c:v>
                </c:pt>
                <c:pt idx="217">
                  <c:v>131.99503029087199</c:v>
                </c:pt>
                <c:pt idx="218">
                  <c:v>145.95724690679901</c:v>
                </c:pt>
                <c:pt idx="219">
                  <c:v>150.44080296896601</c:v>
                </c:pt>
                <c:pt idx="220">
                  <c:v>153.547708368277</c:v>
                </c:pt>
                <c:pt idx="221">
                  <c:v>123.852230000004</c:v>
                </c:pt>
                <c:pt idx="222">
                  <c:v>152.00078410135899</c:v>
                </c:pt>
                <c:pt idx="223">
                  <c:v>144.06320255466801</c:v>
                </c:pt>
                <c:pt idx="224">
                  <c:v>138.07199218154099</c:v>
                </c:pt>
                <c:pt idx="225">
                  <c:v>140.19914691812801</c:v>
                </c:pt>
                <c:pt idx="226">
                  <c:v>143.875242436566</c:v>
                </c:pt>
                <c:pt idx="227">
                  <c:v>150.39453582438301</c:v>
                </c:pt>
                <c:pt idx="228">
                  <c:v>156.43378814922499</c:v>
                </c:pt>
                <c:pt idx="229">
                  <c:v>152.59992840233701</c:v>
                </c:pt>
                <c:pt idx="230">
                  <c:v>148.57602961619401</c:v>
                </c:pt>
                <c:pt idx="231">
                  <c:v>131.27225221281901</c:v>
                </c:pt>
                <c:pt idx="232">
                  <c:v>136.40406430580799</c:v>
                </c:pt>
                <c:pt idx="233">
                  <c:v>129.98041852913499</c:v>
                </c:pt>
                <c:pt idx="234">
                  <c:v>132.473222488278</c:v>
                </c:pt>
                <c:pt idx="235">
                  <c:v>141.38913336092</c:v>
                </c:pt>
                <c:pt idx="236">
                  <c:v>138.801990145979</c:v>
                </c:pt>
                <c:pt idx="237">
                  <c:v>130.92391088709601</c:v>
                </c:pt>
                <c:pt idx="238">
                  <c:v>141.554039621128</c:v>
                </c:pt>
                <c:pt idx="239">
                  <c:v>144.826049998928</c:v>
                </c:pt>
                <c:pt idx="240">
                  <c:v>145.373671776555</c:v>
                </c:pt>
                <c:pt idx="241">
                  <c:v>131.220857122887</c:v>
                </c:pt>
                <c:pt idx="242">
                  <c:v>143.071691846486</c:v>
                </c:pt>
                <c:pt idx="243">
                  <c:v>130.18360163470101</c:v>
                </c:pt>
                <c:pt idx="244">
                  <c:v>149.41021917011801</c:v>
                </c:pt>
                <c:pt idx="245">
                  <c:v>130.436404693181</c:v>
                </c:pt>
                <c:pt idx="246">
                  <c:v>130.85107757245501</c:v>
                </c:pt>
                <c:pt idx="247">
                  <c:v>149.91317677129001</c:v>
                </c:pt>
                <c:pt idx="248">
                  <c:v>129.50584088544599</c:v>
                </c:pt>
                <c:pt idx="249">
                  <c:v>138.33981151594699</c:v>
                </c:pt>
                <c:pt idx="250">
                  <c:v>129.30155000408101</c:v>
                </c:pt>
                <c:pt idx="251">
                  <c:v>132.246855004048</c:v>
                </c:pt>
                <c:pt idx="252">
                  <c:v>151.92533049634301</c:v>
                </c:pt>
                <c:pt idx="253">
                  <c:v>144.60118844239599</c:v>
                </c:pt>
                <c:pt idx="254">
                  <c:v>129.811979076711</c:v>
                </c:pt>
                <c:pt idx="255">
                  <c:v>152.343522905051</c:v>
                </c:pt>
                <c:pt idx="256">
                  <c:v>144.32454660608499</c:v>
                </c:pt>
                <c:pt idx="257">
                  <c:v>143.145811367883</c:v>
                </c:pt>
                <c:pt idx="258">
                  <c:v>139.19005474794599</c:v>
                </c:pt>
                <c:pt idx="259">
                  <c:v>138.761423774522</c:v>
                </c:pt>
                <c:pt idx="260">
                  <c:v>129.657243470933</c:v>
                </c:pt>
                <c:pt idx="261">
                  <c:v>144.898596340247</c:v>
                </c:pt>
                <c:pt idx="262">
                  <c:v>130.830977306779</c:v>
                </c:pt>
                <c:pt idx="263">
                  <c:v>127.23703401404001</c:v>
                </c:pt>
                <c:pt idx="264">
                  <c:v>133.358443023511</c:v>
                </c:pt>
                <c:pt idx="265">
                  <c:v>137.749019467843</c:v>
                </c:pt>
                <c:pt idx="266">
                  <c:v>139.719737157401</c:v>
                </c:pt>
                <c:pt idx="267">
                  <c:v>152.22720170461201</c:v>
                </c:pt>
                <c:pt idx="268">
                  <c:v>133.72940513733801</c:v>
                </c:pt>
                <c:pt idx="269">
                  <c:v>131.91130291804799</c:v>
                </c:pt>
                <c:pt idx="270">
                  <c:v>143.83334478717799</c:v>
                </c:pt>
                <c:pt idx="271">
                  <c:v>146.52757529452299</c:v>
                </c:pt>
                <c:pt idx="272">
                  <c:v>140.837619816005</c:v>
                </c:pt>
                <c:pt idx="273">
                  <c:v>149.602085795297</c:v>
                </c:pt>
                <c:pt idx="274">
                  <c:v>136.35855752518799</c:v>
                </c:pt>
                <c:pt idx="275">
                  <c:v>126.757867476968</c:v>
                </c:pt>
                <c:pt idx="276">
                  <c:v>153.32484078714299</c:v>
                </c:pt>
                <c:pt idx="277">
                  <c:v>125.050837353722</c:v>
                </c:pt>
                <c:pt idx="278">
                  <c:v>140.75865477821901</c:v>
                </c:pt>
                <c:pt idx="279">
                  <c:v>145.805498723456</c:v>
                </c:pt>
                <c:pt idx="280">
                  <c:v>143.76464937507299</c:v>
                </c:pt>
                <c:pt idx="281">
                  <c:v>134.01187036199201</c:v>
                </c:pt>
                <c:pt idx="282">
                  <c:v>137.04484363515201</c:v>
                </c:pt>
                <c:pt idx="283">
                  <c:v>131.448262538721</c:v>
                </c:pt>
                <c:pt idx="284">
                  <c:v>145.92017780227701</c:v>
                </c:pt>
                <c:pt idx="285">
                  <c:v>132.46666729489999</c:v>
                </c:pt>
                <c:pt idx="286">
                  <c:v>118.79010525451299</c:v>
                </c:pt>
                <c:pt idx="287">
                  <c:v>134.413405047927</c:v>
                </c:pt>
                <c:pt idx="288">
                  <c:v>129.60937983260899</c:v>
                </c:pt>
                <c:pt idx="289">
                  <c:v>145.058635049104</c:v>
                </c:pt>
                <c:pt idx="290">
                  <c:v>142.76664285250601</c:v>
                </c:pt>
                <c:pt idx="291">
                  <c:v>147.07644627213099</c:v>
                </c:pt>
              </c:numCache>
            </c:numRef>
          </c:xVal>
          <c:yVal>
            <c:numRef>
              <c:f>Sheet1!$G$2:$G$293</c:f>
              <c:numCache>
                <c:formatCode>0.0</c:formatCode>
                <c:ptCount val="292"/>
                <c:pt idx="0">
                  <c:v>75.175185865463803</c:v>
                </c:pt>
                <c:pt idx="1">
                  <c:v>77.280762251155494</c:v>
                </c:pt>
                <c:pt idx="2">
                  <c:v>66.236922542963995</c:v>
                </c:pt>
                <c:pt idx="3">
                  <c:v>76.749217605516506</c:v>
                </c:pt>
                <c:pt idx="4">
                  <c:v>72.297496060432806</c:v>
                </c:pt>
                <c:pt idx="5">
                  <c:v>78.097124422005393</c:v>
                </c:pt>
                <c:pt idx="6">
                  <c:v>66.896393641304996</c:v>
                </c:pt>
                <c:pt idx="7">
                  <c:v>79.481449996611303</c:v>
                </c:pt>
                <c:pt idx="8">
                  <c:v>73.631875156809699</c:v>
                </c:pt>
                <c:pt idx="9">
                  <c:v>87.445739811342307</c:v>
                </c:pt>
                <c:pt idx="10">
                  <c:v>75.689039109647297</c:v>
                </c:pt>
                <c:pt idx="11">
                  <c:v>79.140903014594997</c:v>
                </c:pt>
                <c:pt idx="12">
                  <c:v>85.720186678772905</c:v>
                </c:pt>
                <c:pt idx="13">
                  <c:v>75.974709074757698</c:v>
                </c:pt>
                <c:pt idx="14">
                  <c:v>62.257033455099602</c:v>
                </c:pt>
                <c:pt idx="15">
                  <c:v>74.873685966021796</c:v>
                </c:pt>
                <c:pt idx="16">
                  <c:v>66.088676113301801</c:v>
                </c:pt>
                <c:pt idx="17">
                  <c:v>63.063856865872999</c:v>
                </c:pt>
                <c:pt idx="18">
                  <c:v>81.393960288029504</c:v>
                </c:pt>
                <c:pt idx="19">
                  <c:v>74.277702786989394</c:v>
                </c:pt>
                <c:pt idx="20">
                  <c:v>80.877763315476997</c:v>
                </c:pt>
                <c:pt idx="21">
                  <c:v>72.934313952962697</c:v>
                </c:pt>
                <c:pt idx="22">
                  <c:v>83.081909085019007</c:v>
                </c:pt>
                <c:pt idx="23">
                  <c:v>75.836335801850595</c:v>
                </c:pt>
                <c:pt idx="24">
                  <c:v>86.025680182162503</c:v>
                </c:pt>
                <c:pt idx="25">
                  <c:v>59.033954086390402</c:v>
                </c:pt>
                <c:pt idx="26">
                  <c:v>62.523599165507498</c:v>
                </c:pt>
                <c:pt idx="27">
                  <c:v>79.399416002888501</c:v>
                </c:pt>
                <c:pt idx="28">
                  <c:v>87.715480357376094</c:v>
                </c:pt>
                <c:pt idx="29">
                  <c:v>58.817891407709297</c:v>
                </c:pt>
                <c:pt idx="30">
                  <c:v>66.898768346378503</c:v>
                </c:pt>
                <c:pt idx="31">
                  <c:v>78.246588668676793</c:v>
                </c:pt>
                <c:pt idx="32">
                  <c:v>70.658795145663007</c:v>
                </c:pt>
                <c:pt idx="33">
                  <c:v>64.382064881926496</c:v>
                </c:pt>
                <c:pt idx="34">
                  <c:v>73.957447551210507</c:v>
                </c:pt>
                <c:pt idx="35">
                  <c:v>76.830220835431405</c:v>
                </c:pt>
                <c:pt idx="36">
                  <c:v>75.780741157089693</c:v>
                </c:pt>
                <c:pt idx="37">
                  <c:v>69.268678678481606</c:v>
                </c:pt>
                <c:pt idx="38">
                  <c:v>71.978046425664004</c:v>
                </c:pt>
                <c:pt idx="39">
                  <c:v>71.388449858721998</c:v>
                </c:pt>
                <c:pt idx="40">
                  <c:v>73.972713601756297</c:v>
                </c:pt>
                <c:pt idx="41">
                  <c:v>72.606104905431806</c:v>
                </c:pt>
                <c:pt idx="42">
                  <c:v>76.137534313306006</c:v>
                </c:pt>
                <c:pt idx="43">
                  <c:v>77.151087957233401</c:v>
                </c:pt>
                <c:pt idx="44">
                  <c:v>79.877103524988698</c:v>
                </c:pt>
                <c:pt idx="45">
                  <c:v>66.477582236520902</c:v>
                </c:pt>
                <c:pt idx="46">
                  <c:v>69.818865565865806</c:v>
                </c:pt>
                <c:pt idx="47">
                  <c:v>83.515263451626396</c:v>
                </c:pt>
                <c:pt idx="48">
                  <c:v>71.589766718453305</c:v>
                </c:pt>
                <c:pt idx="49">
                  <c:v>68.307891420804395</c:v>
                </c:pt>
                <c:pt idx="50">
                  <c:v>68.408914284697602</c:v>
                </c:pt>
                <c:pt idx="51">
                  <c:v>85.4833346718858</c:v>
                </c:pt>
                <c:pt idx="52">
                  <c:v>65.448782714843404</c:v>
                </c:pt>
                <c:pt idx="53">
                  <c:v>65.711931814085801</c:v>
                </c:pt>
                <c:pt idx="54">
                  <c:v>84.824001966451505</c:v>
                </c:pt>
                <c:pt idx="55">
                  <c:v>65.933061827718006</c:v>
                </c:pt>
                <c:pt idx="56">
                  <c:v>77.090059221936002</c:v>
                </c:pt>
                <c:pt idx="57">
                  <c:v>65.333708912602802</c:v>
                </c:pt>
                <c:pt idx="58">
                  <c:v>67.855022456875403</c:v>
                </c:pt>
                <c:pt idx="59">
                  <c:v>66.741745516582995</c:v>
                </c:pt>
                <c:pt idx="60">
                  <c:v>78.6640175153385</c:v>
                </c:pt>
                <c:pt idx="61">
                  <c:v>61.714097768926898</c:v>
                </c:pt>
                <c:pt idx="62">
                  <c:v>81.815545712584196</c:v>
                </c:pt>
                <c:pt idx="63">
                  <c:v>87.478806672377203</c:v>
                </c:pt>
                <c:pt idx="64">
                  <c:v>78.059966293532895</c:v>
                </c:pt>
                <c:pt idx="65">
                  <c:v>72.519249747186393</c:v>
                </c:pt>
                <c:pt idx="66">
                  <c:v>78.795124886131902</c:v>
                </c:pt>
                <c:pt idx="67">
                  <c:v>72.405038887037193</c:v>
                </c:pt>
                <c:pt idx="68">
                  <c:v>68.646152000036295</c:v>
                </c:pt>
                <c:pt idx="69">
                  <c:v>64.570742660589303</c:v>
                </c:pt>
                <c:pt idx="70">
                  <c:v>75.608272310008005</c:v>
                </c:pt>
                <c:pt idx="71">
                  <c:v>62.418552321480099</c:v>
                </c:pt>
                <c:pt idx="72">
                  <c:v>75.271094807720203</c:v>
                </c:pt>
                <c:pt idx="73">
                  <c:v>72.731504704381194</c:v>
                </c:pt>
                <c:pt idx="74">
                  <c:v>75.797533301546693</c:v>
                </c:pt>
                <c:pt idx="75">
                  <c:v>88.343550869620103</c:v>
                </c:pt>
                <c:pt idx="76">
                  <c:v>84.906600239030993</c:v>
                </c:pt>
                <c:pt idx="77">
                  <c:v>71.662558429502198</c:v>
                </c:pt>
                <c:pt idx="78">
                  <c:v>75.036752875095004</c:v>
                </c:pt>
                <c:pt idx="79">
                  <c:v>83.923902238541899</c:v>
                </c:pt>
                <c:pt idx="80">
                  <c:v>68.432966485553294</c:v>
                </c:pt>
                <c:pt idx="81">
                  <c:v>64.445507103732595</c:v>
                </c:pt>
                <c:pt idx="82">
                  <c:v>63.811108111641801</c:v>
                </c:pt>
                <c:pt idx="83">
                  <c:v>69.899253910492106</c:v>
                </c:pt>
                <c:pt idx="84">
                  <c:v>69.867466961729306</c:v>
                </c:pt>
                <c:pt idx="85">
                  <c:v>68.959105495433306</c:v>
                </c:pt>
                <c:pt idx="86">
                  <c:v>68.0069243226108</c:v>
                </c:pt>
                <c:pt idx="87">
                  <c:v>87.5447585478382</c:v>
                </c:pt>
                <c:pt idx="88">
                  <c:v>66.863966118163205</c:v>
                </c:pt>
                <c:pt idx="89">
                  <c:v>75.073578621329105</c:v>
                </c:pt>
                <c:pt idx="90">
                  <c:v>69.760285822393996</c:v>
                </c:pt>
                <c:pt idx="91">
                  <c:v>78.987618757669097</c:v>
                </c:pt>
                <c:pt idx="92">
                  <c:v>58.031849909585503</c:v>
                </c:pt>
                <c:pt idx="93">
                  <c:v>68.7588866795911</c:v>
                </c:pt>
                <c:pt idx="94">
                  <c:v>75.7074732373313</c:v>
                </c:pt>
                <c:pt idx="95">
                  <c:v>80.763797583042205</c:v>
                </c:pt>
                <c:pt idx="96">
                  <c:v>76.635953131248897</c:v>
                </c:pt>
                <c:pt idx="97">
                  <c:v>63.8099628802034</c:v>
                </c:pt>
                <c:pt idx="98">
                  <c:v>63.678744380979303</c:v>
                </c:pt>
                <c:pt idx="99">
                  <c:v>75.976730282629106</c:v>
                </c:pt>
                <c:pt idx="100">
                  <c:v>83.917775899649698</c:v>
                </c:pt>
                <c:pt idx="101">
                  <c:v>66.846729617399106</c:v>
                </c:pt>
                <c:pt idx="102">
                  <c:v>69.083197147579895</c:v>
                </c:pt>
                <c:pt idx="103">
                  <c:v>74.552066667286695</c:v>
                </c:pt>
                <c:pt idx="104">
                  <c:v>75.305812423360095</c:v>
                </c:pt>
                <c:pt idx="105">
                  <c:v>83.303561781746296</c:v>
                </c:pt>
                <c:pt idx="106">
                  <c:v>76.627303409792006</c:v>
                </c:pt>
                <c:pt idx="107">
                  <c:v>63.031711828055201</c:v>
                </c:pt>
                <c:pt idx="108">
                  <c:v>75.832189308980801</c:v>
                </c:pt>
                <c:pt idx="109">
                  <c:v>91.268903563792804</c:v>
                </c:pt>
                <c:pt idx="110">
                  <c:v>74.239406597478094</c:v>
                </c:pt>
                <c:pt idx="111">
                  <c:v>78.807228354348496</c:v>
                </c:pt>
                <c:pt idx="112">
                  <c:v>68.2501235941359</c:v>
                </c:pt>
                <c:pt idx="113">
                  <c:v>88.398298239349103</c:v>
                </c:pt>
                <c:pt idx="114">
                  <c:v>80.370298465400793</c:v>
                </c:pt>
                <c:pt idx="115">
                  <c:v>68.024411204335806</c:v>
                </c:pt>
                <c:pt idx="116">
                  <c:v>80.407681902619203</c:v>
                </c:pt>
                <c:pt idx="117">
                  <c:v>73.5279053829899</c:v>
                </c:pt>
                <c:pt idx="118">
                  <c:v>70.697596410061294</c:v>
                </c:pt>
                <c:pt idx="119">
                  <c:v>78.953601405448495</c:v>
                </c:pt>
                <c:pt idx="120">
                  <c:v>72.441287864260303</c:v>
                </c:pt>
                <c:pt idx="121">
                  <c:v>60.163666164670602</c:v>
                </c:pt>
                <c:pt idx="122">
                  <c:v>69.0872593880339</c:v>
                </c:pt>
                <c:pt idx="123">
                  <c:v>67.7987849617938</c:v>
                </c:pt>
                <c:pt idx="124">
                  <c:v>82.993721806932598</c:v>
                </c:pt>
                <c:pt idx="125">
                  <c:v>69.367851990489299</c:v>
                </c:pt>
                <c:pt idx="126">
                  <c:v>78.844651731703195</c:v>
                </c:pt>
                <c:pt idx="127">
                  <c:v>75.394540032828303</c:v>
                </c:pt>
                <c:pt idx="128">
                  <c:v>82.221123026660806</c:v>
                </c:pt>
                <c:pt idx="129">
                  <c:v>65.3333881849112</c:v>
                </c:pt>
                <c:pt idx="130">
                  <c:v>68.318673615056099</c:v>
                </c:pt>
                <c:pt idx="131">
                  <c:v>71.247303395372597</c:v>
                </c:pt>
                <c:pt idx="132">
                  <c:v>68.108485726883202</c:v>
                </c:pt>
                <c:pt idx="133">
                  <c:v>72.415104238138994</c:v>
                </c:pt>
                <c:pt idx="134">
                  <c:v>72.920649452545604</c:v>
                </c:pt>
                <c:pt idx="135">
                  <c:v>68.813130678629093</c:v>
                </c:pt>
                <c:pt idx="136">
                  <c:v>72.200205012959302</c:v>
                </c:pt>
                <c:pt idx="137">
                  <c:v>71.161439800364107</c:v>
                </c:pt>
                <c:pt idx="138">
                  <c:v>70.765967007596203</c:v>
                </c:pt>
                <c:pt idx="139">
                  <c:v>80.273318303338698</c:v>
                </c:pt>
                <c:pt idx="140">
                  <c:v>69.985367339311395</c:v>
                </c:pt>
                <c:pt idx="141">
                  <c:v>74.614044829760005</c:v>
                </c:pt>
                <c:pt idx="142">
                  <c:v>72.626739861112299</c:v>
                </c:pt>
                <c:pt idx="143">
                  <c:v>81.179525648188005</c:v>
                </c:pt>
                <c:pt idx="144">
                  <c:v>89.041313103297696</c:v>
                </c:pt>
                <c:pt idx="145">
                  <c:v>78.691301660454897</c:v>
                </c:pt>
                <c:pt idx="146">
                  <c:v>61.2801126823842</c:v>
                </c:pt>
                <c:pt idx="147">
                  <c:v>64.854340297895106</c:v>
                </c:pt>
                <c:pt idx="148">
                  <c:v>68.0734711916176</c:v>
                </c:pt>
                <c:pt idx="149">
                  <c:v>63.896890870171298</c:v>
                </c:pt>
                <c:pt idx="150">
                  <c:v>74.564459243939197</c:v>
                </c:pt>
                <c:pt idx="151">
                  <c:v>76.639942039456798</c:v>
                </c:pt>
                <c:pt idx="152">
                  <c:v>66.778085360024605</c:v>
                </c:pt>
                <c:pt idx="153">
                  <c:v>70.733997869398806</c:v>
                </c:pt>
                <c:pt idx="154">
                  <c:v>62.362825389031102</c:v>
                </c:pt>
                <c:pt idx="155">
                  <c:v>71.814876421574098</c:v>
                </c:pt>
                <c:pt idx="156">
                  <c:v>70.037543767372398</c:v>
                </c:pt>
                <c:pt idx="157">
                  <c:v>71.090367967076503</c:v>
                </c:pt>
                <c:pt idx="158">
                  <c:v>69.135063177761197</c:v>
                </c:pt>
                <c:pt idx="159">
                  <c:v>70.016511863431404</c:v>
                </c:pt>
                <c:pt idx="160">
                  <c:v>75.431680890833903</c:v>
                </c:pt>
                <c:pt idx="161">
                  <c:v>74.951162530576994</c:v>
                </c:pt>
                <c:pt idx="162">
                  <c:v>93.313061636827697</c:v>
                </c:pt>
                <c:pt idx="163">
                  <c:v>75.046684032016302</c:v>
                </c:pt>
                <c:pt idx="164">
                  <c:v>74.514695369396705</c:v>
                </c:pt>
                <c:pt idx="165">
                  <c:v>72.345451377161098</c:v>
                </c:pt>
                <c:pt idx="166">
                  <c:v>64.2565765403222</c:v>
                </c:pt>
                <c:pt idx="167">
                  <c:v>79.993402730845801</c:v>
                </c:pt>
                <c:pt idx="168">
                  <c:v>71.858354490134303</c:v>
                </c:pt>
                <c:pt idx="169">
                  <c:v>61.795520727218999</c:v>
                </c:pt>
                <c:pt idx="170">
                  <c:v>78.8273824025907</c:v>
                </c:pt>
                <c:pt idx="171">
                  <c:v>69.471260608987606</c:v>
                </c:pt>
                <c:pt idx="172">
                  <c:v>67.699759179193705</c:v>
                </c:pt>
                <c:pt idx="173">
                  <c:v>68.051002420714696</c:v>
                </c:pt>
                <c:pt idx="174">
                  <c:v>76.959002010550705</c:v>
                </c:pt>
                <c:pt idx="175">
                  <c:v>75.005678597870201</c:v>
                </c:pt>
                <c:pt idx="176">
                  <c:v>70.081597426661503</c:v>
                </c:pt>
                <c:pt idx="177">
                  <c:v>75.221810390880904</c:v>
                </c:pt>
                <c:pt idx="178">
                  <c:v>70.793383617586599</c:v>
                </c:pt>
                <c:pt idx="179">
                  <c:v>71.911924687160194</c:v>
                </c:pt>
                <c:pt idx="180">
                  <c:v>66.369416630822101</c:v>
                </c:pt>
                <c:pt idx="181">
                  <c:v>65.859232852930006</c:v>
                </c:pt>
                <c:pt idx="182">
                  <c:v>82.945133027145999</c:v>
                </c:pt>
                <c:pt idx="183">
                  <c:v>75.878056157407102</c:v>
                </c:pt>
                <c:pt idx="184">
                  <c:v>77.592005210561993</c:v>
                </c:pt>
                <c:pt idx="185">
                  <c:v>68.077910493146106</c:v>
                </c:pt>
                <c:pt idx="186">
                  <c:v>65.896364220511998</c:v>
                </c:pt>
                <c:pt idx="187">
                  <c:v>85.827480079194899</c:v>
                </c:pt>
                <c:pt idx="188">
                  <c:v>74.175903420161703</c:v>
                </c:pt>
                <c:pt idx="189">
                  <c:v>70.301263051364103</c:v>
                </c:pt>
                <c:pt idx="190">
                  <c:v>76.749925186603605</c:v>
                </c:pt>
                <c:pt idx="191">
                  <c:v>65.682087580000498</c:v>
                </c:pt>
                <c:pt idx="192">
                  <c:v>65.147701421623594</c:v>
                </c:pt>
                <c:pt idx="193">
                  <c:v>71.395523329541305</c:v>
                </c:pt>
                <c:pt idx="194">
                  <c:v>73.768262017344597</c:v>
                </c:pt>
                <c:pt idx="195">
                  <c:v>75.296663503983098</c:v>
                </c:pt>
                <c:pt idx="196">
                  <c:v>78.711780770011998</c:v>
                </c:pt>
                <c:pt idx="197">
                  <c:v>75.394663724285394</c:v>
                </c:pt>
                <c:pt idx="198">
                  <c:v>90.393819059386502</c:v>
                </c:pt>
                <c:pt idx="199">
                  <c:v>73.982052940841101</c:v>
                </c:pt>
                <c:pt idx="200">
                  <c:v>69.918284343981298</c:v>
                </c:pt>
                <c:pt idx="201">
                  <c:v>80.330796531456599</c:v>
                </c:pt>
                <c:pt idx="202">
                  <c:v>79.9103046408203</c:v>
                </c:pt>
                <c:pt idx="203">
                  <c:v>87.416535906333905</c:v>
                </c:pt>
                <c:pt idx="204">
                  <c:v>70.035888594461696</c:v>
                </c:pt>
                <c:pt idx="205">
                  <c:v>76.163249223311496</c:v>
                </c:pt>
                <c:pt idx="206">
                  <c:v>65.1086945722396</c:v>
                </c:pt>
                <c:pt idx="207">
                  <c:v>76.706319800306204</c:v>
                </c:pt>
                <c:pt idx="208">
                  <c:v>81.176948948137195</c:v>
                </c:pt>
                <c:pt idx="209">
                  <c:v>69.748609070931707</c:v>
                </c:pt>
                <c:pt idx="210">
                  <c:v>73.591276103339695</c:v>
                </c:pt>
                <c:pt idx="211">
                  <c:v>78.676078522817804</c:v>
                </c:pt>
                <c:pt idx="212">
                  <c:v>75.213977312378006</c:v>
                </c:pt>
                <c:pt idx="213">
                  <c:v>67.902379370234001</c:v>
                </c:pt>
                <c:pt idx="214">
                  <c:v>87.680740742462802</c:v>
                </c:pt>
                <c:pt idx="215">
                  <c:v>83.222177120479799</c:v>
                </c:pt>
                <c:pt idx="216">
                  <c:v>67.403475992130197</c:v>
                </c:pt>
                <c:pt idx="217">
                  <c:v>72.805533603581907</c:v>
                </c:pt>
                <c:pt idx="218">
                  <c:v>83.391310976068397</c:v>
                </c:pt>
                <c:pt idx="219">
                  <c:v>77.680857021814603</c:v>
                </c:pt>
                <c:pt idx="220">
                  <c:v>81.466078230365994</c:v>
                </c:pt>
                <c:pt idx="221">
                  <c:v>63.656835553330303</c:v>
                </c:pt>
                <c:pt idx="222">
                  <c:v>82.195588086267307</c:v>
                </c:pt>
                <c:pt idx="223">
                  <c:v>73.694848903410303</c:v>
                </c:pt>
                <c:pt idx="224">
                  <c:v>69.084031592561502</c:v>
                </c:pt>
                <c:pt idx="225">
                  <c:v>79.585465319896997</c:v>
                </c:pt>
                <c:pt idx="226">
                  <c:v>77.014031878092098</c:v>
                </c:pt>
                <c:pt idx="227">
                  <c:v>81.843500482333795</c:v>
                </c:pt>
                <c:pt idx="228">
                  <c:v>84.501546468637699</c:v>
                </c:pt>
                <c:pt idx="229">
                  <c:v>77.808467091031105</c:v>
                </c:pt>
                <c:pt idx="230">
                  <c:v>83.465819485647401</c:v>
                </c:pt>
                <c:pt idx="231">
                  <c:v>70.389974010409802</c:v>
                </c:pt>
                <c:pt idx="232">
                  <c:v>73.751924926115706</c:v>
                </c:pt>
                <c:pt idx="233">
                  <c:v>67.867028128896095</c:v>
                </c:pt>
                <c:pt idx="234">
                  <c:v>67.459729876144905</c:v>
                </c:pt>
                <c:pt idx="235">
                  <c:v>76.326474377424105</c:v>
                </c:pt>
                <c:pt idx="236">
                  <c:v>70.305713661696998</c:v>
                </c:pt>
                <c:pt idx="237">
                  <c:v>66.359742489227799</c:v>
                </c:pt>
                <c:pt idx="238">
                  <c:v>71.581415976560706</c:v>
                </c:pt>
                <c:pt idx="239">
                  <c:v>76.793678796508303</c:v>
                </c:pt>
                <c:pt idx="240">
                  <c:v>78.544550892912696</c:v>
                </c:pt>
                <c:pt idx="241">
                  <c:v>69.251355338454005</c:v>
                </c:pt>
                <c:pt idx="242">
                  <c:v>76.622622492889803</c:v>
                </c:pt>
                <c:pt idx="243">
                  <c:v>69.401232417491201</c:v>
                </c:pt>
                <c:pt idx="244">
                  <c:v>79.797518572081998</c:v>
                </c:pt>
                <c:pt idx="245">
                  <c:v>68.002886337808206</c:v>
                </c:pt>
                <c:pt idx="246">
                  <c:v>66.550610349486405</c:v>
                </c:pt>
                <c:pt idx="247">
                  <c:v>79.612408442685094</c:v>
                </c:pt>
                <c:pt idx="248">
                  <c:v>65.648231152147702</c:v>
                </c:pt>
                <c:pt idx="249">
                  <c:v>73.239528579108693</c:v>
                </c:pt>
                <c:pt idx="250">
                  <c:v>67.380766751035793</c:v>
                </c:pt>
                <c:pt idx="251">
                  <c:v>68.080293434839803</c:v>
                </c:pt>
                <c:pt idx="252">
                  <c:v>84.784856728069101</c:v>
                </c:pt>
                <c:pt idx="253">
                  <c:v>77.943341233467805</c:v>
                </c:pt>
                <c:pt idx="254">
                  <c:v>70.5269487356654</c:v>
                </c:pt>
                <c:pt idx="255">
                  <c:v>73.867372977572501</c:v>
                </c:pt>
                <c:pt idx="256">
                  <c:v>77.875943010805102</c:v>
                </c:pt>
                <c:pt idx="257">
                  <c:v>79.131212881119694</c:v>
                </c:pt>
                <c:pt idx="258">
                  <c:v>72.684782153438405</c:v>
                </c:pt>
                <c:pt idx="259">
                  <c:v>74.128752868683407</c:v>
                </c:pt>
                <c:pt idx="260">
                  <c:v>67.575903782677898</c:v>
                </c:pt>
                <c:pt idx="261">
                  <c:v>78.519196959977805</c:v>
                </c:pt>
                <c:pt idx="262">
                  <c:v>68.526573432248497</c:v>
                </c:pt>
                <c:pt idx="263">
                  <c:v>68.903412909504993</c:v>
                </c:pt>
                <c:pt idx="264">
                  <c:v>67.918451465871399</c:v>
                </c:pt>
                <c:pt idx="265">
                  <c:v>72.794779826529705</c:v>
                </c:pt>
                <c:pt idx="266">
                  <c:v>73.243462475666803</c:v>
                </c:pt>
                <c:pt idx="267">
                  <c:v>84.382065085992295</c:v>
                </c:pt>
                <c:pt idx="268">
                  <c:v>67.549424079673202</c:v>
                </c:pt>
                <c:pt idx="269">
                  <c:v>66.674041308420598</c:v>
                </c:pt>
                <c:pt idx="270">
                  <c:v>65.324001550219194</c:v>
                </c:pt>
                <c:pt idx="271">
                  <c:v>75.876041120475605</c:v>
                </c:pt>
                <c:pt idx="272">
                  <c:v>72.785238687714099</c:v>
                </c:pt>
                <c:pt idx="273">
                  <c:v>76.091161709329995</c:v>
                </c:pt>
                <c:pt idx="274">
                  <c:v>69.881465354288295</c:v>
                </c:pt>
                <c:pt idx="275">
                  <c:v>65.103369840584904</c:v>
                </c:pt>
                <c:pt idx="276">
                  <c:v>76.901120207916193</c:v>
                </c:pt>
                <c:pt idx="277">
                  <c:v>66.231027827274801</c:v>
                </c:pt>
                <c:pt idx="278">
                  <c:v>72.557166168108196</c:v>
                </c:pt>
                <c:pt idx="279">
                  <c:v>75.166669862620296</c:v>
                </c:pt>
                <c:pt idx="280">
                  <c:v>76.161714366637298</c:v>
                </c:pt>
                <c:pt idx="281">
                  <c:v>68.097449994446194</c:v>
                </c:pt>
                <c:pt idx="282">
                  <c:v>69.391429781295599</c:v>
                </c:pt>
                <c:pt idx="283">
                  <c:v>73.0993747302863</c:v>
                </c:pt>
                <c:pt idx="284">
                  <c:v>79.687006345453398</c:v>
                </c:pt>
                <c:pt idx="285">
                  <c:v>70.788632661608602</c:v>
                </c:pt>
                <c:pt idx="286">
                  <c:v>57.5782612569324</c:v>
                </c:pt>
                <c:pt idx="287">
                  <c:v>72.5586615541783</c:v>
                </c:pt>
                <c:pt idx="288">
                  <c:v>66.579228507855305</c:v>
                </c:pt>
                <c:pt idx="289">
                  <c:v>74.369736094141501</c:v>
                </c:pt>
                <c:pt idx="290">
                  <c:v>73.482146429185804</c:v>
                </c:pt>
                <c:pt idx="291">
                  <c:v>75.9052483217952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B3F-46C3-830C-65F47EA8CA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196032"/>
        <c:axId val="199201920"/>
      </c:scatterChart>
      <c:valAx>
        <c:axId val="1991960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9201920"/>
        <c:crosses val="autoZero"/>
        <c:crossBetween val="midCat"/>
      </c:valAx>
      <c:valAx>
        <c:axId val="1992019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91960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862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i="0" u="none" strike="noStrike" kern="1200" spc="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I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862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G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4798915135608048"/>
                  <c:y val="-0.2585631657153966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sz="1197" b="0" i="0" u="none" strike="noStrike" kern="1200" baseline="0">
                        <a:solidFill>
                          <a:prstClr val="black">
                            <a:lumMod val="65000"/>
                            <a:lumOff val="35000"/>
                          </a:prst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1.0671x + 16.939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1143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sz="1197" b="0" i="0" u="none" strike="noStrike" kern="120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E$2:$E$293</c:f>
              <c:numCache>
                <c:formatCode>0.0</c:formatCode>
                <c:ptCount val="292"/>
                <c:pt idx="0">
                  <c:v>52.776198726008502</c:v>
                </c:pt>
                <c:pt idx="1">
                  <c:v>52.853823858660299</c:v>
                </c:pt>
                <c:pt idx="2">
                  <c:v>47.963701373834098</c:v>
                </c:pt>
                <c:pt idx="3">
                  <c:v>54.583606322228697</c:v>
                </c:pt>
                <c:pt idx="4">
                  <c:v>55.426196230898</c:v>
                </c:pt>
                <c:pt idx="5">
                  <c:v>55.769019260867502</c:v>
                </c:pt>
                <c:pt idx="6">
                  <c:v>51.065331274260203</c:v>
                </c:pt>
                <c:pt idx="7">
                  <c:v>54.425983401221302</c:v>
                </c:pt>
                <c:pt idx="8">
                  <c:v>54.171975015572599</c:v>
                </c:pt>
                <c:pt idx="9">
                  <c:v>55.370491972742002</c:v>
                </c:pt>
                <c:pt idx="10">
                  <c:v>52.056147878179203</c:v>
                </c:pt>
                <c:pt idx="11">
                  <c:v>51.743020135075199</c:v>
                </c:pt>
                <c:pt idx="12">
                  <c:v>52.700143303385701</c:v>
                </c:pt>
                <c:pt idx="13">
                  <c:v>57.314548876337099</c:v>
                </c:pt>
                <c:pt idx="14">
                  <c:v>52.313774366012403</c:v>
                </c:pt>
                <c:pt idx="15">
                  <c:v>54.018322351968898</c:v>
                </c:pt>
                <c:pt idx="16">
                  <c:v>49.224444054428297</c:v>
                </c:pt>
                <c:pt idx="17">
                  <c:v>53.990048648421997</c:v>
                </c:pt>
                <c:pt idx="18">
                  <c:v>55.406704684094201</c:v>
                </c:pt>
                <c:pt idx="19">
                  <c:v>54.5586974850264</c:v>
                </c:pt>
                <c:pt idx="20">
                  <c:v>52.989383975904701</c:v>
                </c:pt>
                <c:pt idx="21">
                  <c:v>49.950872448978402</c:v>
                </c:pt>
                <c:pt idx="22">
                  <c:v>53.6373574758099</c:v>
                </c:pt>
                <c:pt idx="23">
                  <c:v>56.953249567660798</c:v>
                </c:pt>
                <c:pt idx="24">
                  <c:v>56.419361505020902</c:v>
                </c:pt>
                <c:pt idx="25">
                  <c:v>46.791235665231603</c:v>
                </c:pt>
                <c:pt idx="26">
                  <c:v>48.752833697526903</c:v>
                </c:pt>
                <c:pt idx="27">
                  <c:v>54.921511824638799</c:v>
                </c:pt>
                <c:pt idx="28">
                  <c:v>52.469707581110598</c:v>
                </c:pt>
                <c:pt idx="29">
                  <c:v>46.428542786829901</c:v>
                </c:pt>
                <c:pt idx="30">
                  <c:v>53.684963747407103</c:v>
                </c:pt>
                <c:pt idx="31">
                  <c:v>53.168349910853003</c:v>
                </c:pt>
                <c:pt idx="32">
                  <c:v>52.460931696886597</c:v>
                </c:pt>
                <c:pt idx="33">
                  <c:v>52.498805744410902</c:v>
                </c:pt>
                <c:pt idx="34">
                  <c:v>54.112121516883903</c:v>
                </c:pt>
                <c:pt idx="35">
                  <c:v>52.011910651646303</c:v>
                </c:pt>
                <c:pt idx="36">
                  <c:v>54.473945829075703</c:v>
                </c:pt>
                <c:pt idx="37">
                  <c:v>50.220761905319897</c:v>
                </c:pt>
                <c:pt idx="38">
                  <c:v>54.509070900928897</c:v>
                </c:pt>
                <c:pt idx="39">
                  <c:v>52.252805886947201</c:v>
                </c:pt>
                <c:pt idx="40">
                  <c:v>51.743583120067001</c:v>
                </c:pt>
                <c:pt idx="41">
                  <c:v>54.232890153511299</c:v>
                </c:pt>
                <c:pt idx="42">
                  <c:v>54.316836394843897</c:v>
                </c:pt>
                <c:pt idx="43">
                  <c:v>55.626088244953202</c:v>
                </c:pt>
                <c:pt idx="44">
                  <c:v>53.187700279769402</c:v>
                </c:pt>
                <c:pt idx="45">
                  <c:v>50.880044680451498</c:v>
                </c:pt>
                <c:pt idx="46">
                  <c:v>53.519897099596598</c:v>
                </c:pt>
                <c:pt idx="47">
                  <c:v>54.0093890523762</c:v>
                </c:pt>
                <c:pt idx="48">
                  <c:v>54.116180871337697</c:v>
                </c:pt>
                <c:pt idx="49">
                  <c:v>55.314953198038999</c:v>
                </c:pt>
                <c:pt idx="50">
                  <c:v>52.216710875595702</c:v>
                </c:pt>
                <c:pt idx="51">
                  <c:v>54.944383884813199</c:v>
                </c:pt>
                <c:pt idx="52">
                  <c:v>56.738502939732797</c:v>
                </c:pt>
                <c:pt idx="53">
                  <c:v>52.045971747569503</c:v>
                </c:pt>
                <c:pt idx="54">
                  <c:v>55.3597067537982</c:v>
                </c:pt>
                <c:pt idx="55">
                  <c:v>50.150335589603699</c:v>
                </c:pt>
                <c:pt idx="56">
                  <c:v>50.709193785478298</c:v>
                </c:pt>
                <c:pt idx="57">
                  <c:v>50.9014158424702</c:v>
                </c:pt>
                <c:pt idx="58">
                  <c:v>51.785449913828302</c:v>
                </c:pt>
                <c:pt idx="59">
                  <c:v>54.862747855800102</c:v>
                </c:pt>
                <c:pt idx="60">
                  <c:v>55.4573083344346</c:v>
                </c:pt>
                <c:pt idx="61">
                  <c:v>53.549679695522002</c:v>
                </c:pt>
                <c:pt idx="62">
                  <c:v>54.2741582244645</c:v>
                </c:pt>
                <c:pt idx="63">
                  <c:v>54.278172100572199</c:v>
                </c:pt>
                <c:pt idx="64">
                  <c:v>54.757387110934403</c:v>
                </c:pt>
                <c:pt idx="65">
                  <c:v>51.729551702877103</c:v>
                </c:pt>
                <c:pt idx="66">
                  <c:v>55.1393777815466</c:v>
                </c:pt>
                <c:pt idx="67">
                  <c:v>50.191824433241699</c:v>
                </c:pt>
                <c:pt idx="68">
                  <c:v>45.509204714669302</c:v>
                </c:pt>
                <c:pt idx="69">
                  <c:v>54.394922229217997</c:v>
                </c:pt>
                <c:pt idx="70">
                  <c:v>50.565273370463601</c:v>
                </c:pt>
                <c:pt idx="71">
                  <c:v>48.894863366714198</c:v>
                </c:pt>
                <c:pt idx="72">
                  <c:v>51.907915471094498</c:v>
                </c:pt>
                <c:pt idx="73">
                  <c:v>55.044182334731602</c:v>
                </c:pt>
                <c:pt idx="74">
                  <c:v>54.434465249073597</c:v>
                </c:pt>
                <c:pt idx="75">
                  <c:v>55.110513021193199</c:v>
                </c:pt>
                <c:pt idx="76">
                  <c:v>54.407768952736298</c:v>
                </c:pt>
                <c:pt idx="77">
                  <c:v>56.303417018171103</c:v>
                </c:pt>
                <c:pt idx="78">
                  <c:v>51.927292180917803</c:v>
                </c:pt>
                <c:pt idx="79">
                  <c:v>51.548142065389101</c:v>
                </c:pt>
                <c:pt idx="80">
                  <c:v>55.474533134969697</c:v>
                </c:pt>
                <c:pt idx="81">
                  <c:v>53.086211858887303</c:v>
                </c:pt>
                <c:pt idx="82">
                  <c:v>52.723294846406098</c:v>
                </c:pt>
                <c:pt idx="83">
                  <c:v>52.155868490704599</c:v>
                </c:pt>
                <c:pt idx="84">
                  <c:v>54.519568460619297</c:v>
                </c:pt>
                <c:pt idx="85">
                  <c:v>49.973307721074796</c:v>
                </c:pt>
                <c:pt idx="86">
                  <c:v>54.114623473087804</c:v>
                </c:pt>
                <c:pt idx="87">
                  <c:v>52.311083120160198</c:v>
                </c:pt>
                <c:pt idx="88">
                  <c:v>45.8062552187262</c:v>
                </c:pt>
                <c:pt idx="89">
                  <c:v>52.181745652906798</c:v>
                </c:pt>
                <c:pt idx="90">
                  <c:v>55.494042034172502</c:v>
                </c:pt>
                <c:pt idx="91">
                  <c:v>53.720872709627798</c:v>
                </c:pt>
                <c:pt idx="92">
                  <c:v>51.540634769113801</c:v>
                </c:pt>
                <c:pt idx="93">
                  <c:v>51.254487592814698</c:v>
                </c:pt>
                <c:pt idx="94">
                  <c:v>52.807595586551798</c:v>
                </c:pt>
                <c:pt idx="95">
                  <c:v>54.635125577127198</c:v>
                </c:pt>
                <c:pt idx="96">
                  <c:v>55.035681223719401</c:v>
                </c:pt>
                <c:pt idx="97">
                  <c:v>52.493445134024299</c:v>
                </c:pt>
                <c:pt idx="98">
                  <c:v>54.2495525544239</c:v>
                </c:pt>
                <c:pt idx="99">
                  <c:v>55.817252681459998</c:v>
                </c:pt>
                <c:pt idx="100">
                  <c:v>53.085991025800702</c:v>
                </c:pt>
                <c:pt idx="101">
                  <c:v>51.390674164544102</c:v>
                </c:pt>
                <c:pt idx="102">
                  <c:v>53.330549995759597</c:v>
                </c:pt>
                <c:pt idx="103">
                  <c:v>52.245787090669303</c:v>
                </c:pt>
                <c:pt idx="104">
                  <c:v>56.122423981738102</c:v>
                </c:pt>
                <c:pt idx="105">
                  <c:v>53.813750825952702</c:v>
                </c:pt>
                <c:pt idx="106">
                  <c:v>52.677663287253097</c:v>
                </c:pt>
                <c:pt idx="107">
                  <c:v>50.2736988238184</c:v>
                </c:pt>
                <c:pt idx="108">
                  <c:v>55.100018705293103</c:v>
                </c:pt>
                <c:pt idx="109">
                  <c:v>56.210743989225499</c:v>
                </c:pt>
                <c:pt idx="110">
                  <c:v>52.019196556618901</c:v>
                </c:pt>
                <c:pt idx="111">
                  <c:v>53.1920172990555</c:v>
                </c:pt>
                <c:pt idx="112">
                  <c:v>52.5461462015124</c:v>
                </c:pt>
                <c:pt idx="113">
                  <c:v>55.92551306859</c:v>
                </c:pt>
                <c:pt idx="114">
                  <c:v>53.553832004496797</c:v>
                </c:pt>
                <c:pt idx="115">
                  <c:v>54.592127749933702</c:v>
                </c:pt>
                <c:pt idx="116">
                  <c:v>51.7129916311521</c:v>
                </c:pt>
                <c:pt idx="117">
                  <c:v>51.906805372268998</c:v>
                </c:pt>
                <c:pt idx="118">
                  <c:v>53.536873409522201</c:v>
                </c:pt>
                <c:pt idx="119">
                  <c:v>54.852039361125399</c:v>
                </c:pt>
                <c:pt idx="120">
                  <c:v>54.727033400088899</c:v>
                </c:pt>
                <c:pt idx="121">
                  <c:v>52.663809550872202</c:v>
                </c:pt>
                <c:pt idx="122">
                  <c:v>52.160128300355503</c:v>
                </c:pt>
                <c:pt idx="123">
                  <c:v>54.617088195883603</c:v>
                </c:pt>
                <c:pt idx="124">
                  <c:v>52.782158872298098</c:v>
                </c:pt>
                <c:pt idx="125">
                  <c:v>55.371220689442701</c:v>
                </c:pt>
                <c:pt idx="126">
                  <c:v>53.572272846309197</c:v>
                </c:pt>
                <c:pt idx="127">
                  <c:v>54.739669537288002</c:v>
                </c:pt>
                <c:pt idx="128">
                  <c:v>55.243741013796097</c:v>
                </c:pt>
                <c:pt idx="129">
                  <c:v>53.229876485433898</c:v>
                </c:pt>
                <c:pt idx="130">
                  <c:v>53.427527011897702</c:v>
                </c:pt>
                <c:pt idx="131">
                  <c:v>53.322404605246199</c:v>
                </c:pt>
                <c:pt idx="132">
                  <c:v>54.059634658729799</c:v>
                </c:pt>
                <c:pt idx="133">
                  <c:v>52.572675435479901</c:v>
                </c:pt>
                <c:pt idx="134">
                  <c:v>54.167910618431897</c:v>
                </c:pt>
                <c:pt idx="135">
                  <c:v>53.4689972641239</c:v>
                </c:pt>
                <c:pt idx="136">
                  <c:v>54.220047860453803</c:v>
                </c:pt>
                <c:pt idx="137">
                  <c:v>53.683305699879803</c:v>
                </c:pt>
                <c:pt idx="138">
                  <c:v>50.470354517205301</c:v>
                </c:pt>
                <c:pt idx="139">
                  <c:v>50.024690561538897</c:v>
                </c:pt>
                <c:pt idx="140">
                  <c:v>51.735267253179103</c:v>
                </c:pt>
                <c:pt idx="141">
                  <c:v>52.171766160725298</c:v>
                </c:pt>
                <c:pt idx="142">
                  <c:v>57.714679215837599</c:v>
                </c:pt>
                <c:pt idx="143">
                  <c:v>54.573671613810802</c:v>
                </c:pt>
                <c:pt idx="144">
                  <c:v>54.185791158591101</c:v>
                </c:pt>
                <c:pt idx="145">
                  <c:v>52.852192158312597</c:v>
                </c:pt>
                <c:pt idx="146">
                  <c:v>53.465113660225597</c:v>
                </c:pt>
                <c:pt idx="147">
                  <c:v>51.377582491374099</c:v>
                </c:pt>
                <c:pt idx="148">
                  <c:v>53.8420890104411</c:v>
                </c:pt>
                <c:pt idx="149">
                  <c:v>50.717786361925</c:v>
                </c:pt>
                <c:pt idx="150">
                  <c:v>52.684747654427099</c:v>
                </c:pt>
                <c:pt idx="151">
                  <c:v>54.605021521377303</c:v>
                </c:pt>
                <c:pt idx="152">
                  <c:v>54.778033502674603</c:v>
                </c:pt>
                <c:pt idx="153">
                  <c:v>53.657055984175003</c:v>
                </c:pt>
                <c:pt idx="154">
                  <c:v>48.728170745700503</c:v>
                </c:pt>
                <c:pt idx="155">
                  <c:v>55.217841937284497</c:v>
                </c:pt>
                <c:pt idx="156">
                  <c:v>53.631091845724001</c:v>
                </c:pt>
                <c:pt idx="157">
                  <c:v>50.151519236193899</c:v>
                </c:pt>
                <c:pt idx="158">
                  <c:v>56.879108586186</c:v>
                </c:pt>
                <c:pt idx="159">
                  <c:v>54.368059292724901</c:v>
                </c:pt>
                <c:pt idx="160">
                  <c:v>54.835818110127498</c:v>
                </c:pt>
                <c:pt idx="161">
                  <c:v>53.297792008168301</c:v>
                </c:pt>
                <c:pt idx="162">
                  <c:v>55.202316613076803</c:v>
                </c:pt>
                <c:pt idx="163">
                  <c:v>53.822077722629302</c:v>
                </c:pt>
                <c:pt idx="164">
                  <c:v>54.184139782279999</c:v>
                </c:pt>
                <c:pt idx="165">
                  <c:v>52.216796971092897</c:v>
                </c:pt>
                <c:pt idx="166">
                  <c:v>49.735787812811097</c:v>
                </c:pt>
                <c:pt idx="167">
                  <c:v>51.834278330588702</c:v>
                </c:pt>
                <c:pt idx="168">
                  <c:v>49.951672715658297</c:v>
                </c:pt>
                <c:pt idx="169">
                  <c:v>53.029250681607103</c:v>
                </c:pt>
                <c:pt idx="170">
                  <c:v>49.742036151876</c:v>
                </c:pt>
                <c:pt idx="171">
                  <c:v>49.838617166111199</c:v>
                </c:pt>
                <c:pt idx="172">
                  <c:v>52.912124294091498</c:v>
                </c:pt>
                <c:pt idx="173">
                  <c:v>51.551171157294903</c:v>
                </c:pt>
                <c:pt idx="174">
                  <c:v>55.030663892496101</c:v>
                </c:pt>
                <c:pt idx="175">
                  <c:v>50.896968265099297</c:v>
                </c:pt>
                <c:pt idx="176">
                  <c:v>52.506128078349299</c:v>
                </c:pt>
                <c:pt idx="177">
                  <c:v>53.444711563564802</c:v>
                </c:pt>
                <c:pt idx="178">
                  <c:v>51.116121677814398</c:v>
                </c:pt>
                <c:pt idx="179">
                  <c:v>52.6922960687169</c:v>
                </c:pt>
                <c:pt idx="180">
                  <c:v>53.349915228662297</c:v>
                </c:pt>
                <c:pt idx="181">
                  <c:v>54.213887870516999</c:v>
                </c:pt>
                <c:pt idx="182">
                  <c:v>53.536372751499798</c:v>
                </c:pt>
                <c:pt idx="183">
                  <c:v>54.138040803834997</c:v>
                </c:pt>
                <c:pt idx="184">
                  <c:v>51.738721253630402</c:v>
                </c:pt>
                <c:pt idx="185">
                  <c:v>51.91053122932</c:v>
                </c:pt>
                <c:pt idx="186">
                  <c:v>52.551539426702703</c:v>
                </c:pt>
                <c:pt idx="187">
                  <c:v>52.660619045415203</c:v>
                </c:pt>
                <c:pt idx="188">
                  <c:v>51.803403534675198</c:v>
                </c:pt>
                <c:pt idx="189">
                  <c:v>52.1292964803866</c:v>
                </c:pt>
                <c:pt idx="190">
                  <c:v>51.8104096227379</c:v>
                </c:pt>
                <c:pt idx="191">
                  <c:v>49.329805783362602</c:v>
                </c:pt>
                <c:pt idx="192">
                  <c:v>52.908539468115698</c:v>
                </c:pt>
                <c:pt idx="193">
                  <c:v>52.798332056004597</c:v>
                </c:pt>
                <c:pt idx="194">
                  <c:v>49.499032976789501</c:v>
                </c:pt>
                <c:pt idx="195">
                  <c:v>50.905420246001</c:v>
                </c:pt>
                <c:pt idx="196">
                  <c:v>53.543828997169697</c:v>
                </c:pt>
                <c:pt idx="197">
                  <c:v>55.483194121044299</c:v>
                </c:pt>
                <c:pt idx="198">
                  <c:v>53.4476936853927</c:v>
                </c:pt>
                <c:pt idx="199">
                  <c:v>54.822986218878299</c:v>
                </c:pt>
                <c:pt idx="200">
                  <c:v>49.064776278515403</c:v>
                </c:pt>
                <c:pt idx="201">
                  <c:v>53.9386630896323</c:v>
                </c:pt>
                <c:pt idx="202">
                  <c:v>55.805753220474898</c:v>
                </c:pt>
                <c:pt idx="203">
                  <c:v>53.139124566628503</c:v>
                </c:pt>
                <c:pt idx="204">
                  <c:v>51.627246307183199</c:v>
                </c:pt>
                <c:pt idx="205">
                  <c:v>49.2423160201703</c:v>
                </c:pt>
                <c:pt idx="206">
                  <c:v>54.223907019122898</c:v>
                </c:pt>
                <c:pt idx="207">
                  <c:v>49.089710568908998</c:v>
                </c:pt>
                <c:pt idx="208">
                  <c:v>53.6066179693061</c:v>
                </c:pt>
                <c:pt idx="209">
                  <c:v>49.591696942906999</c:v>
                </c:pt>
                <c:pt idx="210">
                  <c:v>54.310368547398397</c:v>
                </c:pt>
                <c:pt idx="211">
                  <c:v>50.509124788167398</c:v>
                </c:pt>
                <c:pt idx="212">
                  <c:v>52.694135508783901</c:v>
                </c:pt>
                <c:pt idx="213">
                  <c:v>51.384193324408599</c:v>
                </c:pt>
                <c:pt idx="214">
                  <c:v>52.595126386317901</c:v>
                </c:pt>
                <c:pt idx="215">
                  <c:v>59.194949515547101</c:v>
                </c:pt>
                <c:pt idx="216">
                  <c:v>51.280507677390901</c:v>
                </c:pt>
                <c:pt idx="217">
                  <c:v>56.500081486713398</c:v>
                </c:pt>
                <c:pt idx="218">
                  <c:v>57.029708936608898</c:v>
                </c:pt>
                <c:pt idx="219">
                  <c:v>51.455587980797503</c:v>
                </c:pt>
                <c:pt idx="220">
                  <c:v>52.293102330391697</c:v>
                </c:pt>
                <c:pt idx="221">
                  <c:v>53.949338270059101</c:v>
                </c:pt>
                <c:pt idx="222">
                  <c:v>53.4054172742593</c:v>
                </c:pt>
                <c:pt idx="223">
                  <c:v>50.818723781887499</c:v>
                </c:pt>
                <c:pt idx="224">
                  <c:v>50.1328247415479</c:v>
                </c:pt>
                <c:pt idx="225">
                  <c:v>57.088106265000199</c:v>
                </c:pt>
                <c:pt idx="226">
                  <c:v>53.491166714050102</c:v>
                </c:pt>
                <c:pt idx="227">
                  <c:v>53.3332322303932</c:v>
                </c:pt>
                <c:pt idx="228">
                  <c:v>53.175782930186799</c:v>
                </c:pt>
                <c:pt idx="229">
                  <c:v>50.442899552686299</c:v>
                </c:pt>
                <c:pt idx="230">
                  <c:v>55.836514595306703</c:v>
                </c:pt>
                <c:pt idx="231">
                  <c:v>54.941161957404098</c:v>
                </c:pt>
                <c:pt idx="232">
                  <c:v>54.575428963174197</c:v>
                </c:pt>
                <c:pt idx="233">
                  <c:v>55.707766573713997</c:v>
                </c:pt>
                <c:pt idx="234">
                  <c:v>51.985041034477298</c:v>
                </c:pt>
                <c:pt idx="235">
                  <c:v>53.918536197242297</c:v>
                </c:pt>
                <c:pt idx="236">
                  <c:v>51.015819408493101</c:v>
                </c:pt>
                <c:pt idx="237">
                  <c:v>51.871014148628397</c:v>
                </c:pt>
                <c:pt idx="238">
                  <c:v>50.545397562698597</c:v>
                </c:pt>
                <c:pt idx="239">
                  <c:v>53.000923279703699</c:v>
                </c:pt>
                <c:pt idx="240">
                  <c:v>53.613012659500797</c:v>
                </c:pt>
                <c:pt idx="241">
                  <c:v>54.488500019039897</c:v>
                </c:pt>
                <c:pt idx="242">
                  <c:v>53.390354581611497</c:v>
                </c:pt>
                <c:pt idx="243">
                  <c:v>54.482328311497497</c:v>
                </c:pt>
                <c:pt idx="244">
                  <c:v>52.777261606472798</c:v>
                </c:pt>
                <c:pt idx="245">
                  <c:v>52.660352810503703</c:v>
                </c:pt>
                <c:pt idx="246">
                  <c:v>52.016756713064296</c:v>
                </c:pt>
                <c:pt idx="247">
                  <c:v>52.045762673647303</c:v>
                </c:pt>
                <c:pt idx="248">
                  <c:v>51.966462011142298</c:v>
                </c:pt>
                <c:pt idx="249">
                  <c:v>53.634490914476601</c:v>
                </c:pt>
                <c:pt idx="250">
                  <c:v>54.964280314159801</c:v>
                </c:pt>
                <c:pt idx="251">
                  <c:v>52.615247265709201</c:v>
                </c:pt>
                <c:pt idx="252">
                  <c:v>54.8870186586404</c:v>
                </c:pt>
                <c:pt idx="253">
                  <c:v>53.436627062434603</c:v>
                </c:pt>
                <c:pt idx="254">
                  <c:v>55.745500720424602</c:v>
                </c:pt>
                <c:pt idx="255">
                  <c:v>47.658442419176701</c:v>
                </c:pt>
                <c:pt idx="256">
                  <c:v>53.672903319138499</c:v>
                </c:pt>
                <c:pt idx="257">
                  <c:v>55.743646913269899</c:v>
                </c:pt>
                <c:pt idx="258">
                  <c:v>53.292007499603997</c:v>
                </c:pt>
                <c:pt idx="259">
                  <c:v>52.985894107553001</c:v>
                </c:pt>
                <c:pt idx="260">
                  <c:v>53.910988011773703</c:v>
                </c:pt>
                <c:pt idx="261">
                  <c:v>54.056890644095802</c:v>
                </c:pt>
                <c:pt idx="262">
                  <c:v>54.175593821623501</c:v>
                </c:pt>
                <c:pt idx="263">
                  <c:v>56.607180876780497</c:v>
                </c:pt>
                <c:pt idx="264">
                  <c:v>52.300168414124201</c:v>
                </c:pt>
                <c:pt idx="265">
                  <c:v>53.198278846499797</c:v>
                </c:pt>
                <c:pt idx="266">
                  <c:v>53.438795598352101</c:v>
                </c:pt>
                <c:pt idx="267">
                  <c:v>55.239433435602002</c:v>
                </c:pt>
                <c:pt idx="268">
                  <c:v>50.566541060399601</c:v>
                </c:pt>
                <c:pt idx="269">
                  <c:v>50.882446888908397</c:v>
                </c:pt>
                <c:pt idx="270">
                  <c:v>45.637257520890998</c:v>
                </c:pt>
                <c:pt idx="271">
                  <c:v>51.658841974081703</c:v>
                </c:pt>
                <c:pt idx="272">
                  <c:v>51.819556362716199</c:v>
                </c:pt>
                <c:pt idx="273">
                  <c:v>50.534255196991197</c:v>
                </c:pt>
                <c:pt idx="274">
                  <c:v>51.489392237112298</c:v>
                </c:pt>
                <c:pt idx="275">
                  <c:v>52.847564727769701</c:v>
                </c:pt>
                <c:pt idx="276">
                  <c:v>49.3196759213536</c:v>
                </c:pt>
                <c:pt idx="277">
                  <c:v>54.599425194077099</c:v>
                </c:pt>
                <c:pt idx="278">
                  <c:v>52.108419506087003</c:v>
                </c:pt>
                <c:pt idx="279">
                  <c:v>51.659152400835801</c:v>
                </c:pt>
                <c:pt idx="280">
                  <c:v>52.336514447192698</c:v>
                </c:pt>
                <c:pt idx="281">
                  <c:v>51.1539504997221</c:v>
                </c:pt>
                <c:pt idx="282">
                  <c:v>50.930794649333599</c:v>
                </c:pt>
                <c:pt idx="283">
                  <c:v>56.811004931876198</c:v>
                </c:pt>
                <c:pt idx="284">
                  <c:v>54.311868411766802</c:v>
                </c:pt>
                <c:pt idx="285">
                  <c:v>55.496364895680998</c:v>
                </c:pt>
                <c:pt idx="286">
                  <c:v>50.5070788521503</c:v>
                </c:pt>
                <c:pt idx="287">
                  <c:v>54.377149088002497</c:v>
                </c:pt>
                <c:pt idx="288">
                  <c:v>53.270628781344499</c:v>
                </c:pt>
                <c:pt idx="289">
                  <c:v>50.892452140248601</c:v>
                </c:pt>
                <c:pt idx="290">
                  <c:v>51.450757776676603</c:v>
                </c:pt>
                <c:pt idx="291">
                  <c:v>51.274756279087903</c:v>
                </c:pt>
              </c:numCache>
            </c:numRef>
          </c:xVal>
          <c:yVal>
            <c:numRef>
              <c:f>Sheet1!$G$2:$G$293</c:f>
              <c:numCache>
                <c:formatCode>0.0</c:formatCode>
                <c:ptCount val="292"/>
                <c:pt idx="0">
                  <c:v>75.175185865463803</c:v>
                </c:pt>
                <c:pt idx="1">
                  <c:v>77.280762251155494</c:v>
                </c:pt>
                <c:pt idx="2">
                  <c:v>66.236922542963995</c:v>
                </c:pt>
                <c:pt idx="3">
                  <c:v>76.749217605516506</c:v>
                </c:pt>
                <c:pt idx="4">
                  <c:v>72.297496060432806</c:v>
                </c:pt>
                <c:pt idx="5">
                  <c:v>78.097124422005393</c:v>
                </c:pt>
                <c:pt idx="6">
                  <c:v>66.896393641304996</c:v>
                </c:pt>
                <c:pt idx="7">
                  <c:v>79.481449996611303</c:v>
                </c:pt>
                <c:pt idx="8">
                  <c:v>73.631875156809699</c:v>
                </c:pt>
                <c:pt idx="9">
                  <c:v>87.445739811342307</c:v>
                </c:pt>
                <c:pt idx="10">
                  <c:v>75.689039109647297</c:v>
                </c:pt>
                <c:pt idx="11">
                  <c:v>79.140903014594997</c:v>
                </c:pt>
                <c:pt idx="12">
                  <c:v>85.720186678772905</c:v>
                </c:pt>
                <c:pt idx="13">
                  <c:v>75.974709074757698</c:v>
                </c:pt>
                <c:pt idx="14">
                  <c:v>62.257033455099602</c:v>
                </c:pt>
                <c:pt idx="15">
                  <c:v>74.873685966021796</c:v>
                </c:pt>
                <c:pt idx="16">
                  <c:v>66.088676113301801</c:v>
                </c:pt>
                <c:pt idx="17">
                  <c:v>63.063856865872999</c:v>
                </c:pt>
                <c:pt idx="18">
                  <c:v>81.393960288029504</c:v>
                </c:pt>
                <c:pt idx="19">
                  <c:v>74.277702786989394</c:v>
                </c:pt>
                <c:pt idx="20">
                  <c:v>80.877763315476997</c:v>
                </c:pt>
                <c:pt idx="21">
                  <c:v>72.934313952962697</c:v>
                </c:pt>
                <c:pt idx="22">
                  <c:v>83.081909085019007</c:v>
                </c:pt>
                <c:pt idx="23">
                  <c:v>75.836335801850595</c:v>
                </c:pt>
                <c:pt idx="24">
                  <c:v>86.025680182162503</c:v>
                </c:pt>
                <c:pt idx="25">
                  <c:v>59.033954086390402</c:v>
                </c:pt>
                <c:pt idx="26">
                  <c:v>62.523599165507498</c:v>
                </c:pt>
                <c:pt idx="27">
                  <c:v>79.399416002888501</c:v>
                </c:pt>
                <c:pt idx="28">
                  <c:v>87.715480357376094</c:v>
                </c:pt>
                <c:pt idx="29">
                  <c:v>58.817891407709297</c:v>
                </c:pt>
                <c:pt idx="30">
                  <c:v>66.898768346378503</c:v>
                </c:pt>
                <c:pt idx="31">
                  <c:v>78.246588668676793</c:v>
                </c:pt>
                <c:pt idx="32">
                  <c:v>70.658795145663007</c:v>
                </c:pt>
                <c:pt idx="33">
                  <c:v>64.382064881926496</c:v>
                </c:pt>
                <c:pt idx="34">
                  <c:v>73.957447551210507</c:v>
                </c:pt>
                <c:pt idx="35">
                  <c:v>76.830220835431405</c:v>
                </c:pt>
                <c:pt idx="36">
                  <c:v>75.780741157089693</c:v>
                </c:pt>
                <c:pt idx="37">
                  <c:v>69.268678678481606</c:v>
                </c:pt>
                <c:pt idx="38">
                  <c:v>71.978046425664004</c:v>
                </c:pt>
                <c:pt idx="39">
                  <c:v>71.388449858721998</c:v>
                </c:pt>
                <c:pt idx="40">
                  <c:v>73.972713601756297</c:v>
                </c:pt>
                <c:pt idx="41">
                  <c:v>72.606104905431806</c:v>
                </c:pt>
                <c:pt idx="42">
                  <c:v>76.137534313306006</c:v>
                </c:pt>
                <c:pt idx="43">
                  <c:v>77.151087957233401</c:v>
                </c:pt>
                <c:pt idx="44">
                  <c:v>79.877103524988698</c:v>
                </c:pt>
                <c:pt idx="45">
                  <c:v>66.477582236520902</c:v>
                </c:pt>
                <c:pt idx="46">
                  <c:v>69.818865565865806</c:v>
                </c:pt>
                <c:pt idx="47">
                  <c:v>83.515263451626396</c:v>
                </c:pt>
                <c:pt idx="48">
                  <c:v>71.589766718453305</c:v>
                </c:pt>
                <c:pt idx="49">
                  <c:v>68.307891420804395</c:v>
                </c:pt>
                <c:pt idx="50">
                  <c:v>68.408914284697602</c:v>
                </c:pt>
                <c:pt idx="51">
                  <c:v>85.4833346718858</c:v>
                </c:pt>
                <c:pt idx="52">
                  <c:v>65.448782714843404</c:v>
                </c:pt>
                <c:pt idx="53">
                  <c:v>65.711931814085801</c:v>
                </c:pt>
                <c:pt idx="54">
                  <c:v>84.824001966451505</c:v>
                </c:pt>
                <c:pt idx="55">
                  <c:v>65.933061827718006</c:v>
                </c:pt>
                <c:pt idx="56">
                  <c:v>77.090059221936002</c:v>
                </c:pt>
                <c:pt idx="57">
                  <c:v>65.333708912602802</c:v>
                </c:pt>
                <c:pt idx="58">
                  <c:v>67.855022456875403</c:v>
                </c:pt>
                <c:pt idx="59">
                  <c:v>66.741745516582995</c:v>
                </c:pt>
                <c:pt idx="60">
                  <c:v>78.6640175153385</c:v>
                </c:pt>
                <c:pt idx="61">
                  <c:v>61.714097768926898</c:v>
                </c:pt>
                <c:pt idx="62">
                  <c:v>81.815545712584196</c:v>
                </c:pt>
                <c:pt idx="63">
                  <c:v>87.478806672377203</c:v>
                </c:pt>
                <c:pt idx="64">
                  <c:v>78.059966293532895</c:v>
                </c:pt>
                <c:pt idx="65">
                  <c:v>72.519249747186393</c:v>
                </c:pt>
                <c:pt idx="66">
                  <c:v>78.795124886131902</c:v>
                </c:pt>
                <c:pt idx="67">
                  <c:v>72.405038887037193</c:v>
                </c:pt>
                <c:pt idx="68">
                  <c:v>68.646152000036295</c:v>
                </c:pt>
                <c:pt idx="69">
                  <c:v>64.570742660589303</c:v>
                </c:pt>
                <c:pt idx="70">
                  <c:v>75.608272310008005</c:v>
                </c:pt>
                <c:pt idx="71">
                  <c:v>62.418552321480099</c:v>
                </c:pt>
                <c:pt idx="72">
                  <c:v>75.271094807720203</c:v>
                </c:pt>
                <c:pt idx="73">
                  <c:v>72.731504704381194</c:v>
                </c:pt>
                <c:pt idx="74">
                  <c:v>75.797533301546693</c:v>
                </c:pt>
                <c:pt idx="75">
                  <c:v>88.343550869620103</c:v>
                </c:pt>
                <c:pt idx="76">
                  <c:v>84.906600239030993</c:v>
                </c:pt>
                <c:pt idx="77">
                  <c:v>71.662558429502198</c:v>
                </c:pt>
                <c:pt idx="78">
                  <c:v>75.036752875095004</c:v>
                </c:pt>
                <c:pt idx="79">
                  <c:v>83.923902238541899</c:v>
                </c:pt>
                <c:pt idx="80">
                  <c:v>68.432966485553294</c:v>
                </c:pt>
                <c:pt idx="81">
                  <c:v>64.445507103732595</c:v>
                </c:pt>
                <c:pt idx="82">
                  <c:v>63.811108111641801</c:v>
                </c:pt>
                <c:pt idx="83">
                  <c:v>69.899253910492106</c:v>
                </c:pt>
                <c:pt idx="84">
                  <c:v>69.867466961729306</c:v>
                </c:pt>
                <c:pt idx="85">
                  <c:v>68.959105495433306</c:v>
                </c:pt>
                <c:pt idx="86">
                  <c:v>68.0069243226108</c:v>
                </c:pt>
                <c:pt idx="87">
                  <c:v>87.5447585478382</c:v>
                </c:pt>
                <c:pt idx="88">
                  <c:v>66.863966118163205</c:v>
                </c:pt>
                <c:pt idx="89">
                  <c:v>75.073578621329105</c:v>
                </c:pt>
                <c:pt idx="90">
                  <c:v>69.760285822393996</c:v>
                </c:pt>
                <c:pt idx="91">
                  <c:v>78.987618757669097</c:v>
                </c:pt>
                <c:pt idx="92">
                  <c:v>58.031849909585503</c:v>
                </c:pt>
                <c:pt idx="93">
                  <c:v>68.7588866795911</c:v>
                </c:pt>
                <c:pt idx="94">
                  <c:v>75.7074732373313</c:v>
                </c:pt>
                <c:pt idx="95">
                  <c:v>80.763797583042205</c:v>
                </c:pt>
                <c:pt idx="96">
                  <c:v>76.635953131248897</c:v>
                </c:pt>
                <c:pt idx="97">
                  <c:v>63.8099628802034</c:v>
                </c:pt>
                <c:pt idx="98">
                  <c:v>63.678744380979303</c:v>
                </c:pt>
                <c:pt idx="99">
                  <c:v>75.976730282629106</c:v>
                </c:pt>
                <c:pt idx="100">
                  <c:v>83.917775899649698</c:v>
                </c:pt>
                <c:pt idx="101">
                  <c:v>66.846729617399106</c:v>
                </c:pt>
                <c:pt idx="102">
                  <c:v>69.083197147579895</c:v>
                </c:pt>
                <c:pt idx="103">
                  <c:v>74.552066667286695</c:v>
                </c:pt>
                <c:pt idx="104">
                  <c:v>75.305812423360095</c:v>
                </c:pt>
                <c:pt idx="105">
                  <c:v>83.303561781746296</c:v>
                </c:pt>
                <c:pt idx="106">
                  <c:v>76.627303409792006</c:v>
                </c:pt>
                <c:pt idx="107">
                  <c:v>63.031711828055201</c:v>
                </c:pt>
                <c:pt idx="108">
                  <c:v>75.832189308980801</c:v>
                </c:pt>
                <c:pt idx="109">
                  <c:v>91.268903563792804</c:v>
                </c:pt>
                <c:pt idx="110">
                  <c:v>74.239406597478094</c:v>
                </c:pt>
                <c:pt idx="111">
                  <c:v>78.807228354348496</c:v>
                </c:pt>
                <c:pt idx="112">
                  <c:v>68.2501235941359</c:v>
                </c:pt>
                <c:pt idx="113">
                  <c:v>88.398298239349103</c:v>
                </c:pt>
                <c:pt idx="114">
                  <c:v>80.370298465400793</c:v>
                </c:pt>
                <c:pt idx="115">
                  <c:v>68.024411204335806</c:v>
                </c:pt>
                <c:pt idx="116">
                  <c:v>80.407681902619203</c:v>
                </c:pt>
                <c:pt idx="117">
                  <c:v>73.5279053829899</c:v>
                </c:pt>
                <c:pt idx="118">
                  <c:v>70.697596410061294</c:v>
                </c:pt>
                <c:pt idx="119">
                  <c:v>78.953601405448495</c:v>
                </c:pt>
                <c:pt idx="120">
                  <c:v>72.441287864260303</c:v>
                </c:pt>
                <c:pt idx="121">
                  <c:v>60.163666164670602</c:v>
                </c:pt>
                <c:pt idx="122">
                  <c:v>69.0872593880339</c:v>
                </c:pt>
                <c:pt idx="123">
                  <c:v>67.7987849617938</c:v>
                </c:pt>
                <c:pt idx="124">
                  <c:v>82.993721806932598</c:v>
                </c:pt>
                <c:pt idx="125">
                  <c:v>69.367851990489299</c:v>
                </c:pt>
                <c:pt idx="126">
                  <c:v>78.844651731703195</c:v>
                </c:pt>
                <c:pt idx="127">
                  <c:v>75.394540032828303</c:v>
                </c:pt>
                <c:pt idx="128">
                  <c:v>82.221123026660806</c:v>
                </c:pt>
                <c:pt idx="129">
                  <c:v>65.3333881849112</c:v>
                </c:pt>
                <c:pt idx="130">
                  <c:v>68.318673615056099</c:v>
                </c:pt>
                <c:pt idx="131">
                  <c:v>71.247303395372597</c:v>
                </c:pt>
                <c:pt idx="132">
                  <c:v>68.108485726883202</c:v>
                </c:pt>
                <c:pt idx="133">
                  <c:v>72.415104238138994</c:v>
                </c:pt>
                <c:pt idx="134">
                  <c:v>72.920649452545604</c:v>
                </c:pt>
                <c:pt idx="135">
                  <c:v>68.813130678629093</c:v>
                </c:pt>
                <c:pt idx="136">
                  <c:v>72.200205012959302</c:v>
                </c:pt>
                <c:pt idx="137">
                  <c:v>71.161439800364107</c:v>
                </c:pt>
                <c:pt idx="138">
                  <c:v>70.765967007596203</c:v>
                </c:pt>
                <c:pt idx="139">
                  <c:v>80.273318303338698</c:v>
                </c:pt>
                <c:pt idx="140">
                  <c:v>69.985367339311395</c:v>
                </c:pt>
                <c:pt idx="141">
                  <c:v>74.614044829760005</c:v>
                </c:pt>
                <c:pt idx="142">
                  <c:v>72.626739861112299</c:v>
                </c:pt>
                <c:pt idx="143">
                  <c:v>81.179525648188005</c:v>
                </c:pt>
                <c:pt idx="144">
                  <c:v>89.041313103297696</c:v>
                </c:pt>
                <c:pt idx="145">
                  <c:v>78.691301660454897</c:v>
                </c:pt>
                <c:pt idx="146">
                  <c:v>61.2801126823842</c:v>
                </c:pt>
                <c:pt idx="147">
                  <c:v>64.854340297895106</c:v>
                </c:pt>
                <c:pt idx="148">
                  <c:v>68.0734711916176</c:v>
                </c:pt>
                <c:pt idx="149">
                  <c:v>63.896890870171298</c:v>
                </c:pt>
                <c:pt idx="150">
                  <c:v>74.564459243939197</c:v>
                </c:pt>
                <c:pt idx="151">
                  <c:v>76.639942039456798</c:v>
                </c:pt>
                <c:pt idx="152">
                  <c:v>66.778085360024605</c:v>
                </c:pt>
                <c:pt idx="153">
                  <c:v>70.733997869398806</c:v>
                </c:pt>
                <c:pt idx="154">
                  <c:v>62.362825389031102</c:v>
                </c:pt>
                <c:pt idx="155">
                  <c:v>71.814876421574098</c:v>
                </c:pt>
                <c:pt idx="156">
                  <c:v>70.037543767372398</c:v>
                </c:pt>
                <c:pt idx="157">
                  <c:v>71.090367967076503</c:v>
                </c:pt>
                <c:pt idx="158">
                  <c:v>69.135063177761197</c:v>
                </c:pt>
                <c:pt idx="159">
                  <c:v>70.016511863431404</c:v>
                </c:pt>
                <c:pt idx="160">
                  <c:v>75.431680890833903</c:v>
                </c:pt>
                <c:pt idx="161">
                  <c:v>74.951162530576994</c:v>
                </c:pt>
                <c:pt idx="162">
                  <c:v>93.313061636827697</c:v>
                </c:pt>
                <c:pt idx="163">
                  <c:v>75.046684032016302</c:v>
                </c:pt>
                <c:pt idx="164">
                  <c:v>74.514695369396705</c:v>
                </c:pt>
                <c:pt idx="165">
                  <c:v>72.345451377161098</c:v>
                </c:pt>
                <c:pt idx="166">
                  <c:v>64.2565765403222</c:v>
                </c:pt>
                <c:pt idx="167">
                  <c:v>79.993402730845801</c:v>
                </c:pt>
                <c:pt idx="168">
                  <c:v>71.858354490134303</c:v>
                </c:pt>
                <c:pt idx="169">
                  <c:v>61.795520727218999</c:v>
                </c:pt>
                <c:pt idx="170">
                  <c:v>78.8273824025907</c:v>
                </c:pt>
                <c:pt idx="171">
                  <c:v>69.471260608987606</c:v>
                </c:pt>
                <c:pt idx="172">
                  <c:v>67.699759179193705</c:v>
                </c:pt>
                <c:pt idx="173">
                  <c:v>68.051002420714696</c:v>
                </c:pt>
                <c:pt idx="174">
                  <c:v>76.959002010550705</c:v>
                </c:pt>
                <c:pt idx="175">
                  <c:v>75.005678597870201</c:v>
                </c:pt>
                <c:pt idx="176">
                  <c:v>70.081597426661503</c:v>
                </c:pt>
                <c:pt idx="177">
                  <c:v>75.221810390880904</c:v>
                </c:pt>
                <c:pt idx="178">
                  <c:v>70.793383617586599</c:v>
                </c:pt>
                <c:pt idx="179">
                  <c:v>71.911924687160194</c:v>
                </c:pt>
                <c:pt idx="180">
                  <c:v>66.369416630822101</c:v>
                </c:pt>
                <c:pt idx="181">
                  <c:v>65.859232852930006</c:v>
                </c:pt>
                <c:pt idx="182">
                  <c:v>82.945133027145999</c:v>
                </c:pt>
                <c:pt idx="183">
                  <c:v>75.878056157407102</c:v>
                </c:pt>
                <c:pt idx="184">
                  <c:v>77.592005210561993</c:v>
                </c:pt>
                <c:pt idx="185">
                  <c:v>68.077910493146106</c:v>
                </c:pt>
                <c:pt idx="186">
                  <c:v>65.896364220511998</c:v>
                </c:pt>
                <c:pt idx="187">
                  <c:v>85.827480079194899</c:v>
                </c:pt>
                <c:pt idx="188">
                  <c:v>74.175903420161703</c:v>
                </c:pt>
                <c:pt idx="189">
                  <c:v>70.301263051364103</c:v>
                </c:pt>
                <c:pt idx="190">
                  <c:v>76.749925186603605</c:v>
                </c:pt>
                <c:pt idx="191">
                  <c:v>65.682087580000498</c:v>
                </c:pt>
                <c:pt idx="192">
                  <c:v>65.147701421623594</c:v>
                </c:pt>
                <c:pt idx="193">
                  <c:v>71.395523329541305</c:v>
                </c:pt>
                <c:pt idx="194">
                  <c:v>73.768262017344597</c:v>
                </c:pt>
                <c:pt idx="195">
                  <c:v>75.296663503983098</c:v>
                </c:pt>
                <c:pt idx="196">
                  <c:v>78.711780770011998</c:v>
                </c:pt>
                <c:pt idx="197">
                  <c:v>75.394663724285394</c:v>
                </c:pt>
                <c:pt idx="198">
                  <c:v>90.393819059386502</c:v>
                </c:pt>
                <c:pt idx="199">
                  <c:v>73.982052940841101</c:v>
                </c:pt>
                <c:pt idx="200">
                  <c:v>69.918284343981298</c:v>
                </c:pt>
                <c:pt idx="201">
                  <c:v>80.330796531456599</c:v>
                </c:pt>
                <c:pt idx="202">
                  <c:v>79.9103046408203</c:v>
                </c:pt>
                <c:pt idx="203">
                  <c:v>87.416535906333905</c:v>
                </c:pt>
                <c:pt idx="204">
                  <c:v>70.035888594461696</c:v>
                </c:pt>
                <c:pt idx="205">
                  <c:v>76.163249223311496</c:v>
                </c:pt>
                <c:pt idx="206">
                  <c:v>65.1086945722396</c:v>
                </c:pt>
                <c:pt idx="207">
                  <c:v>76.706319800306204</c:v>
                </c:pt>
                <c:pt idx="208">
                  <c:v>81.176948948137195</c:v>
                </c:pt>
                <c:pt idx="209">
                  <c:v>69.748609070931707</c:v>
                </c:pt>
                <c:pt idx="210">
                  <c:v>73.591276103339695</c:v>
                </c:pt>
                <c:pt idx="211">
                  <c:v>78.676078522817804</c:v>
                </c:pt>
                <c:pt idx="212">
                  <c:v>75.213977312378006</c:v>
                </c:pt>
                <c:pt idx="213">
                  <c:v>67.902379370234001</c:v>
                </c:pt>
                <c:pt idx="214">
                  <c:v>87.680740742462802</c:v>
                </c:pt>
                <c:pt idx="215">
                  <c:v>83.222177120479799</c:v>
                </c:pt>
                <c:pt idx="216">
                  <c:v>67.403475992130197</c:v>
                </c:pt>
                <c:pt idx="217">
                  <c:v>72.805533603581907</c:v>
                </c:pt>
                <c:pt idx="218">
                  <c:v>83.391310976068397</c:v>
                </c:pt>
                <c:pt idx="219">
                  <c:v>77.680857021814603</c:v>
                </c:pt>
                <c:pt idx="220">
                  <c:v>81.466078230365994</c:v>
                </c:pt>
                <c:pt idx="221">
                  <c:v>63.656835553330303</c:v>
                </c:pt>
                <c:pt idx="222">
                  <c:v>82.195588086267307</c:v>
                </c:pt>
                <c:pt idx="223">
                  <c:v>73.694848903410303</c:v>
                </c:pt>
                <c:pt idx="224">
                  <c:v>69.084031592561502</c:v>
                </c:pt>
                <c:pt idx="225">
                  <c:v>79.585465319896997</c:v>
                </c:pt>
                <c:pt idx="226">
                  <c:v>77.014031878092098</c:v>
                </c:pt>
                <c:pt idx="227">
                  <c:v>81.843500482333795</c:v>
                </c:pt>
                <c:pt idx="228">
                  <c:v>84.501546468637699</c:v>
                </c:pt>
                <c:pt idx="229">
                  <c:v>77.808467091031105</c:v>
                </c:pt>
                <c:pt idx="230">
                  <c:v>83.465819485647401</c:v>
                </c:pt>
                <c:pt idx="231">
                  <c:v>70.389974010409802</c:v>
                </c:pt>
                <c:pt idx="232">
                  <c:v>73.751924926115706</c:v>
                </c:pt>
                <c:pt idx="233">
                  <c:v>67.867028128896095</c:v>
                </c:pt>
                <c:pt idx="234">
                  <c:v>67.459729876144905</c:v>
                </c:pt>
                <c:pt idx="235">
                  <c:v>76.326474377424105</c:v>
                </c:pt>
                <c:pt idx="236">
                  <c:v>70.305713661696998</c:v>
                </c:pt>
                <c:pt idx="237">
                  <c:v>66.359742489227799</c:v>
                </c:pt>
                <c:pt idx="238">
                  <c:v>71.581415976560706</c:v>
                </c:pt>
                <c:pt idx="239">
                  <c:v>76.793678796508303</c:v>
                </c:pt>
                <c:pt idx="240">
                  <c:v>78.544550892912696</c:v>
                </c:pt>
                <c:pt idx="241">
                  <c:v>69.251355338454005</c:v>
                </c:pt>
                <c:pt idx="242">
                  <c:v>76.622622492889803</c:v>
                </c:pt>
                <c:pt idx="243">
                  <c:v>69.401232417491201</c:v>
                </c:pt>
                <c:pt idx="244">
                  <c:v>79.797518572081998</c:v>
                </c:pt>
                <c:pt idx="245">
                  <c:v>68.002886337808206</c:v>
                </c:pt>
                <c:pt idx="246">
                  <c:v>66.550610349486405</c:v>
                </c:pt>
                <c:pt idx="247">
                  <c:v>79.612408442685094</c:v>
                </c:pt>
                <c:pt idx="248">
                  <c:v>65.648231152147702</c:v>
                </c:pt>
                <c:pt idx="249">
                  <c:v>73.239528579108693</c:v>
                </c:pt>
                <c:pt idx="250">
                  <c:v>67.380766751035793</c:v>
                </c:pt>
                <c:pt idx="251">
                  <c:v>68.080293434839803</c:v>
                </c:pt>
                <c:pt idx="252">
                  <c:v>84.784856728069101</c:v>
                </c:pt>
                <c:pt idx="253">
                  <c:v>77.943341233467805</c:v>
                </c:pt>
                <c:pt idx="254">
                  <c:v>70.5269487356654</c:v>
                </c:pt>
                <c:pt idx="255">
                  <c:v>73.867372977572501</c:v>
                </c:pt>
                <c:pt idx="256">
                  <c:v>77.875943010805102</c:v>
                </c:pt>
                <c:pt idx="257">
                  <c:v>79.131212881119694</c:v>
                </c:pt>
                <c:pt idx="258">
                  <c:v>72.684782153438405</c:v>
                </c:pt>
                <c:pt idx="259">
                  <c:v>74.128752868683407</c:v>
                </c:pt>
                <c:pt idx="260">
                  <c:v>67.575903782677898</c:v>
                </c:pt>
                <c:pt idx="261">
                  <c:v>78.519196959977805</c:v>
                </c:pt>
                <c:pt idx="262">
                  <c:v>68.526573432248497</c:v>
                </c:pt>
                <c:pt idx="263">
                  <c:v>68.903412909504993</c:v>
                </c:pt>
                <c:pt idx="264">
                  <c:v>67.918451465871399</c:v>
                </c:pt>
                <c:pt idx="265">
                  <c:v>72.794779826529705</c:v>
                </c:pt>
                <c:pt idx="266">
                  <c:v>73.243462475666803</c:v>
                </c:pt>
                <c:pt idx="267">
                  <c:v>84.382065085992295</c:v>
                </c:pt>
                <c:pt idx="268">
                  <c:v>67.549424079673202</c:v>
                </c:pt>
                <c:pt idx="269">
                  <c:v>66.674041308420598</c:v>
                </c:pt>
                <c:pt idx="270">
                  <c:v>65.324001550219194</c:v>
                </c:pt>
                <c:pt idx="271">
                  <c:v>75.876041120475605</c:v>
                </c:pt>
                <c:pt idx="272">
                  <c:v>72.785238687714099</c:v>
                </c:pt>
                <c:pt idx="273">
                  <c:v>76.091161709329995</c:v>
                </c:pt>
                <c:pt idx="274">
                  <c:v>69.881465354288295</c:v>
                </c:pt>
                <c:pt idx="275">
                  <c:v>65.103369840584904</c:v>
                </c:pt>
                <c:pt idx="276">
                  <c:v>76.901120207916193</c:v>
                </c:pt>
                <c:pt idx="277">
                  <c:v>66.231027827274801</c:v>
                </c:pt>
                <c:pt idx="278">
                  <c:v>72.557166168108196</c:v>
                </c:pt>
                <c:pt idx="279">
                  <c:v>75.166669862620296</c:v>
                </c:pt>
                <c:pt idx="280">
                  <c:v>76.161714366637298</c:v>
                </c:pt>
                <c:pt idx="281">
                  <c:v>68.097449994446194</c:v>
                </c:pt>
                <c:pt idx="282">
                  <c:v>69.391429781295599</c:v>
                </c:pt>
                <c:pt idx="283">
                  <c:v>73.0993747302863</c:v>
                </c:pt>
                <c:pt idx="284">
                  <c:v>79.687006345453398</c:v>
                </c:pt>
                <c:pt idx="285">
                  <c:v>70.788632661608602</c:v>
                </c:pt>
                <c:pt idx="286">
                  <c:v>57.5782612569324</c:v>
                </c:pt>
                <c:pt idx="287">
                  <c:v>72.5586615541783</c:v>
                </c:pt>
                <c:pt idx="288">
                  <c:v>66.579228507855305</c:v>
                </c:pt>
                <c:pt idx="289">
                  <c:v>74.369736094141501</c:v>
                </c:pt>
                <c:pt idx="290">
                  <c:v>73.482146429185804</c:v>
                </c:pt>
                <c:pt idx="291">
                  <c:v>75.9052483217952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DD8-413F-96A8-8B3B1827D1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3113088"/>
        <c:axId val="233115008"/>
      </c:scatterChart>
      <c:valAx>
        <c:axId val="2331130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3115008"/>
        <c:crosses val="autoZero"/>
        <c:crossBetween val="midCat"/>
      </c:valAx>
      <c:valAx>
        <c:axId val="233115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311308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1862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sz="2000" b="1" i="0" u="none" strike="noStrike" kern="1200" spc="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%PodSet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1862" b="0" i="0" u="none" strike="noStrike" kern="1200" spc="0" baseline="0">
              <a:solidFill>
                <a:prstClr val="black">
                  <a:lumMod val="65000"/>
                  <a:lumOff val="35000"/>
                </a:prst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1!$G$1</c:f>
              <c:strCache>
                <c:ptCount val="1"/>
                <c:pt idx="0">
                  <c:v>G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6.2508661417322836E-2"/>
                  <c:y val="-0.2565929258842644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sz="1197" b="0" i="0" u="none" strike="noStrike" kern="1200" baseline="0">
                        <a:solidFill>
                          <a:prstClr val="black">
                            <a:lumMod val="65000"/>
                            <a:lumOff val="35000"/>
                          </a:prst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1964x + 59.958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0331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sz="1197" b="0" i="0" u="none" strike="noStrike" kern="120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F$2:$F$293</c:f>
              <c:numCache>
                <c:formatCode>0.0</c:formatCode>
                <c:ptCount val="292"/>
                <c:pt idx="0">
                  <c:v>71.300731267136797</c:v>
                </c:pt>
                <c:pt idx="1">
                  <c:v>70.711269499032497</c:v>
                </c:pt>
                <c:pt idx="2">
                  <c:v>60.962154097316201</c:v>
                </c:pt>
                <c:pt idx="3">
                  <c:v>69.468514501211104</c:v>
                </c:pt>
                <c:pt idx="4">
                  <c:v>71.318227888499493</c:v>
                </c:pt>
                <c:pt idx="5">
                  <c:v>64.8072667008758</c:v>
                </c:pt>
                <c:pt idx="6">
                  <c:v>68.142592164804</c:v>
                </c:pt>
                <c:pt idx="7">
                  <c:v>73.159446593835199</c:v>
                </c:pt>
                <c:pt idx="8">
                  <c:v>58.9205124463912</c:v>
                </c:pt>
                <c:pt idx="9">
                  <c:v>69.150059479503796</c:v>
                </c:pt>
                <c:pt idx="10">
                  <c:v>78.778516307649994</c:v>
                </c:pt>
                <c:pt idx="11">
                  <c:v>75.8243986815271</c:v>
                </c:pt>
                <c:pt idx="12">
                  <c:v>65.137951879068098</c:v>
                </c:pt>
                <c:pt idx="13">
                  <c:v>72.230725806768504</c:v>
                </c:pt>
                <c:pt idx="14">
                  <c:v>68.039485314542603</c:v>
                </c:pt>
                <c:pt idx="15">
                  <c:v>61.470840059729099</c:v>
                </c:pt>
                <c:pt idx="16">
                  <c:v>69.527090977763294</c:v>
                </c:pt>
                <c:pt idx="17">
                  <c:v>78.767308476070397</c:v>
                </c:pt>
                <c:pt idx="18">
                  <c:v>64.211132779940101</c:v>
                </c:pt>
                <c:pt idx="19">
                  <c:v>71.058199736131499</c:v>
                </c:pt>
                <c:pt idx="20">
                  <c:v>66.039918793034104</c:v>
                </c:pt>
                <c:pt idx="21">
                  <c:v>60.617052749244102</c:v>
                </c:pt>
                <c:pt idx="22">
                  <c:v>69.444071419434593</c:v>
                </c:pt>
                <c:pt idx="23">
                  <c:v>63.330317399491499</c:v>
                </c:pt>
                <c:pt idx="24">
                  <c:v>72.498139622214396</c:v>
                </c:pt>
                <c:pt idx="25">
                  <c:v>52.6420729232279</c:v>
                </c:pt>
                <c:pt idx="26">
                  <c:v>63.612504277811098</c:v>
                </c:pt>
                <c:pt idx="27">
                  <c:v>67.099679059033903</c:v>
                </c:pt>
                <c:pt idx="28">
                  <c:v>71.394197198496897</c:v>
                </c:pt>
                <c:pt idx="29">
                  <c:v>64.472673766748798</c:v>
                </c:pt>
                <c:pt idx="30">
                  <c:v>72.864972824187404</c:v>
                </c:pt>
                <c:pt idx="31">
                  <c:v>69.536685121750693</c:v>
                </c:pt>
                <c:pt idx="32">
                  <c:v>62.513322436732501</c:v>
                </c:pt>
                <c:pt idx="33">
                  <c:v>77.454374258318296</c:v>
                </c:pt>
                <c:pt idx="34">
                  <c:v>77.624592182168698</c:v>
                </c:pt>
                <c:pt idx="35">
                  <c:v>64.272953281407098</c:v>
                </c:pt>
                <c:pt idx="36">
                  <c:v>61.883456071701701</c:v>
                </c:pt>
                <c:pt idx="37">
                  <c:v>71.383713968059794</c:v>
                </c:pt>
                <c:pt idx="38">
                  <c:v>74.106594466860201</c:v>
                </c:pt>
                <c:pt idx="39">
                  <c:v>72.383388084022599</c:v>
                </c:pt>
                <c:pt idx="40">
                  <c:v>70.695247855752001</c:v>
                </c:pt>
                <c:pt idx="41">
                  <c:v>74.842726781960707</c:v>
                </c:pt>
                <c:pt idx="42">
                  <c:v>70.485059206660395</c:v>
                </c:pt>
                <c:pt idx="43">
                  <c:v>61.099832549168198</c:v>
                </c:pt>
                <c:pt idx="44">
                  <c:v>68.144890575511795</c:v>
                </c:pt>
                <c:pt idx="45">
                  <c:v>76.365536855174696</c:v>
                </c:pt>
                <c:pt idx="46">
                  <c:v>63.112635668650199</c:v>
                </c:pt>
                <c:pt idx="47">
                  <c:v>63.981157104057097</c:v>
                </c:pt>
                <c:pt idx="48">
                  <c:v>75.538804805715699</c:v>
                </c:pt>
                <c:pt idx="49">
                  <c:v>69.319645030949204</c:v>
                </c:pt>
                <c:pt idx="50">
                  <c:v>77.667977044203795</c:v>
                </c:pt>
                <c:pt idx="51">
                  <c:v>68.128115465248001</c:v>
                </c:pt>
                <c:pt idx="52">
                  <c:v>64.611725199756407</c:v>
                </c:pt>
                <c:pt idx="53">
                  <c:v>69.478357037646205</c:v>
                </c:pt>
                <c:pt idx="54">
                  <c:v>77.497899168246903</c:v>
                </c:pt>
                <c:pt idx="55">
                  <c:v>57.567967169246401</c:v>
                </c:pt>
                <c:pt idx="56">
                  <c:v>84.196147416853407</c:v>
                </c:pt>
                <c:pt idx="57">
                  <c:v>69.797172880732901</c:v>
                </c:pt>
                <c:pt idx="58">
                  <c:v>61.905892234971802</c:v>
                </c:pt>
                <c:pt idx="59">
                  <c:v>73.842251255556604</c:v>
                </c:pt>
                <c:pt idx="60">
                  <c:v>69.849328802590406</c:v>
                </c:pt>
                <c:pt idx="61">
                  <c:v>60.797020707821197</c:v>
                </c:pt>
                <c:pt idx="62">
                  <c:v>66.496173677000101</c:v>
                </c:pt>
                <c:pt idx="63">
                  <c:v>66.760215146751406</c:v>
                </c:pt>
                <c:pt idx="64">
                  <c:v>71.619079921214393</c:v>
                </c:pt>
                <c:pt idx="65">
                  <c:v>58.946629180818803</c:v>
                </c:pt>
                <c:pt idx="66">
                  <c:v>77.936990609384395</c:v>
                </c:pt>
                <c:pt idx="67">
                  <c:v>76.512982580738694</c:v>
                </c:pt>
                <c:pt idx="68">
                  <c:v>75.720122373105596</c:v>
                </c:pt>
                <c:pt idx="69">
                  <c:v>74.710380957586906</c:v>
                </c:pt>
                <c:pt idx="70">
                  <c:v>62.809556550466503</c:v>
                </c:pt>
                <c:pt idx="71">
                  <c:v>50.486075483552199</c:v>
                </c:pt>
                <c:pt idx="72">
                  <c:v>75.002864334716605</c:v>
                </c:pt>
                <c:pt idx="73">
                  <c:v>65.848884741594503</c:v>
                </c:pt>
                <c:pt idx="74">
                  <c:v>75.874089414018101</c:v>
                </c:pt>
                <c:pt idx="75">
                  <c:v>72.056188184268294</c:v>
                </c:pt>
                <c:pt idx="76">
                  <c:v>77.6903973388699</c:v>
                </c:pt>
                <c:pt idx="77">
                  <c:v>81.192585121670405</c:v>
                </c:pt>
                <c:pt idx="78">
                  <c:v>59.847197821383403</c:v>
                </c:pt>
                <c:pt idx="79">
                  <c:v>65.934375502883398</c:v>
                </c:pt>
                <c:pt idx="80">
                  <c:v>78.146493269225203</c:v>
                </c:pt>
                <c:pt idx="81">
                  <c:v>72.246914951162097</c:v>
                </c:pt>
                <c:pt idx="82">
                  <c:v>56.080588984544399</c:v>
                </c:pt>
                <c:pt idx="83">
                  <c:v>61.738049185413097</c:v>
                </c:pt>
                <c:pt idx="84">
                  <c:v>67.418415037250995</c:v>
                </c:pt>
                <c:pt idx="85">
                  <c:v>62.966387835592599</c:v>
                </c:pt>
                <c:pt idx="86">
                  <c:v>62.001491223075902</c:v>
                </c:pt>
                <c:pt idx="87">
                  <c:v>61.450495133735501</c:v>
                </c:pt>
                <c:pt idx="88">
                  <c:v>48.073107299119798</c:v>
                </c:pt>
                <c:pt idx="89">
                  <c:v>71.738596852149996</c:v>
                </c:pt>
                <c:pt idx="90">
                  <c:v>71.333561626299598</c:v>
                </c:pt>
                <c:pt idx="91">
                  <c:v>80.581719823825694</c:v>
                </c:pt>
                <c:pt idx="92">
                  <c:v>65.475201686620395</c:v>
                </c:pt>
                <c:pt idx="93">
                  <c:v>71.017381670370398</c:v>
                </c:pt>
                <c:pt idx="94">
                  <c:v>64.780736247645905</c:v>
                </c:pt>
                <c:pt idx="95">
                  <c:v>73.303993574060897</c:v>
                </c:pt>
                <c:pt idx="96">
                  <c:v>73.703950991001804</c:v>
                </c:pt>
                <c:pt idx="97">
                  <c:v>65.898209335394199</c:v>
                </c:pt>
                <c:pt idx="98">
                  <c:v>68.940752360667304</c:v>
                </c:pt>
                <c:pt idx="99">
                  <c:v>56.728149289229997</c:v>
                </c:pt>
                <c:pt idx="100">
                  <c:v>67.698098835960195</c:v>
                </c:pt>
                <c:pt idx="101">
                  <c:v>61.376159200846701</c:v>
                </c:pt>
                <c:pt idx="102">
                  <c:v>72.109366474431596</c:v>
                </c:pt>
                <c:pt idx="103">
                  <c:v>64.8821260893572</c:v>
                </c:pt>
                <c:pt idx="104">
                  <c:v>73.644453317639602</c:v>
                </c:pt>
                <c:pt idx="105">
                  <c:v>67.961089122779995</c:v>
                </c:pt>
                <c:pt idx="106">
                  <c:v>62.302666464496099</c:v>
                </c:pt>
                <c:pt idx="107">
                  <c:v>69.338314085694194</c:v>
                </c:pt>
                <c:pt idx="108">
                  <c:v>74.847470061241594</c:v>
                </c:pt>
                <c:pt idx="109">
                  <c:v>73.574498349843296</c:v>
                </c:pt>
                <c:pt idx="110">
                  <c:v>72.783681528968899</c:v>
                </c:pt>
                <c:pt idx="111">
                  <c:v>70.934344133594706</c:v>
                </c:pt>
                <c:pt idx="112">
                  <c:v>68.008210191598394</c:v>
                </c:pt>
                <c:pt idx="113">
                  <c:v>66.6510147725987</c:v>
                </c:pt>
                <c:pt idx="114">
                  <c:v>80.485605536570006</c:v>
                </c:pt>
                <c:pt idx="115">
                  <c:v>66.349996725452002</c:v>
                </c:pt>
                <c:pt idx="116">
                  <c:v>76.734454770919896</c:v>
                </c:pt>
                <c:pt idx="117">
                  <c:v>66.788626283069206</c:v>
                </c:pt>
                <c:pt idx="118">
                  <c:v>77.932758062801497</c:v>
                </c:pt>
                <c:pt idx="119">
                  <c:v>64.596006061115006</c:v>
                </c:pt>
                <c:pt idx="120">
                  <c:v>59.952894011115802</c:v>
                </c:pt>
                <c:pt idx="121">
                  <c:v>63.081033585783103</c:v>
                </c:pt>
                <c:pt idx="122">
                  <c:v>70.881872177160105</c:v>
                </c:pt>
                <c:pt idx="123">
                  <c:v>67.090488505876806</c:v>
                </c:pt>
                <c:pt idx="124">
                  <c:v>79.054879177339302</c:v>
                </c:pt>
                <c:pt idx="125">
                  <c:v>69.539129855132003</c:v>
                </c:pt>
                <c:pt idx="126">
                  <c:v>76.284228576983494</c:v>
                </c:pt>
                <c:pt idx="127">
                  <c:v>80.662070767293102</c:v>
                </c:pt>
                <c:pt idx="128">
                  <c:v>70.016447840561099</c:v>
                </c:pt>
                <c:pt idx="129">
                  <c:v>70.746460773873906</c:v>
                </c:pt>
                <c:pt idx="130">
                  <c:v>65.767660054595098</c:v>
                </c:pt>
                <c:pt idx="131">
                  <c:v>70.379409073920698</c:v>
                </c:pt>
                <c:pt idx="132">
                  <c:v>65.004390987104401</c:v>
                </c:pt>
                <c:pt idx="133">
                  <c:v>78.366009950116805</c:v>
                </c:pt>
                <c:pt idx="134">
                  <c:v>66.950388859957499</c:v>
                </c:pt>
                <c:pt idx="135">
                  <c:v>54.480947091440399</c:v>
                </c:pt>
                <c:pt idx="136">
                  <c:v>58.364688756314301</c:v>
                </c:pt>
                <c:pt idx="137">
                  <c:v>66.607076358520303</c:v>
                </c:pt>
                <c:pt idx="138">
                  <c:v>63.219043249025503</c:v>
                </c:pt>
                <c:pt idx="139">
                  <c:v>70.685289772836995</c:v>
                </c:pt>
                <c:pt idx="140">
                  <c:v>70.214534083841599</c:v>
                </c:pt>
                <c:pt idx="141">
                  <c:v>59.172732121238298</c:v>
                </c:pt>
                <c:pt idx="142">
                  <c:v>69.704732410950101</c:v>
                </c:pt>
                <c:pt idx="143">
                  <c:v>71.802191099526993</c:v>
                </c:pt>
                <c:pt idx="144">
                  <c:v>79.241521853882105</c:v>
                </c:pt>
                <c:pt idx="145">
                  <c:v>55.247452822850697</c:v>
                </c:pt>
                <c:pt idx="146">
                  <c:v>65.678381644856699</c:v>
                </c:pt>
                <c:pt idx="147">
                  <c:v>67.577578892678204</c:v>
                </c:pt>
                <c:pt idx="148">
                  <c:v>71.525539661798405</c:v>
                </c:pt>
                <c:pt idx="149">
                  <c:v>67.543254546988706</c:v>
                </c:pt>
                <c:pt idx="150">
                  <c:v>77.665734613480296</c:v>
                </c:pt>
                <c:pt idx="151">
                  <c:v>74.172445177860098</c:v>
                </c:pt>
                <c:pt idx="152">
                  <c:v>64.282044115364002</c:v>
                </c:pt>
                <c:pt idx="153">
                  <c:v>60.871200781575403</c:v>
                </c:pt>
                <c:pt idx="154">
                  <c:v>71.014907949266401</c:v>
                </c:pt>
                <c:pt idx="155">
                  <c:v>66.331423370295596</c:v>
                </c:pt>
                <c:pt idx="156">
                  <c:v>60.1612372780437</c:v>
                </c:pt>
                <c:pt idx="157">
                  <c:v>82.214963596786404</c:v>
                </c:pt>
                <c:pt idx="158">
                  <c:v>60.906536750555503</c:v>
                </c:pt>
                <c:pt idx="159">
                  <c:v>72.847378903226002</c:v>
                </c:pt>
                <c:pt idx="160">
                  <c:v>59.398069877625304</c:v>
                </c:pt>
                <c:pt idx="161">
                  <c:v>76.414007636310899</c:v>
                </c:pt>
                <c:pt idx="162">
                  <c:v>69.013654462396403</c:v>
                </c:pt>
                <c:pt idx="163">
                  <c:v>65.697922050606394</c:v>
                </c:pt>
                <c:pt idx="164">
                  <c:v>77.551099612795596</c:v>
                </c:pt>
                <c:pt idx="165">
                  <c:v>65.086065190580499</c:v>
                </c:pt>
                <c:pt idx="166">
                  <c:v>66.010105918482694</c:v>
                </c:pt>
                <c:pt idx="167">
                  <c:v>68.008135578725003</c:v>
                </c:pt>
                <c:pt idx="168">
                  <c:v>70.659231177725502</c:v>
                </c:pt>
                <c:pt idx="169">
                  <c:v>69.922251302574907</c:v>
                </c:pt>
                <c:pt idx="170">
                  <c:v>79.038996139687896</c:v>
                </c:pt>
                <c:pt idx="171">
                  <c:v>79.343479210114893</c:v>
                </c:pt>
                <c:pt idx="172">
                  <c:v>64.802854088918707</c:v>
                </c:pt>
                <c:pt idx="173">
                  <c:v>70.619411811674595</c:v>
                </c:pt>
                <c:pt idx="174">
                  <c:v>68.408410644303103</c:v>
                </c:pt>
                <c:pt idx="175">
                  <c:v>76.908951841466504</c:v>
                </c:pt>
                <c:pt idx="176">
                  <c:v>75.784916565014001</c:v>
                </c:pt>
                <c:pt idx="177">
                  <c:v>78.208397515713003</c:v>
                </c:pt>
                <c:pt idx="178">
                  <c:v>72.526228187589297</c:v>
                </c:pt>
                <c:pt idx="179">
                  <c:v>58.756488114472297</c:v>
                </c:pt>
                <c:pt idx="180">
                  <c:v>71.0147549870604</c:v>
                </c:pt>
                <c:pt idx="181">
                  <c:v>63.406547743248801</c:v>
                </c:pt>
                <c:pt idx="182">
                  <c:v>70.5990881639581</c:v>
                </c:pt>
                <c:pt idx="183">
                  <c:v>74.710908567146305</c:v>
                </c:pt>
                <c:pt idx="184">
                  <c:v>60.0582927900127</c:v>
                </c:pt>
                <c:pt idx="185">
                  <c:v>70.411055632225001</c:v>
                </c:pt>
                <c:pt idx="186">
                  <c:v>65.421647229045703</c:v>
                </c:pt>
                <c:pt idx="187">
                  <c:v>59.3293630537609</c:v>
                </c:pt>
                <c:pt idx="188">
                  <c:v>79.390636789328596</c:v>
                </c:pt>
                <c:pt idx="189">
                  <c:v>66.665281608388597</c:v>
                </c:pt>
                <c:pt idx="190">
                  <c:v>75.647445943684801</c:v>
                </c:pt>
                <c:pt idx="191">
                  <c:v>68.663271367554202</c:v>
                </c:pt>
                <c:pt idx="192">
                  <c:v>63.704145891002597</c:v>
                </c:pt>
                <c:pt idx="193">
                  <c:v>68.235172903163601</c:v>
                </c:pt>
                <c:pt idx="194">
                  <c:v>73.944124580014702</c:v>
                </c:pt>
                <c:pt idx="195">
                  <c:v>70.561617694046603</c:v>
                </c:pt>
                <c:pt idx="196">
                  <c:v>64.647603885245502</c:v>
                </c:pt>
                <c:pt idx="197">
                  <c:v>64.619053515394</c:v>
                </c:pt>
                <c:pt idx="198">
                  <c:v>72.7086788825886</c:v>
                </c:pt>
                <c:pt idx="199">
                  <c:v>65.268121810927695</c:v>
                </c:pt>
                <c:pt idx="200">
                  <c:v>68.648523544971894</c:v>
                </c:pt>
                <c:pt idx="201">
                  <c:v>70.161102219352301</c:v>
                </c:pt>
                <c:pt idx="202">
                  <c:v>72.283640125408795</c:v>
                </c:pt>
                <c:pt idx="203">
                  <c:v>71.119922081622207</c:v>
                </c:pt>
                <c:pt idx="204">
                  <c:v>66.907570231793997</c:v>
                </c:pt>
                <c:pt idx="205">
                  <c:v>60.908928136487802</c:v>
                </c:pt>
                <c:pt idx="206">
                  <c:v>67.516317769420198</c:v>
                </c:pt>
                <c:pt idx="207">
                  <c:v>64.907586176110797</c:v>
                </c:pt>
                <c:pt idx="208">
                  <c:v>77.744403664832106</c:v>
                </c:pt>
                <c:pt idx="209">
                  <c:v>74.234701059833199</c:v>
                </c:pt>
                <c:pt idx="210">
                  <c:v>69.419067563945703</c:v>
                </c:pt>
                <c:pt idx="211">
                  <c:v>76.9602153658182</c:v>
                </c:pt>
                <c:pt idx="212">
                  <c:v>69.475137681804597</c:v>
                </c:pt>
                <c:pt idx="213">
                  <c:v>69.137062889969101</c:v>
                </c:pt>
                <c:pt idx="214">
                  <c:v>73.390199605678504</c:v>
                </c:pt>
                <c:pt idx="215">
                  <c:v>67.074841488789104</c:v>
                </c:pt>
                <c:pt idx="216">
                  <c:v>66.347524269893199</c:v>
                </c:pt>
                <c:pt idx="217">
                  <c:v>64.752129133512398</c:v>
                </c:pt>
                <c:pt idx="218">
                  <c:v>61.563327902505598</c:v>
                </c:pt>
                <c:pt idx="219">
                  <c:v>72.671678683230198</c:v>
                </c:pt>
                <c:pt idx="220">
                  <c:v>65.116906524539502</c:v>
                </c:pt>
                <c:pt idx="221">
                  <c:v>54.811429991174101</c:v>
                </c:pt>
                <c:pt idx="222">
                  <c:v>80.911018335305997</c:v>
                </c:pt>
                <c:pt idx="223">
                  <c:v>68.192454860003295</c:v>
                </c:pt>
                <c:pt idx="224">
                  <c:v>72.429331581054697</c:v>
                </c:pt>
                <c:pt idx="225">
                  <c:v>64.007098243894504</c:v>
                </c:pt>
                <c:pt idx="226">
                  <c:v>61.247555756472202</c:v>
                </c:pt>
                <c:pt idx="227">
                  <c:v>76.413214167619202</c:v>
                </c:pt>
                <c:pt idx="228">
                  <c:v>77.869558340054297</c:v>
                </c:pt>
                <c:pt idx="229">
                  <c:v>64.209267964349905</c:v>
                </c:pt>
                <c:pt idx="230">
                  <c:v>66.229843987848398</c:v>
                </c:pt>
                <c:pt idx="231">
                  <c:v>65.055340564210098</c:v>
                </c:pt>
                <c:pt idx="232">
                  <c:v>70.3484959421437</c:v>
                </c:pt>
                <c:pt idx="233">
                  <c:v>66.346269479923507</c:v>
                </c:pt>
                <c:pt idx="234">
                  <c:v>67.039526396692196</c:v>
                </c:pt>
                <c:pt idx="235">
                  <c:v>54.0789808578402</c:v>
                </c:pt>
                <c:pt idx="236">
                  <c:v>71.717786243490707</c:v>
                </c:pt>
                <c:pt idx="237">
                  <c:v>65.708620748840104</c:v>
                </c:pt>
                <c:pt idx="238">
                  <c:v>67.284590662110404</c:v>
                </c:pt>
                <c:pt idx="239">
                  <c:v>60.0440103931452</c:v>
                </c:pt>
                <c:pt idx="240">
                  <c:v>72.288898179407397</c:v>
                </c:pt>
                <c:pt idx="241">
                  <c:v>69.681448441046001</c:v>
                </c:pt>
                <c:pt idx="242">
                  <c:v>66.200992748101996</c:v>
                </c:pt>
                <c:pt idx="243">
                  <c:v>71.478009404089505</c:v>
                </c:pt>
                <c:pt idx="244">
                  <c:v>79.512211708894299</c:v>
                </c:pt>
                <c:pt idx="245">
                  <c:v>75.873366936951598</c:v>
                </c:pt>
                <c:pt idx="246">
                  <c:v>74.446030393040601</c:v>
                </c:pt>
                <c:pt idx="247">
                  <c:v>59.2038260374323</c:v>
                </c:pt>
                <c:pt idx="248">
                  <c:v>62.849902113950101</c:v>
                </c:pt>
                <c:pt idx="249">
                  <c:v>71.012181806561301</c:v>
                </c:pt>
                <c:pt idx="250">
                  <c:v>57.439725759164297</c:v>
                </c:pt>
                <c:pt idx="251">
                  <c:v>67.719299067780497</c:v>
                </c:pt>
                <c:pt idx="252">
                  <c:v>71.723073295660697</c:v>
                </c:pt>
                <c:pt idx="253">
                  <c:v>75.882002095922104</c:v>
                </c:pt>
                <c:pt idx="254">
                  <c:v>67.776973188807204</c:v>
                </c:pt>
                <c:pt idx="255">
                  <c:v>65.030315764528794</c:v>
                </c:pt>
                <c:pt idx="256">
                  <c:v>74.768546327664794</c:v>
                </c:pt>
                <c:pt idx="257">
                  <c:v>74.094378622787403</c:v>
                </c:pt>
                <c:pt idx="258">
                  <c:v>80.0344814864347</c:v>
                </c:pt>
                <c:pt idx="259">
                  <c:v>67.265877857218399</c:v>
                </c:pt>
                <c:pt idx="260">
                  <c:v>66.061157895294897</c:v>
                </c:pt>
                <c:pt idx="261">
                  <c:v>61.889490557765498</c:v>
                </c:pt>
                <c:pt idx="262">
                  <c:v>70.790728710337007</c:v>
                </c:pt>
                <c:pt idx="263">
                  <c:v>65.408935207874194</c:v>
                </c:pt>
                <c:pt idx="264">
                  <c:v>72.545583523763696</c:v>
                </c:pt>
                <c:pt idx="265">
                  <c:v>74.134082727454199</c:v>
                </c:pt>
                <c:pt idx="266">
                  <c:v>72.617048727245802</c:v>
                </c:pt>
                <c:pt idx="267">
                  <c:v>59.784741461280298</c:v>
                </c:pt>
                <c:pt idx="268">
                  <c:v>70.146322983050894</c:v>
                </c:pt>
                <c:pt idx="269">
                  <c:v>62.578946427615001</c:v>
                </c:pt>
                <c:pt idx="270">
                  <c:v>77.942626866783101</c:v>
                </c:pt>
                <c:pt idx="271">
                  <c:v>63.019292050171103</c:v>
                </c:pt>
                <c:pt idx="272">
                  <c:v>65.694122229682506</c:v>
                </c:pt>
                <c:pt idx="273">
                  <c:v>67.107174375173102</c:v>
                </c:pt>
                <c:pt idx="274">
                  <c:v>75.843494716541898</c:v>
                </c:pt>
                <c:pt idx="275">
                  <c:v>58.139649634734504</c:v>
                </c:pt>
                <c:pt idx="276">
                  <c:v>63.572958686777199</c:v>
                </c:pt>
                <c:pt idx="277">
                  <c:v>67.057377100418606</c:v>
                </c:pt>
                <c:pt idx="278">
                  <c:v>67.798372297913701</c:v>
                </c:pt>
                <c:pt idx="279">
                  <c:v>67.704223865615603</c:v>
                </c:pt>
                <c:pt idx="280">
                  <c:v>69.743414191281502</c:v>
                </c:pt>
                <c:pt idx="281">
                  <c:v>77.156795942194194</c:v>
                </c:pt>
                <c:pt idx="282">
                  <c:v>73.478968696788598</c:v>
                </c:pt>
                <c:pt idx="283">
                  <c:v>65.0669486355647</c:v>
                </c:pt>
                <c:pt idx="284">
                  <c:v>63.871947064994799</c:v>
                </c:pt>
                <c:pt idx="285">
                  <c:v>69.456971602438998</c:v>
                </c:pt>
                <c:pt idx="286">
                  <c:v>65.310986745828799</c:v>
                </c:pt>
                <c:pt idx="287">
                  <c:v>69.6224276848301</c:v>
                </c:pt>
                <c:pt idx="288">
                  <c:v>66.387802099306199</c:v>
                </c:pt>
                <c:pt idx="289">
                  <c:v>70.760454470432506</c:v>
                </c:pt>
                <c:pt idx="290">
                  <c:v>74.799125527654994</c:v>
                </c:pt>
                <c:pt idx="291">
                  <c:v>72.028546381205501</c:v>
                </c:pt>
              </c:numCache>
            </c:numRef>
          </c:xVal>
          <c:yVal>
            <c:numRef>
              <c:f>Sheet1!$G$2:$G$293</c:f>
              <c:numCache>
                <c:formatCode>0.0</c:formatCode>
                <c:ptCount val="292"/>
                <c:pt idx="0">
                  <c:v>75.175185865463803</c:v>
                </c:pt>
                <c:pt idx="1">
                  <c:v>77.280762251155494</c:v>
                </c:pt>
                <c:pt idx="2">
                  <c:v>66.236922542963995</c:v>
                </c:pt>
                <c:pt idx="3">
                  <c:v>76.749217605516506</c:v>
                </c:pt>
                <c:pt idx="4">
                  <c:v>72.297496060432806</c:v>
                </c:pt>
                <c:pt idx="5">
                  <c:v>78.097124422005393</c:v>
                </c:pt>
                <c:pt idx="6">
                  <c:v>66.896393641304996</c:v>
                </c:pt>
                <c:pt idx="7">
                  <c:v>79.481449996611303</c:v>
                </c:pt>
                <c:pt idx="8">
                  <c:v>73.631875156809699</c:v>
                </c:pt>
                <c:pt idx="9">
                  <c:v>87.445739811342307</c:v>
                </c:pt>
                <c:pt idx="10">
                  <c:v>75.689039109647297</c:v>
                </c:pt>
                <c:pt idx="11">
                  <c:v>79.140903014594997</c:v>
                </c:pt>
                <c:pt idx="12">
                  <c:v>85.720186678772905</c:v>
                </c:pt>
                <c:pt idx="13">
                  <c:v>75.974709074757698</c:v>
                </c:pt>
                <c:pt idx="14">
                  <c:v>62.257033455099602</c:v>
                </c:pt>
                <c:pt idx="15">
                  <c:v>74.873685966021796</c:v>
                </c:pt>
                <c:pt idx="16">
                  <c:v>66.088676113301801</c:v>
                </c:pt>
                <c:pt idx="17">
                  <c:v>63.063856865872999</c:v>
                </c:pt>
                <c:pt idx="18">
                  <c:v>81.393960288029504</c:v>
                </c:pt>
                <c:pt idx="19">
                  <c:v>74.277702786989394</c:v>
                </c:pt>
                <c:pt idx="20">
                  <c:v>80.877763315476997</c:v>
                </c:pt>
                <c:pt idx="21">
                  <c:v>72.934313952962697</c:v>
                </c:pt>
                <c:pt idx="22">
                  <c:v>83.081909085019007</c:v>
                </c:pt>
                <c:pt idx="23">
                  <c:v>75.836335801850595</c:v>
                </c:pt>
                <c:pt idx="24">
                  <c:v>86.025680182162503</c:v>
                </c:pt>
                <c:pt idx="25">
                  <c:v>59.033954086390402</c:v>
                </c:pt>
                <c:pt idx="26">
                  <c:v>62.523599165507498</c:v>
                </c:pt>
                <c:pt idx="27">
                  <c:v>79.399416002888501</c:v>
                </c:pt>
                <c:pt idx="28">
                  <c:v>87.715480357376094</c:v>
                </c:pt>
                <c:pt idx="29">
                  <c:v>58.817891407709297</c:v>
                </c:pt>
                <c:pt idx="30">
                  <c:v>66.898768346378503</c:v>
                </c:pt>
                <c:pt idx="31">
                  <c:v>78.246588668676793</c:v>
                </c:pt>
                <c:pt idx="32">
                  <c:v>70.658795145663007</c:v>
                </c:pt>
                <c:pt idx="33">
                  <c:v>64.382064881926496</c:v>
                </c:pt>
                <c:pt idx="34">
                  <c:v>73.957447551210507</c:v>
                </c:pt>
                <c:pt idx="35">
                  <c:v>76.830220835431405</c:v>
                </c:pt>
                <c:pt idx="36">
                  <c:v>75.780741157089693</c:v>
                </c:pt>
                <c:pt idx="37">
                  <c:v>69.268678678481606</c:v>
                </c:pt>
                <c:pt idx="38">
                  <c:v>71.978046425664004</c:v>
                </c:pt>
                <c:pt idx="39">
                  <c:v>71.388449858721998</c:v>
                </c:pt>
                <c:pt idx="40">
                  <c:v>73.972713601756297</c:v>
                </c:pt>
                <c:pt idx="41">
                  <c:v>72.606104905431806</c:v>
                </c:pt>
                <c:pt idx="42">
                  <c:v>76.137534313306006</c:v>
                </c:pt>
                <c:pt idx="43">
                  <c:v>77.151087957233401</c:v>
                </c:pt>
                <c:pt idx="44">
                  <c:v>79.877103524988698</c:v>
                </c:pt>
                <c:pt idx="45">
                  <c:v>66.477582236520902</c:v>
                </c:pt>
                <c:pt idx="46">
                  <c:v>69.818865565865806</c:v>
                </c:pt>
                <c:pt idx="47">
                  <c:v>83.515263451626396</c:v>
                </c:pt>
                <c:pt idx="48">
                  <c:v>71.589766718453305</c:v>
                </c:pt>
                <c:pt idx="49">
                  <c:v>68.307891420804395</c:v>
                </c:pt>
                <c:pt idx="50">
                  <c:v>68.408914284697602</c:v>
                </c:pt>
                <c:pt idx="51">
                  <c:v>85.4833346718858</c:v>
                </c:pt>
                <c:pt idx="52">
                  <c:v>65.448782714843404</c:v>
                </c:pt>
                <c:pt idx="53">
                  <c:v>65.711931814085801</c:v>
                </c:pt>
                <c:pt idx="54">
                  <c:v>84.824001966451505</c:v>
                </c:pt>
                <c:pt idx="55">
                  <c:v>65.933061827718006</c:v>
                </c:pt>
                <c:pt idx="56">
                  <c:v>77.090059221936002</c:v>
                </c:pt>
                <c:pt idx="57">
                  <c:v>65.333708912602802</c:v>
                </c:pt>
                <c:pt idx="58">
                  <c:v>67.855022456875403</c:v>
                </c:pt>
                <c:pt idx="59">
                  <c:v>66.741745516582995</c:v>
                </c:pt>
                <c:pt idx="60">
                  <c:v>78.6640175153385</c:v>
                </c:pt>
                <c:pt idx="61">
                  <c:v>61.714097768926898</c:v>
                </c:pt>
                <c:pt idx="62">
                  <c:v>81.815545712584196</c:v>
                </c:pt>
                <c:pt idx="63">
                  <c:v>87.478806672377203</c:v>
                </c:pt>
                <c:pt idx="64">
                  <c:v>78.059966293532895</c:v>
                </c:pt>
                <c:pt idx="65">
                  <c:v>72.519249747186393</c:v>
                </c:pt>
                <c:pt idx="66">
                  <c:v>78.795124886131902</c:v>
                </c:pt>
                <c:pt idx="67">
                  <c:v>72.405038887037193</c:v>
                </c:pt>
                <c:pt idx="68">
                  <c:v>68.646152000036295</c:v>
                </c:pt>
                <c:pt idx="69">
                  <c:v>64.570742660589303</c:v>
                </c:pt>
                <c:pt idx="70">
                  <c:v>75.608272310008005</c:v>
                </c:pt>
                <c:pt idx="71">
                  <c:v>62.418552321480099</c:v>
                </c:pt>
                <c:pt idx="72">
                  <c:v>75.271094807720203</c:v>
                </c:pt>
                <c:pt idx="73">
                  <c:v>72.731504704381194</c:v>
                </c:pt>
                <c:pt idx="74">
                  <c:v>75.797533301546693</c:v>
                </c:pt>
                <c:pt idx="75">
                  <c:v>88.343550869620103</c:v>
                </c:pt>
                <c:pt idx="76">
                  <c:v>84.906600239030993</c:v>
                </c:pt>
                <c:pt idx="77">
                  <c:v>71.662558429502198</c:v>
                </c:pt>
                <c:pt idx="78">
                  <c:v>75.036752875095004</c:v>
                </c:pt>
                <c:pt idx="79">
                  <c:v>83.923902238541899</c:v>
                </c:pt>
                <c:pt idx="80">
                  <c:v>68.432966485553294</c:v>
                </c:pt>
                <c:pt idx="81">
                  <c:v>64.445507103732595</c:v>
                </c:pt>
                <c:pt idx="82">
                  <c:v>63.811108111641801</c:v>
                </c:pt>
                <c:pt idx="83">
                  <c:v>69.899253910492106</c:v>
                </c:pt>
                <c:pt idx="84">
                  <c:v>69.867466961729306</c:v>
                </c:pt>
                <c:pt idx="85">
                  <c:v>68.959105495433306</c:v>
                </c:pt>
                <c:pt idx="86">
                  <c:v>68.0069243226108</c:v>
                </c:pt>
                <c:pt idx="87">
                  <c:v>87.5447585478382</c:v>
                </c:pt>
                <c:pt idx="88">
                  <c:v>66.863966118163205</c:v>
                </c:pt>
                <c:pt idx="89">
                  <c:v>75.073578621329105</c:v>
                </c:pt>
                <c:pt idx="90">
                  <c:v>69.760285822393996</c:v>
                </c:pt>
                <c:pt idx="91">
                  <c:v>78.987618757669097</c:v>
                </c:pt>
                <c:pt idx="92">
                  <c:v>58.031849909585503</c:v>
                </c:pt>
                <c:pt idx="93">
                  <c:v>68.7588866795911</c:v>
                </c:pt>
                <c:pt idx="94">
                  <c:v>75.7074732373313</c:v>
                </c:pt>
                <c:pt idx="95">
                  <c:v>80.763797583042205</c:v>
                </c:pt>
                <c:pt idx="96">
                  <c:v>76.635953131248897</c:v>
                </c:pt>
                <c:pt idx="97">
                  <c:v>63.8099628802034</c:v>
                </c:pt>
                <c:pt idx="98">
                  <c:v>63.678744380979303</c:v>
                </c:pt>
                <c:pt idx="99">
                  <c:v>75.976730282629106</c:v>
                </c:pt>
                <c:pt idx="100">
                  <c:v>83.917775899649698</c:v>
                </c:pt>
                <c:pt idx="101">
                  <c:v>66.846729617399106</c:v>
                </c:pt>
                <c:pt idx="102">
                  <c:v>69.083197147579895</c:v>
                </c:pt>
                <c:pt idx="103">
                  <c:v>74.552066667286695</c:v>
                </c:pt>
                <c:pt idx="104">
                  <c:v>75.305812423360095</c:v>
                </c:pt>
                <c:pt idx="105">
                  <c:v>83.303561781746296</c:v>
                </c:pt>
                <c:pt idx="106">
                  <c:v>76.627303409792006</c:v>
                </c:pt>
                <c:pt idx="107">
                  <c:v>63.031711828055201</c:v>
                </c:pt>
                <c:pt idx="108">
                  <c:v>75.832189308980801</c:v>
                </c:pt>
                <c:pt idx="109">
                  <c:v>91.268903563792804</c:v>
                </c:pt>
                <c:pt idx="110">
                  <c:v>74.239406597478094</c:v>
                </c:pt>
                <c:pt idx="111">
                  <c:v>78.807228354348496</c:v>
                </c:pt>
                <c:pt idx="112">
                  <c:v>68.2501235941359</c:v>
                </c:pt>
                <c:pt idx="113">
                  <c:v>88.398298239349103</c:v>
                </c:pt>
                <c:pt idx="114">
                  <c:v>80.370298465400793</c:v>
                </c:pt>
                <c:pt idx="115">
                  <c:v>68.024411204335806</c:v>
                </c:pt>
                <c:pt idx="116">
                  <c:v>80.407681902619203</c:v>
                </c:pt>
                <c:pt idx="117">
                  <c:v>73.5279053829899</c:v>
                </c:pt>
                <c:pt idx="118">
                  <c:v>70.697596410061294</c:v>
                </c:pt>
                <c:pt idx="119">
                  <c:v>78.953601405448495</c:v>
                </c:pt>
                <c:pt idx="120">
                  <c:v>72.441287864260303</c:v>
                </c:pt>
                <c:pt idx="121">
                  <c:v>60.163666164670602</c:v>
                </c:pt>
                <c:pt idx="122">
                  <c:v>69.0872593880339</c:v>
                </c:pt>
                <c:pt idx="123">
                  <c:v>67.7987849617938</c:v>
                </c:pt>
                <c:pt idx="124">
                  <c:v>82.993721806932598</c:v>
                </c:pt>
                <c:pt idx="125">
                  <c:v>69.367851990489299</c:v>
                </c:pt>
                <c:pt idx="126">
                  <c:v>78.844651731703195</c:v>
                </c:pt>
                <c:pt idx="127">
                  <c:v>75.394540032828303</c:v>
                </c:pt>
                <c:pt idx="128">
                  <c:v>82.221123026660806</c:v>
                </c:pt>
                <c:pt idx="129">
                  <c:v>65.3333881849112</c:v>
                </c:pt>
                <c:pt idx="130">
                  <c:v>68.318673615056099</c:v>
                </c:pt>
                <c:pt idx="131">
                  <c:v>71.247303395372597</c:v>
                </c:pt>
                <c:pt idx="132">
                  <c:v>68.108485726883202</c:v>
                </c:pt>
                <c:pt idx="133">
                  <c:v>72.415104238138994</c:v>
                </c:pt>
                <c:pt idx="134">
                  <c:v>72.920649452545604</c:v>
                </c:pt>
                <c:pt idx="135">
                  <c:v>68.813130678629093</c:v>
                </c:pt>
                <c:pt idx="136">
                  <c:v>72.200205012959302</c:v>
                </c:pt>
                <c:pt idx="137">
                  <c:v>71.161439800364107</c:v>
                </c:pt>
                <c:pt idx="138">
                  <c:v>70.765967007596203</c:v>
                </c:pt>
                <c:pt idx="139">
                  <c:v>80.273318303338698</c:v>
                </c:pt>
                <c:pt idx="140">
                  <c:v>69.985367339311395</c:v>
                </c:pt>
                <c:pt idx="141">
                  <c:v>74.614044829760005</c:v>
                </c:pt>
                <c:pt idx="142">
                  <c:v>72.626739861112299</c:v>
                </c:pt>
                <c:pt idx="143">
                  <c:v>81.179525648188005</c:v>
                </c:pt>
                <c:pt idx="144">
                  <c:v>89.041313103297696</c:v>
                </c:pt>
                <c:pt idx="145">
                  <c:v>78.691301660454897</c:v>
                </c:pt>
                <c:pt idx="146">
                  <c:v>61.2801126823842</c:v>
                </c:pt>
                <c:pt idx="147">
                  <c:v>64.854340297895106</c:v>
                </c:pt>
                <c:pt idx="148">
                  <c:v>68.0734711916176</c:v>
                </c:pt>
                <c:pt idx="149">
                  <c:v>63.896890870171298</c:v>
                </c:pt>
                <c:pt idx="150">
                  <c:v>74.564459243939197</c:v>
                </c:pt>
                <c:pt idx="151">
                  <c:v>76.639942039456798</c:v>
                </c:pt>
                <c:pt idx="152">
                  <c:v>66.778085360024605</c:v>
                </c:pt>
                <c:pt idx="153">
                  <c:v>70.733997869398806</c:v>
                </c:pt>
                <c:pt idx="154">
                  <c:v>62.362825389031102</c:v>
                </c:pt>
                <c:pt idx="155">
                  <c:v>71.814876421574098</c:v>
                </c:pt>
                <c:pt idx="156">
                  <c:v>70.037543767372398</c:v>
                </c:pt>
                <c:pt idx="157">
                  <c:v>71.090367967076503</c:v>
                </c:pt>
                <c:pt idx="158">
                  <c:v>69.135063177761197</c:v>
                </c:pt>
                <c:pt idx="159">
                  <c:v>70.016511863431404</c:v>
                </c:pt>
                <c:pt idx="160">
                  <c:v>75.431680890833903</c:v>
                </c:pt>
                <c:pt idx="161">
                  <c:v>74.951162530576994</c:v>
                </c:pt>
                <c:pt idx="162">
                  <c:v>93.313061636827697</c:v>
                </c:pt>
                <c:pt idx="163">
                  <c:v>75.046684032016302</c:v>
                </c:pt>
                <c:pt idx="164">
                  <c:v>74.514695369396705</c:v>
                </c:pt>
                <c:pt idx="165">
                  <c:v>72.345451377161098</c:v>
                </c:pt>
                <c:pt idx="166">
                  <c:v>64.2565765403222</c:v>
                </c:pt>
                <c:pt idx="167">
                  <c:v>79.993402730845801</c:v>
                </c:pt>
                <c:pt idx="168">
                  <c:v>71.858354490134303</c:v>
                </c:pt>
                <c:pt idx="169">
                  <c:v>61.795520727218999</c:v>
                </c:pt>
                <c:pt idx="170">
                  <c:v>78.8273824025907</c:v>
                </c:pt>
                <c:pt idx="171">
                  <c:v>69.471260608987606</c:v>
                </c:pt>
                <c:pt idx="172">
                  <c:v>67.699759179193705</c:v>
                </c:pt>
                <c:pt idx="173">
                  <c:v>68.051002420714696</c:v>
                </c:pt>
                <c:pt idx="174">
                  <c:v>76.959002010550705</c:v>
                </c:pt>
                <c:pt idx="175">
                  <c:v>75.005678597870201</c:v>
                </c:pt>
                <c:pt idx="176">
                  <c:v>70.081597426661503</c:v>
                </c:pt>
                <c:pt idx="177">
                  <c:v>75.221810390880904</c:v>
                </c:pt>
                <c:pt idx="178">
                  <c:v>70.793383617586599</c:v>
                </c:pt>
                <c:pt idx="179">
                  <c:v>71.911924687160194</c:v>
                </c:pt>
                <c:pt idx="180">
                  <c:v>66.369416630822101</c:v>
                </c:pt>
                <c:pt idx="181">
                  <c:v>65.859232852930006</c:v>
                </c:pt>
                <c:pt idx="182">
                  <c:v>82.945133027145999</c:v>
                </c:pt>
                <c:pt idx="183">
                  <c:v>75.878056157407102</c:v>
                </c:pt>
                <c:pt idx="184">
                  <c:v>77.592005210561993</c:v>
                </c:pt>
                <c:pt idx="185">
                  <c:v>68.077910493146106</c:v>
                </c:pt>
                <c:pt idx="186">
                  <c:v>65.896364220511998</c:v>
                </c:pt>
                <c:pt idx="187">
                  <c:v>85.827480079194899</c:v>
                </c:pt>
                <c:pt idx="188">
                  <c:v>74.175903420161703</c:v>
                </c:pt>
                <c:pt idx="189">
                  <c:v>70.301263051364103</c:v>
                </c:pt>
                <c:pt idx="190">
                  <c:v>76.749925186603605</c:v>
                </c:pt>
                <c:pt idx="191">
                  <c:v>65.682087580000498</c:v>
                </c:pt>
                <c:pt idx="192">
                  <c:v>65.147701421623594</c:v>
                </c:pt>
                <c:pt idx="193">
                  <c:v>71.395523329541305</c:v>
                </c:pt>
                <c:pt idx="194">
                  <c:v>73.768262017344597</c:v>
                </c:pt>
                <c:pt idx="195">
                  <c:v>75.296663503983098</c:v>
                </c:pt>
                <c:pt idx="196">
                  <c:v>78.711780770011998</c:v>
                </c:pt>
                <c:pt idx="197">
                  <c:v>75.394663724285394</c:v>
                </c:pt>
                <c:pt idx="198">
                  <c:v>90.393819059386502</c:v>
                </c:pt>
                <c:pt idx="199">
                  <c:v>73.982052940841101</c:v>
                </c:pt>
                <c:pt idx="200">
                  <c:v>69.918284343981298</c:v>
                </c:pt>
                <c:pt idx="201">
                  <c:v>80.330796531456599</c:v>
                </c:pt>
                <c:pt idx="202">
                  <c:v>79.9103046408203</c:v>
                </c:pt>
                <c:pt idx="203">
                  <c:v>87.416535906333905</c:v>
                </c:pt>
                <c:pt idx="204">
                  <c:v>70.035888594461696</c:v>
                </c:pt>
                <c:pt idx="205">
                  <c:v>76.163249223311496</c:v>
                </c:pt>
                <c:pt idx="206">
                  <c:v>65.1086945722396</c:v>
                </c:pt>
                <c:pt idx="207">
                  <c:v>76.706319800306204</c:v>
                </c:pt>
                <c:pt idx="208">
                  <c:v>81.176948948137195</c:v>
                </c:pt>
                <c:pt idx="209">
                  <c:v>69.748609070931707</c:v>
                </c:pt>
                <c:pt idx="210">
                  <c:v>73.591276103339695</c:v>
                </c:pt>
                <c:pt idx="211">
                  <c:v>78.676078522817804</c:v>
                </c:pt>
                <c:pt idx="212">
                  <c:v>75.213977312378006</c:v>
                </c:pt>
                <c:pt idx="213">
                  <c:v>67.902379370234001</c:v>
                </c:pt>
                <c:pt idx="214">
                  <c:v>87.680740742462802</c:v>
                </c:pt>
                <c:pt idx="215">
                  <c:v>83.222177120479799</c:v>
                </c:pt>
                <c:pt idx="216">
                  <c:v>67.403475992130197</c:v>
                </c:pt>
                <c:pt idx="217">
                  <c:v>72.805533603581907</c:v>
                </c:pt>
                <c:pt idx="218">
                  <c:v>83.391310976068397</c:v>
                </c:pt>
                <c:pt idx="219">
                  <c:v>77.680857021814603</c:v>
                </c:pt>
                <c:pt idx="220">
                  <c:v>81.466078230365994</c:v>
                </c:pt>
                <c:pt idx="221">
                  <c:v>63.656835553330303</c:v>
                </c:pt>
                <c:pt idx="222">
                  <c:v>82.195588086267307</c:v>
                </c:pt>
                <c:pt idx="223">
                  <c:v>73.694848903410303</c:v>
                </c:pt>
                <c:pt idx="224">
                  <c:v>69.084031592561502</c:v>
                </c:pt>
                <c:pt idx="225">
                  <c:v>79.585465319896997</c:v>
                </c:pt>
                <c:pt idx="226">
                  <c:v>77.014031878092098</c:v>
                </c:pt>
                <c:pt idx="227">
                  <c:v>81.843500482333795</c:v>
                </c:pt>
                <c:pt idx="228">
                  <c:v>84.501546468637699</c:v>
                </c:pt>
                <c:pt idx="229">
                  <c:v>77.808467091031105</c:v>
                </c:pt>
                <c:pt idx="230">
                  <c:v>83.465819485647401</c:v>
                </c:pt>
                <c:pt idx="231">
                  <c:v>70.389974010409802</c:v>
                </c:pt>
                <c:pt idx="232">
                  <c:v>73.751924926115706</c:v>
                </c:pt>
                <c:pt idx="233">
                  <c:v>67.867028128896095</c:v>
                </c:pt>
                <c:pt idx="234">
                  <c:v>67.459729876144905</c:v>
                </c:pt>
                <c:pt idx="235">
                  <c:v>76.326474377424105</c:v>
                </c:pt>
                <c:pt idx="236">
                  <c:v>70.305713661696998</c:v>
                </c:pt>
                <c:pt idx="237">
                  <c:v>66.359742489227799</c:v>
                </c:pt>
                <c:pt idx="238">
                  <c:v>71.581415976560706</c:v>
                </c:pt>
                <c:pt idx="239">
                  <c:v>76.793678796508303</c:v>
                </c:pt>
                <c:pt idx="240">
                  <c:v>78.544550892912696</c:v>
                </c:pt>
                <c:pt idx="241">
                  <c:v>69.251355338454005</c:v>
                </c:pt>
                <c:pt idx="242">
                  <c:v>76.622622492889803</c:v>
                </c:pt>
                <c:pt idx="243">
                  <c:v>69.401232417491201</c:v>
                </c:pt>
                <c:pt idx="244">
                  <c:v>79.797518572081998</c:v>
                </c:pt>
                <c:pt idx="245">
                  <c:v>68.002886337808206</c:v>
                </c:pt>
                <c:pt idx="246">
                  <c:v>66.550610349486405</c:v>
                </c:pt>
                <c:pt idx="247">
                  <c:v>79.612408442685094</c:v>
                </c:pt>
                <c:pt idx="248">
                  <c:v>65.648231152147702</c:v>
                </c:pt>
                <c:pt idx="249">
                  <c:v>73.239528579108693</c:v>
                </c:pt>
                <c:pt idx="250">
                  <c:v>67.380766751035793</c:v>
                </c:pt>
                <c:pt idx="251">
                  <c:v>68.080293434839803</c:v>
                </c:pt>
                <c:pt idx="252">
                  <c:v>84.784856728069101</c:v>
                </c:pt>
                <c:pt idx="253">
                  <c:v>77.943341233467805</c:v>
                </c:pt>
                <c:pt idx="254">
                  <c:v>70.5269487356654</c:v>
                </c:pt>
                <c:pt idx="255">
                  <c:v>73.867372977572501</c:v>
                </c:pt>
                <c:pt idx="256">
                  <c:v>77.875943010805102</c:v>
                </c:pt>
                <c:pt idx="257">
                  <c:v>79.131212881119694</c:v>
                </c:pt>
                <c:pt idx="258">
                  <c:v>72.684782153438405</c:v>
                </c:pt>
                <c:pt idx="259">
                  <c:v>74.128752868683407</c:v>
                </c:pt>
                <c:pt idx="260">
                  <c:v>67.575903782677898</c:v>
                </c:pt>
                <c:pt idx="261">
                  <c:v>78.519196959977805</c:v>
                </c:pt>
                <c:pt idx="262">
                  <c:v>68.526573432248497</c:v>
                </c:pt>
                <c:pt idx="263">
                  <c:v>68.903412909504993</c:v>
                </c:pt>
                <c:pt idx="264">
                  <c:v>67.918451465871399</c:v>
                </c:pt>
                <c:pt idx="265">
                  <c:v>72.794779826529705</c:v>
                </c:pt>
                <c:pt idx="266">
                  <c:v>73.243462475666803</c:v>
                </c:pt>
                <c:pt idx="267">
                  <c:v>84.382065085992295</c:v>
                </c:pt>
                <c:pt idx="268">
                  <c:v>67.549424079673202</c:v>
                </c:pt>
                <c:pt idx="269">
                  <c:v>66.674041308420598</c:v>
                </c:pt>
                <c:pt idx="270">
                  <c:v>65.324001550219194</c:v>
                </c:pt>
                <c:pt idx="271">
                  <c:v>75.876041120475605</c:v>
                </c:pt>
                <c:pt idx="272">
                  <c:v>72.785238687714099</c:v>
                </c:pt>
                <c:pt idx="273">
                  <c:v>76.091161709329995</c:v>
                </c:pt>
                <c:pt idx="274">
                  <c:v>69.881465354288295</c:v>
                </c:pt>
                <c:pt idx="275">
                  <c:v>65.103369840584904</c:v>
                </c:pt>
                <c:pt idx="276">
                  <c:v>76.901120207916193</c:v>
                </c:pt>
                <c:pt idx="277">
                  <c:v>66.231027827274801</c:v>
                </c:pt>
                <c:pt idx="278">
                  <c:v>72.557166168108196</c:v>
                </c:pt>
                <c:pt idx="279">
                  <c:v>75.166669862620296</c:v>
                </c:pt>
                <c:pt idx="280">
                  <c:v>76.161714366637298</c:v>
                </c:pt>
                <c:pt idx="281">
                  <c:v>68.097449994446194</c:v>
                </c:pt>
                <c:pt idx="282">
                  <c:v>69.391429781295599</c:v>
                </c:pt>
                <c:pt idx="283">
                  <c:v>73.0993747302863</c:v>
                </c:pt>
                <c:pt idx="284">
                  <c:v>79.687006345453398</c:v>
                </c:pt>
                <c:pt idx="285">
                  <c:v>70.788632661608602</c:v>
                </c:pt>
                <c:pt idx="286">
                  <c:v>57.5782612569324</c:v>
                </c:pt>
                <c:pt idx="287">
                  <c:v>72.5586615541783</c:v>
                </c:pt>
                <c:pt idx="288">
                  <c:v>66.579228507855305</c:v>
                </c:pt>
                <c:pt idx="289">
                  <c:v>74.369736094141501</c:v>
                </c:pt>
                <c:pt idx="290">
                  <c:v>73.482146429185804</c:v>
                </c:pt>
                <c:pt idx="291">
                  <c:v>75.9052483217952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D04-4F42-ACAB-6B4784B428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346240"/>
        <c:axId val="200348032"/>
      </c:scatterChart>
      <c:valAx>
        <c:axId val="2003462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348032"/>
        <c:crosses val="autoZero"/>
        <c:crossBetween val="midCat"/>
      </c:valAx>
      <c:valAx>
        <c:axId val="2003480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03462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511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477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420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15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918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582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015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495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051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434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811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E483FF-FF29-42F3-B61D-08F727D15E23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05689-5DE2-4F27-94A1-8E20F9217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267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578302933"/>
              </p:ext>
            </p:extLst>
          </p:nvPr>
        </p:nvGraphicFramePr>
        <p:xfrm>
          <a:off x="212241" y="461961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>
            <p:extLst>
              <p:ext uri="{D42A27DB-BD31-4B8C-83A1-F6EECF244321}">
                <p14:modId xmlns:p14="http://schemas.microsoft.com/office/powerpoint/2010/main" val="1749014385"/>
              </p:ext>
            </p:extLst>
          </p:nvPr>
        </p:nvGraphicFramePr>
        <p:xfrm>
          <a:off x="6252954" y="461961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3521206605"/>
              </p:ext>
            </p:extLst>
          </p:nvPr>
        </p:nvGraphicFramePr>
        <p:xfrm>
          <a:off x="212241" y="3639999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37230721"/>
              </p:ext>
            </p:extLst>
          </p:nvPr>
        </p:nvGraphicFramePr>
        <p:xfrm>
          <a:off x="6252954" y="3639999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902989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>
            <p:extLst>
              <p:ext uri="{D42A27DB-BD31-4B8C-83A1-F6EECF244321}">
                <p14:modId xmlns:p14="http://schemas.microsoft.com/office/powerpoint/2010/main" val="3170008406"/>
              </p:ext>
            </p:extLst>
          </p:nvPr>
        </p:nvGraphicFramePr>
        <p:xfrm>
          <a:off x="337931" y="347870"/>
          <a:ext cx="5715000" cy="288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08409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6</Words>
  <Application>Microsoft Office PowerPoint</Application>
  <PresentationFormat>Widescreen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NOB PAUL</dc:creator>
  <cp:lastModifiedBy>Pronob J. Paul</cp:lastModifiedBy>
  <cp:revision>5</cp:revision>
  <dcterms:created xsi:type="dcterms:W3CDTF">2016-06-06T06:39:37Z</dcterms:created>
  <dcterms:modified xsi:type="dcterms:W3CDTF">2017-09-12T08:36:12Z</dcterms:modified>
</cp:coreProperties>
</file>